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6"/>
  </p:notesMasterIdLst>
  <p:sldIdLst>
    <p:sldId id="261" r:id="rId2"/>
    <p:sldId id="728" r:id="rId3"/>
    <p:sldId id="704" r:id="rId4"/>
    <p:sldId id="729" r:id="rId5"/>
    <p:sldId id="724" r:id="rId6"/>
    <p:sldId id="732" r:id="rId7"/>
    <p:sldId id="726" r:id="rId8"/>
    <p:sldId id="708" r:id="rId9"/>
    <p:sldId id="730" r:id="rId10"/>
    <p:sldId id="731" r:id="rId11"/>
    <p:sldId id="719" r:id="rId12"/>
    <p:sldId id="720" r:id="rId13"/>
    <p:sldId id="721" r:id="rId14"/>
    <p:sldId id="722" r:id="rId1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EBE42"/>
    <a:srgbClr val="3AD05A"/>
    <a:srgbClr val="25C548"/>
    <a:srgbClr val="FF00FF"/>
    <a:srgbClr val="BDD7EE"/>
    <a:srgbClr val="FFCCCC"/>
    <a:srgbClr val="FF5050"/>
    <a:srgbClr val="000000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84E427A-3D55-4303-BF80-6455036E1DE7}" styleName="Themed Style 1 - Acc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297" autoAdjust="0"/>
    <p:restoredTop sz="92209" autoAdjust="0"/>
  </p:normalViewPr>
  <p:slideViewPr>
    <p:cSldViewPr snapToGrid="0">
      <p:cViewPr varScale="1">
        <p:scale>
          <a:sx n="98" d="100"/>
          <a:sy n="98" d="100"/>
        </p:scale>
        <p:origin x="114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percentStack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gree/Strongly Agree</c:v>
                </c:pt>
              </c:strCache>
            </c:strRef>
          </c:tx>
          <c:spPr>
            <a:solidFill>
              <a:srgbClr val="00B05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A$2:$A$13</c:f>
              <c:strCache>
                <c:ptCount val="12"/>
                <c:pt idx="0">
                  <c:v>I think that the MantUS can help decrease adverse outcomes</c:v>
                </c:pt>
                <c:pt idx="1">
                  <c:v>I think that MantUS can help decrease failed vascular access attempts and unintentional puncture of adjacent anatomy</c:v>
                </c:pt>
                <c:pt idx="2">
                  <c:v>I preferred using MantUS  over conventional u/s for vas access</c:v>
                </c:pt>
                <c:pt idx="3">
                  <c:v>I would be more comfortable using MantUS than conventional u/s for vasc access </c:v>
                </c:pt>
                <c:pt idx="4">
                  <c:v>MantUS allowed for better overall understanding of spatial awareness </c:v>
                </c:pt>
                <c:pt idx="5">
                  <c:v>I used the larger U/S billboard view to localize my target for access</c:v>
                </c:pt>
                <c:pt idx="6">
                  <c:v>MantUS made it easier to identify needle entry into target location</c:v>
                </c:pt>
                <c:pt idx="7">
                  <c:v>Using MantUS made vasc access easier to perform </c:v>
                </c:pt>
                <c:pt idx="8">
                  <c:v>MantUS images were easier to interpret than conventional u/s images</c:v>
                </c:pt>
                <c:pt idx="9">
                  <c:v>I was comfortable using MantUS</c:v>
                </c:pt>
                <c:pt idx="10">
                  <c:v>MantUS was easy to use</c:v>
                </c:pt>
                <c:pt idx="11">
                  <c:v>Headset is comfortable </c:v>
                </c:pt>
              </c:strCache>
            </c:strRef>
          </c:cat>
          <c:val>
            <c:numRef>
              <c:f>Sheet1!$B$2:$B$13</c:f>
              <c:numCache>
                <c:formatCode>General</c:formatCode>
                <c:ptCount val="12"/>
                <c:pt idx="0">
                  <c:v>22</c:v>
                </c:pt>
                <c:pt idx="1">
                  <c:v>25</c:v>
                </c:pt>
                <c:pt idx="2">
                  <c:v>10</c:v>
                </c:pt>
                <c:pt idx="3">
                  <c:v>11</c:v>
                </c:pt>
                <c:pt idx="4">
                  <c:v>23</c:v>
                </c:pt>
                <c:pt idx="5">
                  <c:v>25</c:v>
                </c:pt>
                <c:pt idx="6">
                  <c:v>20</c:v>
                </c:pt>
                <c:pt idx="7">
                  <c:v>14</c:v>
                </c:pt>
                <c:pt idx="8">
                  <c:v>11</c:v>
                </c:pt>
                <c:pt idx="9">
                  <c:v>23</c:v>
                </c:pt>
                <c:pt idx="10">
                  <c:v>26</c:v>
                </c:pt>
                <c:pt idx="11">
                  <c:v>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442-4BC3-B3C9-E2CEA2E16F4D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Neutral</c:v>
                </c:pt>
              </c:strCache>
            </c:strRef>
          </c:tx>
          <c:spPr>
            <a:noFill/>
            <a:ln>
              <a:noFill/>
            </a:ln>
            <a:effectLst/>
          </c:spPr>
          <c:invertIfNegative val="0"/>
          <c:cat>
            <c:strRef>
              <c:f>Sheet1!$A$2:$A$13</c:f>
              <c:strCache>
                <c:ptCount val="12"/>
                <c:pt idx="0">
                  <c:v>I think that the MantUS can help decrease adverse outcomes</c:v>
                </c:pt>
                <c:pt idx="1">
                  <c:v>I think that MantUS can help decrease failed vascular access attempts and unintentional puncture of adjacent anatomy</c:v>
                </c:pt>
                <c:pt idx="2">
                  <c:v>I preferred using MantUS  over conventional u/s for vas access</c:v>
                </c:pt>
                <c:pt idx="3">
                  <c:v>I would be more comfortable using MantUS than conventional u/s for vasc access </c:v>
                </c:pt>
                <c:pt idx="4">
                  <c:v>MantUS allowed for better overall understanding of spatial awareness </c:v>
                </c:pt>
                <c:pt idx="5">
                  <c:v>I used the larger U/S billboard view to localize my target for access</c:v>
                </c:pt>
                <c:pt idx="6">
                  <c:v>MantUS made it easier to identify needle entry into target location</c:v>
                </c:pt>
                <c:pt idx="7">
                  <c:v>Using MantUS made vasc access easier to perform </c:v>
                </c:pt>
                <c:pt idx="8">
                  <c:v>MantUS images were easier to interpret than conventional u/s images</c:v>
                </c:pt>
                <c:pt idx="9">
                  <c:v>I was comfortable using MantUS</c:v>
                </c:pt>
                <c:pt idx="10">
                  <c:v>MantUS was easy to use</c:v>
                </c:pt>
                <c:pt idx="11">
                  <c:v>Headset is comfortable </c:v>
                </c:pt>
              </c:strCache>
            </c:strRef>
          </c:cat>
          <c:val>
            <c:numRef>
              <c:f>Sheet1!$C$2:$C$13</c:f>
              <c:numCache>
                <c:formatCode>General</c:formatCode>
                <c:ptCount val="12"/>
                <c:pt idx="0">
                  <c:v>7</c:v>
                </c:pt>
                <c:pt idx="1">
                  <c:v>4</c:v>
                </c:pt>
                <c:pt idx="2">
                  <c:v>12</c:v>
                </c:pt>
                <c:pt idx="3">
                  <c:v>10</c:v>
                </c:pt>
                <c:pt idx="4">
                  <c:v>5</c:v>
                </c:pt>
                <c:pt idx="5">
                  <c:v>3</c:v>
                </c:pt>
                <c:pt idx="6">
                  <c:v>8</c:v>
                </c:pt>
                <c:pt idx="7">
                  <c:v>12</c:v>
                </c:pt>
                <c:pt idx="8">
                  <c:v>11</c:v>
                </c:pt>
                <c:pt idx="9">
                  <c:v>4</c:v>
                </c:pt>
                <c:pt idx="10">
                  <c:v>3</c:v>
                </c:pt>
                <c:pt idx="11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442-4BC3-B3C9-E2CEA2E16F4D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Disagree/Strongly Disagree</c:v>
                </c:pt>
              </c:strCache>
            </c:strRef>
          </c:tx>
          <c:spPr>
            <a:noFill/>
            <a:ln>
              <a:noFill/>
            </a:ln>
            <a:effectLst/>
          </c:spPr>
          <c:invertIfNegative val="0"/>
          <c:cat>
            <c:strRef>
              <c:f>Sheet1!$A$2:$A$13</c:f>
              <c:strCache>
                <c:ptCount val="12"/>
                <c:pt idx="0">
                  <c:v>I think that the MantUS can help decrease adverse outcomes</c:v>
                </c:pt>
                <c:pt idx="1">
                  <c:v>I think that MantUS can help decrease failed vascular access attempts and unintentional puncture of adjacent anatomy</c:v>
                </c:pt>
                <c:pt idx="2">
                  <c:v>I preferred using MantUS  over conventional u/s for vas access</c:v>
                </c:pt>
                <c:pt idx="3">
                  <c:v>I would be more comfortable using MantUS than conventional u/s for vasc access </c:v>
                </c:pt>
                <c:pt idx="4">
                  <c:v>MantUS allowed for better overall understanding of spatial awareness </c:v>
                </c:pt>
                <c:pt idx="5">
                  <c:v>I used the larger U/S billboard view to localize my target for access</c:v>
                </c:pt>
                <c:pt idx="6">
                  <c:v>MantUS made it easier to identify needle entry into target location</c:v>
                </c:pt>
                <c:pt idx="7">
                  <c:v>Using MantUS made vasc access easier to perform </c:v>
                </c:pt>
                <c:pt idx="8">
                  <c:v>MantUS images were easier to interpret than conventional u/s images</c:v>
                </c:pt>
                <c:pt idx="9">
                  <c:v>I was comfortable using MantUS</c:v>
                </c:pt>
                <c:pt idx="10">
                  <c:v>MantUS was easy to use</c:v>
                </c:pt>
                <c:pt idx="11">
                  <c:v>Headset is comfortable </c:v>
                </c:pt>
              </c:strCache>
            </c:strRef>
          </c:cat>
          <c:val>
            <c:numRef>
              <c:f>Sheet1!$D$2:$D$13</c:f>
              <c:numCache>
                <c:formatCode>General</c:formatCode>
                <c:ptCount val="12"/>
                <c:pt idx="0">
                  <c:v>1</c:v>
                </c:pt>
                <c:pt idx="1">
                  <c:v>1</c:v>
                </c:pt>
                <c:pt idx="2">
                  <c:v>8</c:v>
                </c:pt>
                <c:pt idx="3">
                  <c:v>9</c:v>
                </c:pt>
                <c:pt idx="4">
                  <c:v>2</c:v>
                </c:pt>
                <c:pt idx="5">
                  <c:v>2</c:v>
                </c:pt>
                <c:pt idx="6">
                  <c:v>2</c:v>
                </c:pt>
                <c:pt idx="7">
                  <c:v>4</c:v>
                </c:pt>
                <c:pt idx="8">
                  <c:v>8</c:v>
                </c:pt>
                <c:pt idx="9">
                  <c:v>3</c:v>
                </c:pt>
                <c:pt idx="10">
                  <c:v>1</c:v>
                </c:pt>
                <c:pt idx="1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442-4BC3-B3C9-E2CEA2E16F4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100"/>
        <c:axId val="424125808"/>
        <c:axId val="424123840"/>
      </c:barChart>
      <c:catAx>
        <c:axId val="42412580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24123840"/>
        <c:crosses val="autoZero"/>
        <c:auto val="1"/>
        <c:lblAlgn val="ctr"/>
        <c:lblOffset val="100"/>
        <c:noMultiLvlLbl val="0"/>
      </c:catAx>
      <c:valAx>
        <c:axId val="42412384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241258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1"/>
        <c:delete val="1"/>
      </c:legendEntry>
      <c:legendEntry>
        <c:idx val="2"/>
        <c:delete val="1"/>
      </c:legendEntry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9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0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11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12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8F72A85-20FF-4316-A7FD-4D64DDDC1AD7}" type="datetimeFigureOut">
              <a:rPr lang="en-US" smtClean="0"/>
              <a:t>5/31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E8A7DC-C6A1-4292-9BCF-37CD9FDAC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55013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DE8A7DC-C6A1-4292-9BCF-37CD9FDACC5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8686175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Table 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DE8A7DC-C6A1-4292-9BCF-37CD9FDACC51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1334786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Table 2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DE8A7DC-C6A1-4292-9BCF-37CD9FDACC51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0662470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Table 3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DE8A7DC-C6A1-4292-9BCF-37CD9FDACC51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407248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 2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DE8A7DC-C6A1-4292-9BCF-37CD9FDACC51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722791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0" i="0" dirty="0">
                <a:solidFill>
                  <a:srgbClr val="201F1E"/>
                </a:solidFill>
                <a:effectLst/>
                <a:latin typeface="Calibri Light" panose="020F0302020204030204" pitchFamily="34" charset="0"/>
                <a:cs typeface="Calibri Light" panose="020F0302020204030204" pitchFamily="34" charset="0"/>
              </a:rPr>
              <a:t>Figure 3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DE8A7DC-C6A1-4292-9BCF-37CD9FDACC51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569037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5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DE8A7DC-C6A1-4292-9BCF-37CD9FDACC51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603854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Figure 6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DE8A7DC-C6A1-4292-9BCF-37CD9FDACC51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4353073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</a:t>
            </a:r>
            <a:r>
              <a:rPr lang="en-US" dirty="0" smtClean="0"/>
              <a:t>7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DE8A7DC-C6A1-4292-9BCF-37CD9FDACC51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34491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Figure 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DE8A7DC-C6A1-4292-9BCF-37CD9FDACC51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7444117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Figure 2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DE8A7DC-C6A1-4292-9BCF-37CD9FDACC51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2804651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Figure 3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DE8A7DC-C6A1-4292-9BCF-37CD9FDACC51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27639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934C5E-D8A9-43C0-A04F-92E967A0D49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FA4E1D5-EE35-4731-BAAC-4D688AB26EB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C05E0C-0266-4CC3-8482-BEE2A5571E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665A5-CD13-4331-BA45-350449C38369}" type="datetimeFigureOut">
              <a:rPr lang="en-US" smtClean="0"/>
              <a:t>5/3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1EA3ED-C09A-4117-BAA3-8B376CBB48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27FE0D-2B36-4E55-BED8-69483FF48D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F5FD7-3117-4822-8565-9501326AD8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07605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066173-B003-4531-8F0E-4C01DB1D41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83E07FB-3F1F-4CCD-AEEE-8603B27D20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8D3399-5C70-442E-8FF7-8374119C8F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665A5-CD13-4331-BA45-350449C38369}" type="datetimeFigureOut">
              <a:rPr lang="en-US" smtClean="0"/>
              <a:t>5/3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A85DF8-4BCD-4478-83A7-3A4125CA1A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77A6D0-747D-4779-871E-637E47FADA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F5FD7-3117-4822-8565-9501326AD8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95774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33CEBA6-9AB6-4696-945D-34ACEE9BB3A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E526B3F-E126-4CD5-87B7-743DF68198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A7ACCB-28EC-4BB5-86A7-6D5DF4486B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665A5-CD13-4331-BA45-350449C38369}" type="datetimeFigureOut">
              <a:rPr lang="en-US" smtClean="0"/>
              <a:t>5/3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532B7C-BE00-43D6-A32A-59B5BD30C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CC8CE0-1F30-4D06-8E9D-FAB4E3D0C3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F5FD7-3117-4822-8565-9501326AD8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2024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2A1911-194E-494B-B186-DDFFED6FC6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43BC554-DF33-4F20-A8F9-262E1292652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FC39A6-7D6B-463E-85CE-7C22E16DA4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665A5-CD13-4331-BA45-350449C38369}" type="datetimeFigureOut">
              <a:rPr lang="en-US" smtClean="0"/>
              <a:t>5/3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664FAA-EDD6-4DF9-913A-495B391D54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942106-1B26-4572-8C5E-F9E0E6D5C8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F5FD7-3117-4822-8565-9501326AD8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55902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460DAE-E10E-4AB8-BA6E-DA7A455C9A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EF1E166-C1AB-4C9A-AB5F-E5E85C0722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585B95-DF62-4382-80A7-D5B3E694F9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665A5-CD13-4331-BA45-350449C38369}" type="datetimeFigureOut">
              <a:rPr lang="en-US" smtClean="0"/>
              <a:t>5/3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1715FC-9325-4ED8-A55C-C293084177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553CAE-EEC8-4147-9A9E-60896DA015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F5FD7-3117-4822-8565-9501326AD8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3348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B99BFD-B473-4753-B400-A0AE5CD4F8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822A41E-97AC-4605-BC46-1D2FCC19E71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D826E1C-A2A3-46BA-A0E9-4BC310A50C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0A6D10-E729-4C8A-BC8E-CCF066BD45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665A5-CD13-4331-BA45-350449C38369}" type="datetimeFigureOut">
              <a:rPr lang="en-US" smtClean="0"/>
              <a:t>5/3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7564FD5-6940-4676-B0D5-255263CD00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3889EF6-9AEB-4BD1-A290-5573A2624A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F5FD7-3117-4822-8565-9501326AD8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37774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3BCD89-D8A0-411D-8C44-CBF65B313C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C096F55-0ACC-404B-88C0-5BD3738BEE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8B1471D-7E43-4E0D-B864-119D29E648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46E3698-7E6E-48D8-B926-FC8693761BF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A8E51C5-631E-41F9-B3BC-186312CD38E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0582106-FDD8-488C-AC22-5AA0AB7875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665A5-CD13-4331-BA45-350449C38369}" type="datetimeFigureOut">
              <a:rPr lang="en-US" smtClean="0"/>
              <a:t>5/31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6DBBB49-AFE8-42EA-9C2C-48FD0D6775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9756DF4-3C40-4D14-B8AD-35FE44382A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F5FD7-3117-4822-8565-9501326AD8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02557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253965-F09F-4E58-AAFE-5F8679907A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0AF4F20-E08F-4336-B97C-3500BF7058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665A5-CD13-4331-BA45-350449C38369}" type="datetimeFigureOut">
              <a:rPr lang="en-US" smtClean="0"/>
              <a:t>5/31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F2EB76D-6127-4DCA-8FE8-DFE72BA96C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8AB6B2B-596A-401C-87EC-06AAD20EF2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F5FD7-3117-4822-8565-9501326AD8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32428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4C24FE8-90E2-48DC-9F8F-76E78A3C75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665A5-CD13-4331-BA45-350449C38369}" type="datetimeFigureOut">
              <a:rPr lang="en-US" smtClean="0"/>
              <a:t>5/31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77055C2-90A7-4E22-8A26-7CFB2C6173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6C8A779-D13C-4E55-B648-DC15FBADE2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F5FD7-3117-4822-8565-9501326AD8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7887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3BC106-1A46-4A5C-AAC3-38B7A01C7C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FD1F5E-BE30-41E7-A3EB-13F2C727654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BDF7A86-E4BF-4C90-9B7E-CA926597CE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1787FCB-EF7C-472C-A3C7-A79B34FFD5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665A5-CD13-4331-BA45-350449C38369}" type="datetimeFigureOut">
              <a:rPr lang="en-US" smtClean="0"/>
              <a:t>5/3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26E99DD-F60F-4F95-90C4-12A10F0970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CA9BDFC-7844-4B96-ADE8-1901D065F0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F5FD7-3117-4822-8565-9501326AD8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27963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351752-6B37-4140-BD9E-A374E95280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44F8305-EF13-4F4B-87DF-63DA550C522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51A4D30-AA01-40A2-8AB9-953131CF04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F9F75A4-3E8C-4B05-B5C9-823257C95F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665A5-CD13-4331-BA45-350449C38369}" type="datetimeFigureOut">
              <a:rPr lang="en-US" smtClean="0"/>
              <a:t>5/3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11476E4-F392-4698-81A1-8A6840D04E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C83C2B4-3DC0-47E2-A273-07A0071F9A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F5FD7-3117-4822-8565-9501326AD8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27747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B5C925A-ED8D-4C84-B103-310C47C195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5186713-69F1-470E-9E34-45C8DB65CC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7FACE3-E792-4D45-8D9F-82FB7F07DE2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C665A5-CD13-4331-BA45-350449C38369}" type="datetimeFigureOut">
              <a:rPr lang="en-US" smtClean="0"/>
              <a:t>5/3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1C1943-6FF9-486C-814E-66F7FB6E7B2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230045-DF28-4D98-A1A7-8AA723397C1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4F5FD7-3117-4822-8565-9501326AD8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85241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8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5" Type="http://schemas.openxmlformats.org/officeDocument/2006/relationships/image" Target="../media/image11.emf"/><Relationship Id="rId4" Type="http://schemas.openxmlformats.org/officeDocument/2006/relationships/oleObject" Target="../embeddings/oleObject4.bin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9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5" Type="http://schemas.openxmlformats.org/officeDocument/2006/relationships/image" Target="../media/image12.emf"/><Relationship Id="rId4" Type="http://schemas.openxmlformats.org/officeDocument/2006/relationships/oleObject" Target="../embeddings/oleObject5.bin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7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6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5" Type="http://schemas.openxmlformats.org/officeDocument/2006/relationships/image" Target="../media/image9.emf"/><Relationship Id="rId4" Type="http://schemas.openxmlformats.org/officeDocument/2006/relationships/oleObject" Target="../embeddings/oleObject2.bin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7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5" Type="http://schemas.openxmlformats.org/officeDocument/2006/relationships/image" Target="../media/image10.emf"/><Relationship Id="rId4" Type="http://schemas.openxmlformats.org/officeDocument/2006/relationships/oleObject" Target="../embeddings/oleObject3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C0E49C3-DB70-4694-826A-52AF840E2F5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2529" y="1"/>
            <a:ext cx="11646942" cy="68579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4387913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9AD5F7B2-4179-4B35-94E2-DA630AC0805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99291747"/>
              </p:ext>
            </p:extLst>
          </p:nvPr>
        </p:nvGraphicFramePr>
        <p:xfrm>
          <a:off x="2135371" y="-15936"/>
          <a:ext cx="7921257" cy="68739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298" name="Prism 9" r:id="rId4" imgW="7011779" imgH="6084437" progId="Prism9.Document">
                  <p:embed/>
                </p:oleObj>
              </mc:Choice>
              <mc:Fallback>
                <p:oleObj name="Prism 9" r:id="rId4" imgW="7011779" imgH="6084437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135371" y="-15936"/>
                        <a:ext cx="7921257" cy="68739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70829409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4F6BC05A-B3C8-4C22-AD8C-CBF1B95E7BD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07058510"/>
              </p:ext>
            </p:extLst>
          </p:nvPr>
        </p:nvGraphicFramePr>
        <p:xfrm>
          <a:off x="2066389" y="-24747"/>
          <a:ext cx="8059222" cy="68827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19" name="Prism 9" r:id="rId4" imgW="7046697" imgH="6018908" progId="Prism9.Document">
                  <p:embed/>
                </p:oleObj>
              </mc:Choice>
              <mc:Fallback>
                <p:oleObj name="Prism 9" r:id="rId4" imgW="7046697" imgH="6018908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066389" y="-24747"/>
                        <a:ext cx="8059222" cy="68827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52606775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4">
            <a:extLst>
              <a:ext uri="{FF2B5EF4-FFF2-40B4-BE49-F238E27FC236}">
                <a16:creationId xmlns:a16="http://schemas.microsoft.com/office/drawing/2014/main" id="{7B286A67-E987-49AA-AC7E-3C12F28F106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73474827"/>
              </p:ext>
            </p:extLst>
          </p:nvPr>
        </p:nvGraphicFramePr>
        <p:xfrm>
          <a:off x="79022" y="257323"/>
          <a:ext cx="11930452" cy="53949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569924">
                  <a:extLst>
                    <a:ext uri="{9D8B030D-6E8A-4147-A177-3AD203B41FA5}">
                      <a16:colId xmlns:a16="http://schemas.microsoft.com/office/drawing/2014/main" val="2128368095"/>
                    </a:ext>
                  </a:extLst>
                </a:gridCol>
                <a:gridCol w="1368430">
                  <a:extLst>
                    <a:ext uri="{9D8B030D-6E8A-4147-A177-3AD203B41FA5}">
                      <a16:colId xmlns:a16="http://schemas.microsoft.com/office/drawing/2014/main" val="3264976404"/>
                    </a:ext>
                  </a:extLst>
                </a:gridCol>
                <a:gridCol w="1633464">
                  <a:extLst>
                    <a:ext uri="{9D8B030D-6E8A-4147-A177-3AD203B41FA5}">
                      <a16:colId xmlns:a16="http://schemas.microsoft.com/office/drawing/2014/main" val="3787374046"/>
                    </a:ext>
                  </a:extLst>
                </a:gridCol>
                <a:gridCol w="1622645">
                  <a:extLst>
                    <a:ext uri="{9D8B030D-6E8A-4147-A177-3AD203B41FA5}">
                      <a16:colId xmlns:a16="http://schemas.microsoft.com/office/drawing/2014/main" val="638908228"/>
                    </a:ext>
                  </a:extLst>
                </a:gridCol>
                <a:gridCol w="1676734">
                  <a:extLst>
                    <a:ext uri="{9D8B030D-6E8A-4147-A177-3AD203B41FA5}">
                      <a16:colId xmlns:a16="http://schemas.microsoft.com/office/drawing/2014/main" val="3502475661"/>
                    </a:ext>
                  </a:extLst>
                </a:gridCol>
                <a:gridCol w="1649690">
                  <a:extLst>
                    <a:ext uri="{9D8B030D-6E8A-4147-A177-3AD203B41FA5}">
                      <a16:colId xmlns:a16="http://schemas.microsoft.com/office/drawing/2014/main" val="1049169253"/>
                    </a:ext>
                  </a:extLst>
                </a:gridCol>
                <a:gridCol w="1409565">
                  <a:extLst>
                    <a:ext uri="{9D8B030D-6E8A-4147-A177-3AD203B41FA5}">
                      <a16:colId xmlns:a16="http://schemas.microsoft.com/office/drawing/2014/main" val="43052242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bgroup Analysis by Career Stag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e to Acces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 of Access Attempt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 of Reposition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tanc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gle of Elevatio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zimuth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982061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llow In Training</a:t>
                      </a:r>
                    </a:p>
                    <a:p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Conventional U/S    </a:t>
                      </a:r>
                    </a:p>
                    <a:p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</a:t>
                      </a:r>
                      <a:r>
                        <a:rPr lang="en-US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ntUS</a:t>
                      </a:r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p-val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1.3±117.8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5.9± 72.2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3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93±3.1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4±1.21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1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63±2.7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49±1.2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lt;0.00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20.9±10.7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8.3±10.5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lt;0.00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50.9±9.9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47.3±9.5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01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.5±15.5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8.1±12.6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4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2422717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tending ≤5 </a:t>
                      </a:r>
                      <a:r>
                        <a:rPr lang="en-US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rs</a:t>
                      </a:r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    Conventional U/S </a:t>
                      </a:r>
                    </a:p>
                    <a:p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    </a:t>
                      </a:r>
                      <a:r>
                        <a:rPr lang="en-US" sz="1800" kern="12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antUS</a:t>
                      </a:r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    p-value</a:t>
                      </a:r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.8</a:t>
                      </a:r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±56.6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9.8±69.8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38</a:t>
                      </a:r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54±1.2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61±1.55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8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18±2.1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11±2.9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9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19.8±9.9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6.23±6.3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lt;0.00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47.1±8.9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44.3±11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0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1.4±11.8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.03±14.5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2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8126753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tending 6-10 </a:t>
                      </a:r>
                      <a:r>
                        <a:rPr lang="en-US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rs</a:t>
                      </a:r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    Conventional U/S </a:t>
                      </a:r>
                    </a:p>
                    <a:p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    </a:t>
                      </a:r>
                      <a:r>
                        <a:rPr lang="en-US" sz="1800" kern="12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antUS</a:t>
                      </a:r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    p-value</a:t>
                      </a:r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.5</a:t>
                      </a:r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±94.8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7.1±105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99</a:t>
                      </a:r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.63±1.69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88±1.4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3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.5±3.5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.25±4.8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9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26.8±9.51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8.12±8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00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52.7±8.1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44.4±7.1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1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3.1±7.45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.7±13.9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0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3169465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tending &gt;10 </a:t>
                      </a:r>
                      <a:r>
                        <a:rPr lang="en-US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rs</a:t>
                      </a:r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    Conventional U/S</a:t>
                      </a:r>
                    </a:p>
                    <a:p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    </a:t>
                      </a:r>
                      <a:r>
                        <a:rPr lang="en-US" sz="1800" kern="12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antUS</a:t>
                      </a:r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    p-value</a:t>
                      </a:r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2.9±16.8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5.5±34.2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2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17±0.58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75±1.22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1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67±0.89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17±1.75</a:t>
                      </a:r>
                    </a:p>
                    <a:p>
                      <a:pPr algn="ctr"/>
                      <a:r>
                        <a:rPr lang="en-US" sz="1800" kern="1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29</a:t>
                      </a:r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23.2±7.72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16.1±13.4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0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46.7±8.1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45.4±6.9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6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1.8±11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.01±4.7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0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0210471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0474479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4">
            <a:extLst>
              <a:ext uri="{FF2B5EF4-FFF2-40B4-BE49-F238E27FC236}">
                <a16:creationId xmlns:a16="http://schemas.microsoft.com/office/drawing/2014/main" id="{7B286A67-E987-49AA-AC7E-3C12F28F106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22770167"/>
              </p:ext>
            </p:extLst>
          </p:nvPr>
        </p:nvGraphicFramePr>
        <p:xfrm>
          <a:off x="79022" y="257323"/>
          <a:ext cx="11930452" cy="44805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569924">
                  <a:extLst>
                    <a:ext uri="{9D8B030D-6E8A-4147-A177-3AD203B41FA5}">
                      <a16:colId xmlns:a16="http://schemas.microsoft.com/office/drawing/2014/main" val="2128368095"/>
                    </a:ext>
                  </a:extLst>
                </a:gridCol>
                <a:gridCol w="1368430">
                  <a:extLst>
                    <a:ext uri="{9D8B030D-6E8A-4147-A177-3AD203B41FA5}">
                      <a16:colId xmlns:a16="http://schemas.microsoft.com/office/drawing/2014/main" val="3264976404"/>
                    </a:ext>
                  </a:extLst>
                </a:gridCol>
                <a:gridCol w="1633464">
                  <a:extLst>
                    <a:ext uri="{9D8B030D-6E8A-4147-A177-3AD203B41FA5}">
                      <a16:colId xmlns:a16="http://schemas.microsoft.com/office/drawing/2014/main" val="3787374046"/>
                    </a:ext>
                  </a:extLst>
                </a:gridCol>
                <a:gridCol w="1622645">
                  <a:extLst>
                    <a:ext uri="{9D8B030D-6E8A-4147-A177-3AD203B41FA5}">
                      <a16:colId xmlns:a16="http://schemas.microsoft.com/office/drawing/2014/main" val="638908228"/>
                    </a:ext>
                  </a:extLst>
                </a:gridCol>
                <a:gridCol w="1676734">
                  <a:extLst>
                    <a:ext uri="{9D8B030D-6E8A-4147-A177-3AD203B41FA5}">
                      <a16:colId xmlns:a16="http://schemas.microsoft.com/office/drawing/2014/main" val="3502475661"/>
                    </a:ext>
                  </a:extLst>
                </a:gridCol>
                <a:gridCol w="1649690">
                  <a:extLst>
                    <a:ext uri="{9D8B030D-6E8A-4147-A177-3AD203B41FA5}">
                      <a16:colId xmlns:a16="http://schemas.microsoft.com/office/drawing/2014/main" val="1049169253"/>
                    </a:ext>
                  </a:extLst>
                </a:gridCol>
                <a:gridCol w="1409565">
                  <a:extLst>
                    <a:ext uri="{9D8B030D-6E8A-4147-A177-3AD203B41FA5}">
                      <a16:colId xmlns:a16="http://schemas.microsoft.com/office/drawing/2014/main" val="43052242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bgroup Analysis by Frequency of Acces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e to Acces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 of Access Attempt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 of Reposition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tanc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gle of Elevatio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zimuth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982061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Frequent</a:t>
                      </a:r>
                    </a:p>
                    <a:p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Conventional U/S    </a:t>
                      </a:r>
                    </a:p>
                    <a:p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</a:t>
                      </a:r>
                      <a:r>
                        <a:rPr lang="en-US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ntUS</a:t>
                      </a:r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p-val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5.1±65.9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2.9±61.5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8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54±1.2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5±1.3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87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35±2.3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09±2.9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6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20.5±9.04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7.5±9.64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lt;0.00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48.6±8.5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44.4±7.9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00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8.34±11.4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.3±9.97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1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2422717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ften</a:t>
                      </a:r>
                    </a:p>
                    <a:p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    Conventional U/S </a:t>
                      </a:r>
                    </a:p>
                    <a:p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    </a:t>
                      </a:r>
                      <a:r>
                        <a:rPr lang="en-US" sz="1800" kern="12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antUS</a:t>
                      </a:r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    p-value</a:t>
                      </a:r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.3</a:t>
                      </a:r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±52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5.7±72.3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90</a:t>
                      </a:r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54±1.2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25±0.73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2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46±1.9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38±0.82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01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22.7±12.4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9.67±12.4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lt;0.00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46.6±7.7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42.9±8.5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00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.96±15.6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58±11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5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8126753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frequent</a:t>
                      </a:r>
                    </a:p>
                    <a:p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    Conventional U/S </a:t>
                      </a:r>
                    </a:p>
                    <a:p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    </a:t>
                      </a:r>
                      <a:r>
                        <a:rPr lang="en-US" sz="1800" kern="12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antUS</a:t>
                      </a:r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    p-value</a:t>
                      </a:r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.3</a:t>
                      </a:r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±141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9.6±76.1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56</a:t>
                      </a:r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.61±3.6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68±1.6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1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66±3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73±1.4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0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20.9±10.7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9.01±10.6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lt;0.00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53.2±10.7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50.8±10.5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27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0.5±15.7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1.1±14.5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8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3169465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022335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4">
            <a:extLst>
              <a:ext uri="{FF2B5EF4-FFF2-40B4-BE49-F238E27FC236}">
                <a16:creationId xmlns:a16="http://schemas.microsoft.com/office/drawing/2014/main" id="{7B286A67-E987-49AA-AC7E-3C12F28F106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40259857"/>
              </p:ext>
            </p:extLst>
          </p:nvPr>
        </p:nvGraphicFramePr>
        <p:xfrm>
          <a:off x="79022" y="257323"/>
          <a:ext cx="11930452" cy="35661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569924">
                  <a:extLst>
                    <a:ext uri="{9D8B030D-6E8A-4147-A177-3AD203B41FA5}">
                      <a16:colId xmlns:a16="http://schemas.microsoft.com/office/drawing/2014/main" val="2128368095"/>
                    </a:ext>
                  </a:extLst>
                </a:gridCol>
                <a:gridCol w="1368430">
                  <a:extLst>
                    <a:ext uri="{9D8B030D-6E8A-4147-A177-3AD203B41FA5}">
                      <a16:colId xmlns:a16="http://schemas.microsoft.com/office/drawing/2014/main" val="3264976404"/>
                    </a:ext>
                  </a:extLst>
                </a:gridCol>
                <a:gridCol w="1633464">
                  <a:extLst>
                    <a:ext uri="{9D8B030D-6E8A-4147-A177-3AD203B41FA5}">
                      <a16:colId xmlns:a16="http://schemas.microsoft.com/office/drawing/2014/main" val="3787374046"/>
                    </a:ext>
                  </a:extLst>
                </a:gridCol>
                <a:gridCol w="1622645">
                  <a:extLst>
                    <a:ext uri="{9D8B030D-6E8A-4147-A177-3AD203B41FA5}">
                      <a16:colId xmlns:a16="http://schemas.microsoft.com/office/drawing/2014/main" val="638908228"/>
                    </a:ext>
                  </a:extLst>
                </a:gridCol>
                <a:gridCol w="1676734">
                  <a:extLst>
                    <a:ext uri="{9D8B030D-6E8A-4147-A177-3AD203B41FA5}">
                      <a16:colId xmlns:a16="http://schemas.microsoft.com/office/drawing/2014/main" val="3502475661"/>
                    </a:ext>
                  </a:extLst>
                </a:gridCol>
                <a:gridCol w="1649690">
                  <a:extLst>
                    <a:ext uri="{9D8B030D-6E8A-4147-A177-3AD203B41FA5}">
                      <a16:colId xmlns:a16="http://schemas.microsoft.com/office/drawing/2014/main" val="1049169253"/>
                    </a:ext>
                  </a:extLst>
                </a:gridCol>
                <a:gridCol w="1409565">
                  <a:extLst>
                    <a:ext uri="{9D8B030D-6E8A-4147-A177-3AD203B41FA5}">
                      <a16:colId xmlns:a16="http://schemas.microsoft.com/office/drawing/2014/main" val="43052242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bgroup Analysis by Specialty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e to Acces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 of Access Attempt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 of Reposition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tanc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gle of Elevatio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zimuth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982061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ediatric Cardiology</a:t>
                      </a:r>
                    </a:p>
                    <a:p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Conventional U/S    </a:t>
                      </a:r>
                    </a:p>
                    <a:p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</a:t>
                      </a:r>
                      <a:r>
                        <a:rPr lang="en-US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ntUS</a:t>
                      </a:r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p-val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3.9±117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2.8±76.3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9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.13±3.02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65±1.4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2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37±2.44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76±1.8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0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21.4±9.9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9.3±11.1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lt;0.00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48.6±10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46.7±10.1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1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9.9±13.6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.24±9.1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1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2422717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diatric Intensive Care or Cardiac Intensive Care</a:t>
                      </a:r>
                    </a:p>
                    <a:p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    Conventional U/S </a:t>
                      </a:r>
                    </a:p>
                    <a:p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    </a:t>
                      </a:r>
                      <a:r>
                        <a:rPr lang="en-US" sz="1800" kern="12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antUS</a:t>
                      </a:r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    p-value</a:t>
                      </a:r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.4</a:t>
                      </a:r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±71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2.2±61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4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67±1.26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35±1.14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1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63±2.62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88±2.55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1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20.7±10.9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7.5±8.62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lt;0.00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51.6±8.7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46.1±9.01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lt;0.00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US" sz="1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.34±14.3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.96±15.9</a:t>
                      </a:r>
                    </a:p>
                    <a:p>
                      <a:pPr algn="ctr"/>
                      <a:r>
                        <a:rPr lang="en-US" sz="1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8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3169465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953709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>
            <a:extLst>
              <a:ext uri="{FF2B5EF4-FFF2-40B4-BE49-F238E27FC236}">
                <a16:creationId xmlns:a16="http://schemas.microsoft.com/office/drawing/2014/main" id="{4BD3B045-3B62-4328-B285-806BC1889B9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8095" b="36662"/>
          <a:stretch/>
        </p:blipFill>
        <p:spPr>
          <a:xfrm>
            <a:off x="8116854" y="566237"/>
            <a:ext cx="2706624" cy="2298437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F51FA9D1-DD83-4DB7-91DD-5BF5FDC066E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3084" b="45591"/>
          <a:stretch/>
        </p:blipFill>
        <p:spPr>
          <a:xfrm>
            <a:off x="1501644" y="511891"/>
            <a:ext cx="985494" cy="222313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F51FA9D1-DD83-4DB7-91DD-5BF5FDC066E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040" r="48838" b="38242"/>
          <a:stretch/>
        </p:blipFill>
        <p:spPr>
          <a:xfrm>
            <a:off x="3210815" y="541143"/>
            <a:ext cx="997453" cy="2298437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B22E8F77-189B-4138-8820-0B66A32FE108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9379" b="32623"/>
          <a:stretch/>
        </p:blipFill>
        <p:spPr>
          <a:xfrm>
            <a:off x="4872183" y="513595"/>
            <a:ext cx="2708988" cy="2325679"/>
          </a:xfrm>
          <a:prstGeom prst="rect">
            <a:avLst/>
          </a:prstGeom>
        </p:spPr>
      </p:pic>
      <p:sp>
        <p:nvSpPr>
          <p:cNvPr id="31" name="Rectangle 30"/>
          <p:cNvSpPr/>
          <p:nvPr/>
        </p:nvSpPr>
        <p:spPr>
          <a:xfrm>
            <a:off x="1180218" y="511891"/>
            <a:ext cx="9920177" cy="597397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2" name="Picture 31">
            <a:extLst>
              <a:ext uri="{FF2B5EF4-FFF2-40B4-BE49-F238E27FC236}">
                <a16:creationId xmlns:a16="http://schemas.microsoft.com/office/drawing/2014/main" id="{F51FA9D1-DD83-4DB7-91DD-5BF5FDC066E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48" r="65121" b="38242"/>
          <a:stretch/>
        </p:blipFill>
        <p:spPr>
          <a:xfrm>
            <a:off x="2482500" y="540837"/>
            <a:ext cx="770830" cy="2298437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36" name="TextBox 35"/>
          <p:cNvSpPr txBox="1"/>
          <p:nvPr/>
        </p:nvSpPr>
        <p:spPr>
          <a:xfrm>
            <a:off x="1201860" y="519197"/>
            <a:ext cx="6698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A.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4461022" y="511891"/>
            <a:ext cx="6698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B.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7839937" y="543085"/>
            <a:ext cx="6698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C.</a:t>
            </a:r>
          </a:p>
        </p:txBody>
      </p:sp>
      <p:cxnSp>
        <p:nvCxnSpPr>
          <p:cNvPr id="40" name="Straight Connector 39"/>
          <p:cNvCxnSpPr/>
          <p:nvPr/>
        </p:nvCxnSpPr>
        <p:spPr>
          <a:xfrm flipH="1">
            <a:off x="4465678" y="511891"/>
            <a:ext cx="10633" cy="597397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>
            <a:off x="7797225" y="526062"/>
            <a:ext cx="7077" cy="59598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9" name="Picture 38" descr="A picture containing text, purple&#10;&#10;Description automatically generated">
            <a:extLst>
              <a:ext uri="{FF2B5EF4-FFF2-40B4-BE49-F238E27FC236}">
                <a16:creationId xmlns:a16="http://schemas.microsoft.com/office/drawing/2014/main" id="{D41B7171-0E36-40E7-BD57-287108BFA36E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190" r="33436"/>
          <a:stretch/>
        </p:blipFill>
        <p:spPr>
          <a:xfrm>
            <a:off x="5004135" y="2802830"/>
            <a:ext cx="2443280" cy="3613715"/>
          </a:xfrm>
          <a:prstGeom prst="rect">
            <a:avLst/>
          </a:prstGeom>
        </p:spPr>
      </p:pic>
      <p:pic>
        <p:nvPicPr>
          <p:cNvPr id="42" name="Picture 41" descr="A picture containing text, purple&#10;&#10;Description automatically generated">
            <a:extLst>
              <a:ext uri="{FF2B5EF4-FFF2-40B4-BE49-F238E27FC236}">
                <a16:creationId xmlns:a16="http://schemas.microsoft.com/office/drawing/2014/main" id="{D41B7171-0E36-40E7-BD57-287108BFA36E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216" r="3736"/>
          <a:stretch/>
        </p:blipFill>
        <p:spPr>
          <a:xfrm>
            <a:off x="7975239" y="2766920"/>
            <a:ext cx="2837260" cy="3636363"/>
          </a:xfrm>
          <a:prstGeom prst="rect">
            <a:avLst/>
          </a:prstGeom>
        </p:spPr>
      </p:pic>
      <p:grpSp>
        <p:nvGrpSpPr>
          <p:cNvPr id="3" name="Group 2"/>
          <p:cNvGrpSpPr/>
          <p:nvPr/>
        </p:nvGrpSpPr>
        <p:grpSpPr>
          <a:xfrm>
            <a:off x="2057399" y="2735022"/>
            <a:ext cx="2188111" cy="3668262"/>
            <a:chOff x="1518868" y="2887033"/>
            <a:chExt cx="1940401" cy="3396136"/>
          </a:xfrm>
        </p:grpSpPr>
        <p:pic>
          <p:nvPicPr>
            <p:cNvPr id="43" name="Picture 42" descr="A picture containing text, purple&#10;&#10;Description automatically generated">
              <a:extLst>
                <a:ext uri="{FF2B5EF4-FFF2-40B4-BE49-F238E27FC236}">
                  <a16:creationId xmlns:a16="http://schemas.microsoft.com/office/drawing/2014/main" id="{D41B7171-0E36-40E7-BD57-287108BFA36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907" r="58293"/>
            <a:stretch/>
          </p:blipFill>
          <p:spPr>
            <a:xfrm>
              <a:off x="1518868" y="2887033"/>
              <a:ext cx="1931629" cy="3396136"/>
            </a:xfrm>
            <a:prstGeom prst="rect">
              <a:avLst/>
            </a:prstGeom>
          </p:spPr>
        </p:pic>
        <p:sp>
          <p:nvSpPr>
            <p:cNvPr id="2" name="Rectangle 1"/>
            <p:cNvSpPr/>
            <p:nvPr/>
          </p:nvSpPr>
          <p:spPr>
            <a:xfrm>
              <a:off x="3142850" y="3330054"/>
              <a:ext cx="316419" cy="47084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55" name="Picture 54" descr="A picture containing text, purple&#10;&#10;Description automatically generated">
            <a:extLst>
              <a:ext uri="{FF2B5EF4-FFF2-40B4-BE49-F238E27FC236}">
                <a16:creationId xmlns:a16="http://schemas.microsoft.com/office/drawing/2014/main" id="{D41B7171-0E36-40E7-BD57-287108BFA36E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ackgroundRemoval t="11392" b="47539" l="39676" r="61072">
                        <a14:backgroundMark x1="54549" y1="28411" x2="54549" y2="28411"/>
                        <a14:backgroundMark x1="54508" y1="43319" x2="54508" y2="43319"/>
                        <a14:backgroundMark x1="58953" y1="45148" x2="58953" y2="45148"/>
                        <a14:backgroundMark x1="57790" y1="43882" x2="57790" y2="43882"/>
                        <a14:backgroundMark x1="54549" y1="40928" x2="54549" y2="40928"/>
                        <a14:backgroundMark x1="59493" y1="41491" x2="59493" y2="41491"/>
                        <a14:backgroundMark x1="59202" y1="40788" x2="59202" y2="40788"/>
                        <a14:backgroundMark x1="58828" y1="44023" x2="58828" y2="44023"/>
                        <a14:backgroundMark x1="58828" y1="43179" x2="58828" y2="43179"/>
                        <a14:backgroundMark x1="59244" y1="39662" x2="59244" y2="39662"/>
                        <a14:backgroundMark x1="58953" y1="41210" x2="58953" y2="41210"/>
                        <a14:backgroundMark x1="59036" y1="40647" x2="59036" y2="40647"/>
                        <a14:backgroundMark x1="58828" y1="42757" x2="58828" y2="42757"/>
                        <a14:backgroundMark x1="58704" y1="43741" x2="58704" y2="43741"/>
                        <a14:backgroundMark x1="54632" y1="30661" x2="54632" y2="30661"/>
                      </a14:backgroundRemoval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8190" t="24733" r="40630" b="51865"/>
          <a:stretch/>
        </p:blipFill>
        <p:spPr>
          <a:xfrm rot="21449486">
            <a:off x="1295145" y="3535702"/>
            <a:ext cx="1486582" cy="883518"/>
          </a:xfrm>
          <a:prstGeom prst="rect">
            <a:avLst/>
          </a:prstGeom>
        </p:spPr>
      </p:pic>
      <p:cxnSp>
        <p:nvCxnSpPr>
          <p:cNvPr id="5" name="Straight Connector 4"/>
          <p:cNvCxnSpPr/>
          <p:nvPr/>
        </p:nvCxnSpPr>
        <p:spPr>
          <a:xfrm flipH="1">
            <a:off x="2676525" y="4081462"/>
            <a:ext cx="71438" cy="164307"/>
          </a:xfrm>
          <a:prstGeom prst="line">
            <a:avLst/>
          </a:prstGeom>
          <a:ln w="25400">
            <a:solidFill>
              <a:srgbClr val="25C548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/>
          <p:cNvCxnSpPr/>
          <p:nvPr/>
        </p:nvCxnSpPr>
        <p:spPr>
          <a:xfrm>
            <a:off x="2545150" y="4193382"/>
            <a:ext cx="136556" cy="47625"/>
          </a:xfrm>
          <a:prstGeom prst="line">
            <a:avLst/>
          </a:prstGeom>
          <a:ln w="25400">
            <a:solidFill>
              <a:srgbClr val="3AD05A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/>
          <p:cNvCxnSpPr/>
          <p:nvPr/>
        </p:nvCxnSpPr>
        <p:spPr>
          <a:xfrm>
            <a:off x="2618114" y="4038601"/>
            <a:ext cx="136556" cy="47625"/>
          </a:xfrm>
          <a:prstGeom prst="line">
            <a:avLst/>
          </a:prstGeom>
          <a:ln w="25400">
            <a:solidFill>
              <a:srgbClr val="2EBE42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081599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>
            <a:extLst>
              <a:ext uri="{FF2B5EF4-FFF2-40B4-BE49-F238E27FC236}">
                <a16:creationId xmlns:a16="http://schemas.microsoft.com/office/drawing/2014/main" id="{DF0B2F7E-1ACA-4523-8D52-FF54C27BF85C}"/>
              </a:ext>
            </a:extLst>
          </p:cNvPr>
          <p:cNvGrpSpPr/>
          <p:nvPr/>
        </p:nvGrpSpPr>
        <p:grpSpPr>
          <a:xfrm>
            <a:off x="6384019" y="118463"/>
            <a:ext cx="4358459" cy="4734670"/>
            <a:chOff x="1874111" y="132575"/>
            <a:chExt cx="4358459" cy="4734670"/>
          </a:xfrm>
        </p:grpSpPr>
        <p:sp>
          <p:nvSpPr>
            <p:cNvPr id="2" name="Rounded Rectangle 1"/>
            <p:cNvSpPr/>
            <p:nvPr/>
          </p:nvSpPr>
          <p:spPr>
            <a:xfrm>
              <a:off x="1966074" y="2428012"/>
              <a:ext cx="4266496" cy="2439233"/>
            </a:xfrm>
            <a:prstGeom prst="roundRect">
              <a:avLst/>
            </a:prstGeom>
            <a:solidFill>
              <a:srgbClr val="FFCCCC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2900290" y="132575"/>
              <a:ext cx="2673489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800" dirty="0">
                  <a:latin typeface="Arial" panose="020B0604020202020204" pitchFamily="34" charset="0"/>
                  <a:cs typeface="Arial" panose="020B0604020202020204" pitchFamily="34" charset="0"/>
                </a:rPr>
                <a:t>Short Axis View</a:t>
              </a:r>
            </a:p>
          </p:txBody>
        </p:sp>
        <p:sp>
          <p:nvSpPr>
            <p:cNvPr id="7" name="Oval 6"/>
            <p:cNvSpPr/>
            <p:nvPr/>
          </p:nvSpPr>
          <p:spPr>
            <a:xfrm>
              <a:off x="3775237" y="3395837"/>
              <a:ext cx="745016" cy="671187"/>
            </a:xfrm>
            <a:prstGeom prst="ellipse">
              <a:avLst/>
            </a:prstGeom>
            <a:solidFill>
              <a:schemeClr val="accent5">
                <a:lumMod val="40000"/>
                <a:lumOff val="60000"/>
              </a:schemeClr>
            </a:solidFill>
            <a:ln>
              <a:solidFill>
                <a:schemeClr val="accent5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Oval 7"/>
            <p:cNvSpPr/>
            <p:nvPr/>
          </p:nvSpPr>
          <p:spPr>
            <a:xfrm>
              <a:off x="3009355" y="2904530"/>
              <a:ext cx="754731" cy="705410"/>
            </a:xfrm>
            <a:prstGeom prst="ellipse">
              <a:avLst/>
            </a:prstGeom>
            <a:solidFill>
              <a:srgbClr val="FF5050">
                <a:alpha val="73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" name="Straight Connector 21"/>
            <p:cNvCxnSpPr>
              <a:cxnSpLocks/>
            </p:cNvCxnSpPr>
            <p:nvPr/>
          </p:nvCxnSpPr>
          <p:spPr>
            <a:xfrm flipH="1">
              <a:off x="2497998" y="2418352"/>
              <a:ext cx="1639477" cy="1672222"/>
            </a:xfrm>
            <a:prstGeom prst="line">
              <a:avLst/>
            </a:prstGeom>
            <a:ln w="25400">
              <a:solidFill>
                <a:srgbClr val="00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7F8C0F15-056D-41BD-935C-1160CA294A78}"/>
                </a:ext>
              </a:extLst>
            </p:cNvPr>
            <p:cNvSpPr txBox="1"/>
            <p:nvPr/>
          </p:nvSpPr>
          <p:spPr>
            <a:xfrm>
              <a:off x="2235696" y="2475485"/>
              <a:ext cx="69571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nterior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93259153-3072-4B24-8EC7-48774CCA285E}"/>
                </a:ext>
              </a:extLst>
            </p:cNvPr>
            <p:cNvSpPr txBox="1"/>
            <p:nvPr/>
          </p:nvSpPr>
          <p:spPr>
            <a:xfrm>
              <a:off x="2260343" y="3012251"/>
              <a:ext cx="8720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osterior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id="{861926F1-B5B2-4138-A399-3215D705C6C5}"/>
                </a:ext>
              </a:extLst>
            </p:cNvPr>
            <p:cNvCxnSpPr>
              <a:cxnSpLocks/>
            </p:cNvCxnSpPr>
            <p:nvPr/>
          </p:nvCxnSpPr>
          <p:spPr>
            <a:xfrm>
              <a:off x="4131540" y="1289582"/>
              <a:ext cx="32137" cy="3514244"/>
            </a:xfrm>
            <a:prstGeom prst="line">
              <a:avLst/>
            </a:prstGeom>
            <a:ln w="25400">
              <a:solidFill>
                <a:srgbClr val="0000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>
              <a:extLst>
                <a:ext uri="{FF2B5EF4-FFF2-40B4-BE49-F238E27FC236}">
                  <a16:creationId xmlns:a16="http://schemas.microsoft.com/office/drawing/2014/main" id="{E70D9A6E-E845-4285-9CD1-67F30A97743E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490139" y="3233617"/>
              <a:ext cx="681746" cy="549655"/>
            </a:xfrm>
            <a:prstGeom prst="line">
              <a:avLst/>
            </a:prstGeom>
            <a:ln w="57150">
              <a:solidFill>
                <a:schemeClr val="tx1"/>
              </a:solidFill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Arc 51">
              <a:extLst>
                <a:ext uri="{FF2B5EF4-FFF2-40B4-BE49-F238E27FC236}">
                  <a16:creationId xmlns:a16="http://schemas.microsoft.com/office/drawing/2014/main" id="{758711BA-9B84-4406-A214-383FD27C7052}"/>
                </a:ext>
              </a:extLst>
            </p:cNvPr>
            <p:cNvSpPr/>
            <p:nvPr/>
          </p:nvSpPr>
          <p:spPr>
            <a:xfrm rot="19437307">
              <a:off x="3724616" y="3017392"/>
              <a:ext cx="867633" cy="898435"/>
            </a:xfrm>
            <a:prstGeom prst="arc">
              <a:avLst>
                <a:gd name="adj1" fmla="val 14121011"/>
                <a:gd name="adj2" fmla="val 704475"/>
              </a:avLst>
            </a:prstGeom>
            <a:ln w="22225">
              <a:solidFill>
                <a:schemeClr val="tx1"/>
              </a:solidFill>
              <a:prstDash val="solid"/>
              <a:round/>
              <a:headEnd type="arrow"/>
              <a:tailEnd type="arrow"/>
              <a:extLst>
                <a:ext uri="{C807C97D-BFC1-408E-A445-0C87EB9F89A2}">
                  <ask:lineSketchStyleProps xmlns="" xmlns:ask="http://schemas.microsoft.com/office/drawing/2018/sketchyshapes" sd="1219033472">
                    <a:custGeom>
                      <a:avLst/>
                      <a:gdLst>
                        <a:gd name="connsiteX0" fmla="*/ 373537 w 1310640"/>
                        <a:gd name="connsiteY0" fmla="*/ 65740 h 1353130"/>
                        <a:gd name="connsiteX1" fmla="*/ 1000338 w 1310640"/>
                        <a:gd name="connsiteY1" fmla="*/ 101361 h 1353130"/>
                        <a:gd name="connsiteX2" fmla="*/ 1309606 w 1310640"/>
                        <a:gd name="connsiteY2" fmla="*/ 638575 h 1353130"/>
                        <a:gd name="connsiteX3" fmla="*/ 655320 w 1310640"/>
                        <a:gd name="connsiteY3" fmla="*/ 676565 h 1353130"/>
                        <a:gd name="connsiteX4" fmla="*/ 373537 w 1310640"/>
                        <a:gd name="connsiteY4" fmla="*/ 65740 h 1353130"/>
                        <a:gd name="connsiteX0" fmla="*/ 373537 w 1310640"/>
                        <a:gd name="connsiteY0" fmla="*/ 65740 h 1353130"/>
                        <a:gd name="connsiteX1" fmla="*/ 1000338 w 1310640"/>
                        <a:gd name="connsiteY1" fmla="*/ 101361 h 1353130"/>
                        <a:gd name="connsiteX2" fmla="*/ 1309606 w 1310640"/>
                        <a:gd name="connsiteY2" fmla="*/ 638575 h 1353130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</a:cxnLst>
                      <a:rect l="l" t="t" r="r" b="b"/>
                      <a:pathLst>
                        <a:path w="1310640" h="1353130" stroke="0" extrusionOk="0">
                          <a:moveTo>
                            <a:pt x="373537" y="65740"/>
                          </a:moveTo>
                          <a:cubicBezTo>
                            <a:pt x="541767" y="-53538"/>
                            <a:pt x="771609" y="-5045"/>
                            <a:pt x="1000338" y="101361"/>
                          </a:cubicBezTo>
                          <a:cubicBezTo>
                            <a:pt x="1222782" y="226158"/>
                            <a:pt x="1280474" y="418675"/>
                            <a:pt x="1309606" y="638575"/>
                          </a:cubicBezTo>
                          <a:cubicBezTo>
                            <a:pt x="998922" y="658840"/>
                            <a:pt x="946923" y="696086"/>
                            <a:pt x="655320" y="676565"/>
                          </a:cubicBezTo>
                          <a:cubicBezTo>
                            <a:pt x="535596" y="479352"/>
                            <a:pt x="443651" y="277091"/>
                            <a:pt x="373537" y="65740"/>
                          </a:cubicBezTo>
                          <a:close/>
                        </a:path>
                        <a:path w="1310640" h="1353130" fill="none" extrusionOk="0">
                          <a:moveTo>
                            <a:pt x="373537" y="65740"/>
                          </a:moveTo>
                          <a:cubicBezTo>
                            <a:pt x="595039" y="-30788"/>
                            <a:pt x="818495" y="-35483"/>
                            <a:pt x="1000338" y="101361"/>
                          </a:cubicBezTo>
                          <a:cubicBezTo>
                            <a:pt x="1138682" y="210947"/>
                            <a:pt x="1291059" y="424286"/>
                            <a:pt x="1309606" y="638575"/>
                          </a:cubicBezTo>
                        </a:path>
                      </a:pathLst>
                    </a:custGeom>
                    <ask:type>
                      <ask:lineSketchNone/>
                    </ask:type>
                  </ask:lineSketchStyleProps>
                </a:ext>
              </a:extLst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3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AC6C44BC-68D1-45D4-9051-B24A21C2CAF9}"/>
                </a:ext>
              </a:extLst>
            </p:cNvPr>
            <p:cNvSpPr txBox="1"/>
            <p:nvPr/>
          </p:nvSpPr>
          <p:spPr>
            <a:xfrm>
              <a:off x="4237035" y="2637699"/>
              <a:ext cx="1017000" cy="369332"/>
            </a:xfrm>
            <a:prstGeom prst="rect">
              <a:avLst/>
            </a:prstGeom>
            <a:solidFill>
              <a:srgbClr val="FFCCCC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i="1" dirty="0">
                  <a:latin typeface="Arial" panose="020B0604020202020204" pitchFamily="34" charset="0"/>
                  <a:cs typeface="Arial" panose="020B0604020202020204" pitchFamily="34" charset="0"/>
                </a:rPr>
                <a:t>Azimuth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93259153-3072-4B24-8EC7-48774CCA285E}"/>
                </a:ext>
              </a:extLst>
            </p:cNvPr>
            <p:cNvSpPr txBox="1"/>
            <p:nvPr/>
          </p:nvSpPr>
          <p:spPr>
            <a:xfrm>
              <a:off x="2710758" y="2753640"/>
              <a:ext cx="5441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Right 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93259153-3072-4B24-8EC7-48774CCA285E}"/>
                </a:ext>
              </a:extLst>
            </p:cNvPr>
            <p:cNvSpPr txBox="1"/>
            <p:nvPr/>
          </p:nvSpPr>
          <p:spPr>
            <a:xfrm>
              <a:off x="1874111" y="2736819"/>
              <a:ext cx="5973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Left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grpSp>
          <p:nvGrpSpPr>
            <p:cNvPr id="9" name="Group 8"/>
            <p:cNvGrpSpPr/>
            <p:nvPr/>
          </p:nvGrpSpPr>
          <p:grpSpPr>
            <a:xfrm>
              <a:off x="2316481" y="2677210"/>
              <a:ext cx="482751" cy="434188"/>
              <a:chOff x="718606" y="798028"/>
              <a:chExt cx="1119982" cy="1124712"/>
            </a:xfrm>
          </p:grpSpPr>
          <p:cxnSp>
            <p:nvCxnSpPr>
              <p:cNvPr id="21" name="Straight Arrow Connector 20"/>
              <p:cNvCxnSpPr/>
              <p:nvPr/>
            </p:nvCxnSpPr>
            <p:spPr>
              <a:xfrm>
                <a:off x="1278597" y="798028"/>
                <a:ext cx="0" cy="1124712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Straight Arrow Connector 40"/>
              <p:cNvCxnSpPr/>
              <p:nvPr/>
            </p:nvCxnSpPr>
            <p:spPr>
              <a:xfrm flipH="1" flipV="1">
                <a:off x="718606" y="1366570"/>
                <a:ext cx="1119982" cy="2707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45" name="Straight Connector 44">
              <a:extLst>
                <a:ext uri="{FF2B5EF4-FFF2-40B4-BE49-F238E27FC236}">
                  <a16:creationId xmlns:a16="http://schemas.microsoft.com/office/drawing/2014/main" id="{E70D9A6E-E845-4285-9CD1-67F30A97743E}"/>
                </a:ext>
              </a:extLst>
            </p:cNvPr>
            <p:cNvCxnSpPr>
              <a:cxnSpLocks/>
            </p:cNvCxnSpPr>
            <p:nvPr/>
          </p:nvCxnSpPr>
          <p:spPr>
            <a:xfrm rot="5880000" flipH="1" flipV="1">
              <a:off x="4110261" y="3212375"/>
              <a:ext cx="681746" cy="549655"/>
            </a:xfrm>
            <a:prstGeom prst="line">
              <a:avLst/>
            </a:prstGeom>
            <a:ln w="57150">
              <a:solidFill>
                <a:schemeClr val="tx1"/>
              </a:solidFill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Rounded Rectangle 12"/>
            <p:cNvSpPr/>
            <p:nvPr/>
          </p:nvSpPr>
          <p:spPr>
            <a:xfrm>
              <a:off x="3449465" y="694515"/>
              <a:ext cx="1433838" cy="1729380"/>
            </a:xfrm>
            <a:custGeom>
              <a:avLst/>
              <a:gdLst>
                <a:gd name="connsiteX0" fmla="*/ 0 w 1417935"/>
                <a:gd name="connsiteY0" fmla="*/ 95422 h 572520"/>
                <a:gd name="connsiteX1" fmla="*/ 95422 w 1417935"/>
                <a:gd name="connsiteY1" fmla="*/ 0 h 572520"/>
                <a:gd name="connsiteX2" fmla="*/ 1322513 w 1417935"/>
                <a:gd name="connsiteY2" fmla="*/ 0 h 572520"/>
                <a:gd name="connsiteX3" fmla="*/ 1417935 w 1417935"/>
                <a:gd name="connsiteY3" fmla="*/ 95422 h 572520"/>
                <a:gd name="connsiteX4" fmla="*/ 1417935 w 1417935"/>
                <a:gd name="connsiteY4" fmla="*/ 477098 h 572520"/>
                <a:gd name="connsiteX5" fmla="*/ 1322513 w 1417935"/>
                <a:gd name="connsiteY5" fmla="*/ 572520 h 572520"/>
                <a:gd name="connsiteX6" fmla="*/ 95422 w 1417935"/>
                <a:gd name="connsiteY6" fmla="*/ 572520 h 572520"/>
                <a:gd name="connsiteX7" fmla="*/ 0 w 1417935"/>
                <a:gd name="connsiteY7" fmla="*/ 477098 h 572520"/>
                <a:gd name="connsiteX8" fmla="*/ 0 w 1417935"/>
                <a:gd name="connsiteY8" fmla="*/ 95422 h 572520"/>
                <a:gd name="connsiteX0" fmla="*/ 0 w 1417935"/>
                <a:gd name="connsiteY0" fmla="*/ 978017 h 1455115"/>
                <a:gd name="connsiteX1" fmla="*/ 699721 w 1417935"/>
                <a:gd name="connsiteY1" fmla="*/ 0 h 1455115"/>
                <a:gd name="connsiteX2" fmla="*/ 1322513 w 1417935"/>
                <a:gd name="connsiteY2" fmla="*/ 882595 h 1455115"/>
                <a:gd name="connsiteX3" fmla="*/ 1417935 w 1417935"/>
                <a:gd name="connsiteY3" fmla="*/ 978017 h 1455115"/>
                <a:gd name="connsiteX4" fmla="*/ 1417935 w 1417935"/>
                <a:gd name="connsiteY4" fmla="*/ 1359693 h 1455115"/>
                <a:gd name="connsiteX5" fmla="*/ 1322513 w 1417935"/>
                <a:gd name="connsiteY5" fmla="*/ 1455115 h 1455115"/>
                <a:gd name="connsiteX6" fmla="*/ 95422 w 1417935"/>
                <a:gd name="connsiteY6" fmla="*/ 1455115 h 1455115"/>
                <a:gd name="connsiteX7" fmla="*/ 0 w 1417935"/>
                <a:gd name="connsiteY7" fmla="*/ 1359693 h 1455115"/>
                <a:gd name="connsiteX8" fmla="*/ 0 w 1417935"/>
                <a:gd name="connsiteY8" fmla="*/ 978017 h 1455115"/>
                <a:gd name="connsiteX0" fmla="*/ 357808 w 1417935"/>
                <a:gd name="connsiteY0" fmla="*/ 985968 h 1455115"/>
                <a:gd name="connsiteX1" fmla="*/ 699721 w 1417935"/>
                <a:gd name="connsiteY1" fmla="*/ 0 h 1455115"/>
                <a:gd name="connsiteX2" fmla="*/ 1322513 w 1417935"/>
                <a:gd name="connsiteY2" fmla="*/ 882595 h 1455115"/>
                <a:gd name="connsiteX3" fmla="*/ 1417935 w 1417935"/>
                <a:gd name="connsiteY3" fmla="*/ 978017 h 1455115"/>
                <a:gd name="connsiteX4" fmla="*/ 1417935 w 1417935"/>
                <a:gd name="connsiteY4" fmla="*/ 1359693 h 1455115"/>
                <a:gd name="connsiteX5" fmla="*/ 1322513 w 1417935"/>
                <a:gd name="connsiteY5" fmla="*/ 1455115 h 1455115"/>
                <a:gd name="connsiteX6" fmla="*/ 95422 w 1417935"/>
                <a:gd name="connsiteY6" fmla="*/ 1455115 h 1455115"/>
                <a:gd name="connsiteX7" fmla="*/ 0 w 1417935"/>
                <a:gd name="connsiteY7" fmla="*/ 1359693 h 1455115"/>
                <a:gd name="connsiteX8" fmla="*/ 357808 w 1417935"/>
                <a:gd name="connsiteY8" fmla="*/ 985968 h 1455115"/>
                <a:gd name="connsiteX0" fmla="*/ 357808 w 1417935"/>
                <a:gd name="connsiteY0" fmla="*/ 985968 h 1455115"/>
                <a:gd name="connsiteX1" fmla="*/ 699721 w 1417935"/>
                <a:gd name="connsiteY1" fmla="*/ 0 h 1455115"/>
                <a:gd name="connsiteX2" fmla="*/ 1322513 w 1417935"/>
                <a:gd name="connsiteY2" fmla="*/ 882595 h 1455115"/>
                <a:gd name="connsiteX3" fmla="*/ 1417935 w 1417935"/>
                <a:gd name="connsiteY3" fmla="*/ 978017 h 1455115"/>
                <a:gd name="connsiteX4" fmla="*/ 1417935 w 1417935"/>
                <a:gd name="connsiteY4" fmla="*/ 1359693 h 1455115"/>
                <a:gd name="connsiteX5" fmla="*/ 1322513 w 1417935"/>
                <a:gd name="connsiteY5" fmla="*/ 1455115 h 1455115"/>
                <a:gd name="connsiteX6" fmla="*/ 95422 w 1417935"/>
                <a:gd name="connsiteY6" fmla="*/ 1455115 h 1455115"/>
                <a:gd name="connsiteX7" fmla="*/ 0 w 1417935"/>
                <a:gd name="connsiteY7" fmla="*/ 1359693 h 1455115"/>
                <a:gd name="connsiteX8" fmla="*/ 357808 w 1417935"/>
                <a:gd name="connsiteY8" fmla="*/ 985968 h 1455115"/>
                <a:gd name="connsiteX0" fmla="*/ 357808 w 1417935"/>
                <a:gd name="connsiteY0" fmla="*/ 985968 h 1455115"/>
                <a:gd name="connsiteX1" fmla="*/ 699721 w 1417935"/>
                <a:gd name="connsiteY1" fmla="*/ 0 h 1455115"/>
                <a:gd name="connsiteX2" fmla="*/ 1044217 w 1417935"/>
                <a:gd name="connsiteY2" fmla="*/ 954157 h 1455115"/>
                <a:gd name="connsiteX3" fmla="*/ 1417935 w 1417935"/>
                <a:gd name="connsiteY3" fmla="*/ 978017 h 1455115"/>
                <a:gd name="connsiteX4" fmla="*/ 1417935 w 1417935"/>
                <a:gd name="connsiteY4" fmla="*/ 1359693 h 1455115"/>
                <a:gd name="connsiteX5" fmla="*/ 1322513 w 1417935"/>
                <a:gd name="connsiteY5" fmla="*/ 1455115 h 1455115"/>
                <a:gd name="connsiteX6" fmla="*/ 95422 w 1417935"/>
                <a:gd name="connsiteY6" fmla="*/ 1455115 h 1455115"/>
                <a:gd name="connsiteX7" fmla="*/ 0 w 1417935"/>
                <a:gd name="connsiteY7" fmla="*/ 1359693 h 1455115"/>
                <a:gd name="connsiteX8" fmla="*/ 357808 w 1417935"/>
                <a:gd name="connsiteY8" fmla="*/ 985968 h 1455115"/>
                <a:gd name="connsiteX0" fmla="*/ 357808 w 1417935"/>
                <a:gd name="connsiteY0" fmla="*/ 985968 h 1455115"/>
                <a:gd name="connsiteX1" fmla="*/ 699721 w 1417935"/>
                <a:gd name="connsiteY1" fmla="*/ 0 h 1455115"/>
                <a:gd name="connsiteX2" fmla="*/ 1044217 w 1417935"/>
                <a:gd name="connsiteY2" fmla="*/ 954157 h 1455115"/>
                <a:gd name="connsiteX3" fmla="*/ 1290714 w 1417935"/>
                <a:gd name="connsiteY3" fmla="*/ 1041627 h 1455115"/>
                <a:gd name="connsiteX4" fmla="*/ 1417935 w 1417935"/>
                <a:gd name="connsiteY4" fmla="*/ 1359693 h 1455115"/>
                <a:gd name="connsiteX5" fmla="*/ 1322513 w 1417935"/>
                <a:gd name="connsiteY5" fmla="*/ 1455115 h 1455115"/>
                <a:gd name="connsiteX6" fmla="*/ 95422 w 1417935"/>
                <a:gd name="connsiteY6" fmla="*/ 1455115 h 1455115"/>
                <a:gd name="connsiteX7" fmla="*/ 0 w 1417935"/>
                <a:gd name="connsiteY7" fmla="*/ 1359693 h 1455115"/>
                <a:gd name="connsiteX8" fmla="*/ 357808 w 1417935"/>
                <a:gd name="connsiteY8" fmla="*/ 985968 h 1455115"/>
                <a:gd name="connsiteX0" fmla="*/ 357808 w 1417935"/>
                <a:gd name="connsiteY0" fmla="*/ 1071289 h 1540436"/>
                <a:gd name="connsiteX1" fmla="*/ 699721 w 1417935"/>
                <a:gd name="connsiteY1" fmla="*/ 85321 h 1540436"/>
                <a:gd name="connsiteX2" fmla="*/ 1002221 w 1417935"/>
                <a:gd name="connsiteY2" fmla="*/ 159632 h 1540436"/>
                <a:gd name="connsiteX3" fmla="*/ 1044217 w 1417935"/>
                <a:gd name="connsiteY3" fmla="*/ 1039478 h 1540436"/>
                <a:gd name="connsiteX4" fmla="*/ 1290714 w 1417935"/>
                <a:gd name="connsiteY4" fmla="*/ 1126948 h 1540436"/>
                <a:gd name="connsiteX5" fmla="*/ 1417935 w 1417935"/>
                <a:gd name="connsiteY5" fmla="*/ 1445014 h 1540436"/>
                <a:gd name="connsiteX6" fmla="*/ 1322513 w 1417935"/>
                <a:gd name="connsiteY6" fmla="*/ 1540436 h 1540436"/>
                <a:gd name="connsiteX7" fmla="*/ 95422 w 1417935"/>
                <a:gd name="connsiteY7" fmla="*/ 1540436 h 1540436"/>
                <a:gd name="connsiteX8" fmla="*/ 0 w 1417935"/>
                <a:gd name="connsiteY8" fmla="*/ 1445014 h 1540436"/>
                <a:gd name="connsiteX9" fmla="*/ 357808 w 1417935"/>
                <a:gd name="connsiteY9" fmla="*/ 1071289 h 1540436"/>
                <a:gd name="connsiteX0" fmla="*/ 357808 w 1417935"/>
                <a:gd name="connsiteY0" fmla="*/ 1056120 h 1525267"/>
                <a:gd name="connsiteX1" fmla="*/ 548646 w 1417935"/>
                <a:gd name="connsiteY1" fmla="*/ 94006 h 1525267"/>
                <a:gd name="connsiteX2" fmla="*/ 1002221 w 1417935"/>
                <a:gd name="connsiteY2" fmla="*/ 144463 h 1525267"/>
                <a:gd name="connsiteX3" fmla="*/ 1044217 w 1417935"/>
                <a:gd name="connsiteY3" fmla="*/ 1024309 h 1525267"/>
                <a:gd name="connsiteX4" fmla="*/ 1290714 w 1417935"/>
                <a:gd name="connsiteY4" fmla="*/ 1111779 h 1525267"/>
                <a:gd name="connsiteX5" fmla="*/ 1417935 w 1417935"/>
                <a:gd name="connsiteY5" fmla="*/ 1429845 h 1525267"/>
                <a:gd name="connsiteX6" fmla="*/ 1322513 w 1417935"/>
                <a:gd name="connsiteY6" fmla="*/ 1525267 h 1525267"/>
                <a:gd name="connsiteX7" fmla="*/ 95422 w 1417935"/>
                <a:gd name="connsiteY7" fmla="*/ 1525267 h 1525267"/>
                <a:gd name="connsiteX8" fmla="*/ 0 w 1417935"/>
                <a:gd name="connsiteY8" fmla="*/ 1429845 h 1525267"/>
                <a:gd name="connsiteX9" fmla="*/ 357808 w 1417935"/>
                <a:gd name="connsiteY9" fmla="*/ 1056120 h 1525267"/>
                <a:gd name="connsiteX0" fmla="*/ 357808 w 1417935"/>
                <a:gd name="connsiteY0" fmla="*/ 1174872 h 1644019"/>
                <a:gd name="connsiteX1" fmla="*/ 461182 w 1417935"/>
                <a:gd name="connsiteY1" fmla="*/ 53732 h 1644019"/>
                <a:gd name="connsiteX2" fmla="*/ 1002221 w 1417935"/>
                <a:gd name="connsiteY2" fmla="*/ 263215 h 1644019"/>
                <a:gd name="connsiteX3" fmla="*/ 1044217 w 1417935"/>
                <a:gd name="connsiteY3" fmla="*/ 1143061 h 1644019"/>
                <a:gd name="connsiteX4" fmla="*/ 1290714 w 1417935"/>
                <a:gd name="connsiteY4" fmla="*/ 1230531 h 1644019"/>
                <a:gd name="connsiteX5" fmla="*/ 1417935 w 1417935"/>
                <a:gd name="connsiteY5" fmla="*/ 1548597 h 1644019"/>
                <a:gd name="connsiteX6" fmla="*/ 1322513 w 1417935"/>
                <a:gd name="connsiteY6" fmla="*/ 1644019 h 1644019"/>
                <a:gd name="connsiteX7" fmla="*/ 95422 w 1417935"/>
                <a:gd name="connsiteY7" fmla="*/ 1644019 h 1644019"/>
                <a:gd name="connsiteX8" fmla="*/ 0 w 1417935"/>
                <a:gd name="connsiteY8" fmla="*/ 1548597 h 1644019"/>
                <a:gd name="connsiteX9" fmla="*/ 357808 w 1417935"/>
                <a:gd name="connsiteY9" fmla="*/ 1174872 h 1644019"/>
                <a:gd name="connsiteX0" fmla="*/ 357808 w 1417935"/>
                <a:gd name="connsiteY0" fmla="*/ 1249033 h 1718180"/>
                <a:gd name="connsiteX1" fmla="*/ 461182 w 1417935"/>
                <a:gd name="connsiteY1" fmla="*/ 127893 h 1718180"/>
                <a:gd name="connsiteX2" fmla="*/ 1002221 w 1417935"/>
                <a:gd name="connsiteY2" fmla="*/ 106789 h 1718180"/>
                <a:gd name="connsiteX3" fmla="*/ 1044217 w 1417935"/>
                <a:gd name="connsiteY3" fmla="*/ 1217222 h 1718180"/>
                <a:gd name="connsiteX4" fmla="*/ 1290714 w 1417935"/>
                <a:gd name="connsiteY4" fmla="*/ 1304692 h 1718180"/>
                <a:gd name="connsiteX5" fmla="*/ 1417935 w 1417935"/>
                <a:gd name="connsiteY5" fmla="*/ 1622758 h 1718180"/>
                <a:gd name="connsiteX6" fmla="*/ 1322513 w 1417935"/>
                <a:gd name="connsiteY6" fmla="*/ 1718180 h 1718180"/>
                <a:gd name="connsiteX7" fmla="*/ 95422 w 1417935"/>
                <a:gd name="connsiteY7" fmla="*/ 1718180 h 1718180"/>
                <a:gd name="connsiteX8" fmla="*/ 0 w 1417935"/>
                <a:gd name="connsiteY8" fmla="*/ 1622758 h 1718180"/>
                <a:gd name="connsiteX9" fmla="*/ 357808 w 1417935"/>
                <a:gd name="connsiteY9" fmla="*/ 1249033 h 1718180"/>
                <a:gd name="connsiteX0" fmla="*/ 357808 w 1417935"/>
                <a:gd name="connsiteY0" fmla="*/ 1249033 h 1718180"/>
                <a:gd name="connsiteX1" fmla="*/ 461182 w 1417935"/>
                <a:gd name="connsiteY1" fmla="*/ 127893 h 1718180"/>
                <a:gd name="connsiteX2" fmla="*/ 1002221 w 1417935"/>
                <a:gd name="connsiteY2" fmla="*/ 106789 h 1718180"/>
                <a:gd name="connsiteX3" fmla="*/ 1004461 w 1417935"/>
                <a:gd name="connsiteY3" fmla="*/ 1280832 h 1718180"/>
                <a:gd name="connsiteX4" fmla="*/ 1290714 w 1417935"/>
                <a:gd name="connsiteY4" fmla="*/ 1304692 h 1718180"/>
                <a:gd name="connsiteX5" fmla="*/ 1417935 w 1417935"/>
                <a:gd name="connsiteY5" fmla="*/ 1622758 h 1718180"/>
                <a:gd name="connsiteX6" fmla="*/ 1322513 w 1417935"/>
                <a:gd name="connsiteY6" fmla="*/ 1718180 h 1718180"/>
                <a:gd name="connsiteX7" fmla="*/ 95422 w 1417935"/>
                <a:gd name="connsiteY7" fmla="*/ 1718180 h 1718180"/>
                <a:gd name="connsiteX8" fmla="*/ 0 w 1417935"/>
                <a:gd name="connsiteY8" fmla="*/ 1622758 h 1718180"/>
                <a:gd name="connsiteX9" fmla="*/ 357808 w 1417935"/>
                <a:gd name="connsiteY9" fmla="*/ 1249033 h 1718180"/>
                <a:gd name="connsiteX0" fmla="*/ 421419 w 1417935"/>
                <a:gd name="connsiteY0" fmla="*/ 1209276 h 1718180"/>
                <a:gd name="connsiteX1" fmla="*/ 461182 w 1417935"/>
                <a:gd name="connsiteY1" fmla="*/ 127893 h 1718180"/>
                <a:gd name="connsiteX2" fmla="*/ 1002221 w 1417935"/>
                <a:gd name="connsiteY2" fmla="*/ 106789 h 1718180"/>
                <a:gd name="connsiteX3" fmla="*/ 1004461 w 1417935"/>
                <a:gd name="connsiteY3" fmla="*/ 1280832 h 1718180"/>
                <a:gd name="connsiteX4" fmla="*/ 1290714 w 1417935"/>
                <a:gd name="connsiteY4" fmla="*/ 1304692 h 1718180"/>
                <a:gd name="connsiteX5" fmla="*/ 1417935 w 1417935"/>
                <a:gd name="connsiteY5" fmla="*/ 1622758 h 1718180"/>
                <a:gd name="connsiteX6" fmla="*/ 1322513 w 1417935"/>
                <a:gd name="connsiteY6" fmla="*/ 1718180 h 1718180"/>
                <a:gd name="connsiteX7" fmla="*/ 95422 w 1417935"/>
                <a:gd name="connsiteY7" fmla="*/ 1718180 h 1718180"/>
                <a:gd name="connsiteX8" fmla="*/ 0 w 1417935"/>
                <a:gd name="connsiteY8" fmla="*/ 1622758 h 1718180"/>
                <a:gd name="connsiteX9" fmla="*/ 421419 w 1417935"/>
                <a:gd name="connsiteY9" fmla="*/ 1209276 h 1718180"/>
                <a:gd name="connsiteX0" fmla="*/ 421419 w 1417935"/>
                <a:gd name="connsiteY0" fmla="*/ 1209276 h 1718180"/>
                <a:gd name="connsiteX1" fmla="*/ 461182 w 1417935"/>
                <a:gd name="connsiteY1" fmla="*/ 127893 h 1718180"/>
                <a:gd name="connsiteX2" fmla="*/ 1002221 w 1417935"/>
                <a:gd name="connsiteY2" fmla="*/ 106789 h 1718180"/>
                <a:gd name="connsiteX3" fmla="*/ 1004461 w 1417935"/>
                <a:gd name="connsiteY3" fmla="*/ 1280832 h 1718180"/>
                <a:gd name="connsiteX4" fmla="*/ 1290714 w 1417935"/>
                <a:gd name="connsiteY4" fmla="*/ 1304692 h 1718180"/>
                <a:gd name="connsiteX5" fmla="*/ 1417935 w 1417935"/>
                <a:gd name="connsiteY5" fmla="*/ 1622758 h 1718180"/>
                <a:gd name="connsiteX6" fmla="*/ 1322513 w 1417935"/>
                <a:gd name="connsiteY6" fmla="*/ 1718180 h 1718180"/>
                <a:gd name="connsiteX7" fmla="*/ 95422 w 1417935"/>
                <a:gd name="connsiteY7" fmla="*/ 1718180 h 1718180"/>
                <a:gd name="connsiteX8" fmla="*/ 0 w 1417935"/>
                <a:gd name="connsiteY8" fmla="*/ 1622758 h 1718180"/>
                <a:gd name="connsiteX9" fmla="*/ 119626 w 1417935"/>
                <a:gd name="connsiteY9" fmla="*/ 1299484 h 1718180"/>
                <a:gd name="connsiteX10" fmla="*/ 421419 w 1417935"/>
                <a:gd name="connsiteY10" fmla="*/ 1209276 h 1718180"/>
                <a:gd name="connsiteX0" fmla="*/ 461175 w 1417935"/>
                <a:gd name="connsiteY0" fmla="*/ 1177470 h 1718180"/>
                <a:gd name="connsiteX1" fmla="*/ 461182 w 1417935"/>
                <a:gd name="connsiteY1" fmla="*/ 127893 h 1718180"/>
                <a:gd name="connsiteX2" fmla="*/ 1002221 w 1417935"/>
                <a:gd name="connsiteY2" fmla="*/ 106789 h 1718180"/>
                <a:gd name="connsiteX3" fmla="*/ 1004461 w 1417935"/>
                <a:gd name="connsiteY3" fmla="*/ 1280832 h 1718180"/>
                <a:gd name="connsiteX4" fmla="*/ 1290714 w 1417935"/>
                <a:gd name="connsiteY4" fmla="*/ 1304692 h 1718180"/>
                <a:gd name="connsiteX5" fmla="*/ 1417935 w 1417935"/>
                <a:gd name="connsiteY5" fmla="*/ 1622758 h 1718180"/>
                <a:gd name="connsiteX6" fmla="*/ 1322513 w 1417935"/>
                <a:gd name="connsiteY6" fmla="*/ 1718180 h 1718180"/>
                <a:gd name="connsiteX7" fmla="*/ 95422 w 1417935"/>
                <a:gd name="connsiteY7" fmla="*/ 1718180 h 1718180"/>
                <a:gd name="connsiteX8" fmla="*/ 0 w 1417935"/>
                <a:gd name="connsiteY8" fmla="*/ 1622758 h 1718180"/>
                <a:gd name="connsiteX9" fmla="*/ 119626 w 1417935"/>
                <a:gd name="connsiteY9" fmla="*/ 1299484 h 1718180"/>
                <a:gd name="connsiteX10" fmla="*/ 461175 w 1417935"/>
                <a:gd name="connsiteY10" fmla="*/ 1177470 h 1718180"/>
                <a:gd name="connsiteX0" fmla="*/ 461175 w 1417935"/>
                <a:gd name="connsiteY0" fmla="*/ 1177470 h 1718180"/>
                <a:gd name="connsiteX1" fmla="*/ 461182 w 1417935"/>
                <a:gd name="connsiteY1" fmla="*/ 127893 h 1718180"/>
                <a:gd name="connsiteX2" fmla="*/ 1002221 w 1417935"/>
                <a:gd name="connsiteY2" fmla="*/ 106789 h 1718180"/>
                <a:gd name="connsiteX3" fmla="*/ 996510 w 1417935"/>
                <a:gd name="connsiteY3" fmla="*/ 1201319 h 1718180"/>
                <a:gd name="connsiteX4" fmla="*/ 1290714 w 1417935"/>
                <a:gd name="connsiteY4" fmla="*/ 1304692 h 1718180"/>
                <a:gd name="connsiteX5" fmla="*/ 1417935 w 1417935"/>
                <a:gd name="connsiteY5" fmla="*/ 1622758 h 1718180"/>
                <a:gd name="connsiteX6" fmla="*/ 1322513 w 1417935"/>
                <a:gd name="connsiteY6" fmla="*/ 1718180 h 1718180"/>
                <a:gd name="connsiteX7" fmla="*/ 95422 w 1417935"/>
                <a:gd name="connsiteY7" fmla="*/ 1718180 h 1718180"/>
                <a:gd name="connsiteX8" fmla="*/ 0 w 1417935"/>
                <a:gd name="connsiteY8" fmla="*/ 1622758 h 1718180"/>
                <a:gd name="connsiteX9" fmla="*/ 119626 w 1417935"/>
                <a:gd name="connsiteY9" fmla="*/ 1299484 h 1718180"/>
                <a:gd name="connsiteX10" fmla="*/ 461175 w 1417935"/>
                <a:gd name="connsiteY10" fmla="*/ 1177470 h 1718180"/>
                <a:gd name="connsiteX0" fmla="*/ 461175 w 1417935"/>
                <a:gd name="connsiteY0" fmla="*/ 1177470 h 1718180"/>
                <a:gd name="connsiteX1" fmla="*/ 461182 w 1417935"/>
                <a:gd name="connsiteY1" fmla="*/ 127893 h 1718180"/>
                <a:gd name="connsiteX2" fmla="*/ 1002221 w 1417935"/>
                <a:gd name="connsiteY2" fmla="*/ 106789 h 1718180"/>
                <a:gd name="connsiteX3" fmla="*/ 996510 w 1417935"/>
                <a:gd name="connsiteY3" fmla="*/ 1201319 h 1718180"/>
                <a:gd name="connsiteX4" fmla="*/ 1417935 w 1417935"/>
                <a:gd name="connsiteY4" fmla="*/ 1288789 h 1718180"/>
                <a:gd name="connsiteX5" fmla="*/ 1417935 w 1417935"/>
                <a:gd name="connsiteY5" fmla="*/ 1622758 h 1718180"/>
                <a:gd name="connsiteX6" fmla="*/ 1322513 w 1417935"/>
                <a:gd name="connsiteY6" fmla="*/ 1718180 h 1718180"/>
                <a:gd name="connsiteX7" fmla="*/ 95422 w 1417935"/>
                <a:gd name="connsiteY7" fmla="*/ 1718180 h 1718180"/>
                <a:gd name="connsiteX8" fmla="*/ 0 w 1417935"/>
                <a:gd name="connsiteY8" fmla="*/ 1622758 h 1718180"/>
                <a:gd name="connsiteX9" fmla="*/ 119626 w 1417935"/>
                <a:gd name="connsiteY9" fmla="*/ 1299484 h 1718180"/>
                <a:gd name="connsiteX10" fmla="*/ 461175 w 1417935"/>
                <a:gd name="connsiteY10" fmla="*/ 1177470 h 1718180"/>
                <a:gd name="connsiteX0" fmla="*/ 461175 w 1417935"/>
                <a:gd name="connsiteY0" fmla="*/ 1177470 h 1718180"/>
                <a:gd name="connsiteX1" fmla="*/ 461182 w 1417935"/>
                <a:gd name="connsiteY1" fmla="*/ 127893 h 1718180"/>
                <a:gd name="connsiteX2" fmla="*/ 1002221 w 1417935"/>
                <a:gd name="connsiteY2" fmla="*/ 106789 h 1718180"/>
                <a:gd name="connsiteX3" fmla="*/ 996510 w 1417935"/>
                <a:gd name="connsiteY3" fmla="*/ 1201319 h 1718180"/>
                <a:gd name="connsiteX4" fmla="*/ 1417935 w 1417935"/>
                <a:gd name="connsiteY4" fmla="*/ 1288789 h 1718180"/>
                <a:gd name="connsiteX5" fmla="*/ 1417935 w 1417935"/>
                <a:gd name="connsiteY5" fmla="*/ 1622758 h 1718180"/>
                <a:gd name="connsiteX6" fmla="*/ 1322513 w 1417935"/>
                <a:gd name="connsiteY6" fmla="*/ 1718180 h 1718180"/>
                <a:gd name="connsiteX7" fmla="*/ 95422 w 1417935"/>
                <a:gd name="connsiteY7" fmla="*/ 1718180 h 1718180"/>
                <a:gd name="connsiteX8" fmla="*/ 0 w 1417935"/>
                <a:gd name="connsiteY8" fmla="*/ 1622758 h 1718180"/>
                <a:gd name="connsiteX9" fmla="*/ 119626 w 1417935"/>
                <a:gd name="connsiteY9" fmla="*/ 1299484 h 1718180"/>
                <a:gd name="connsiteX10" fmla="*/ 461175 w 1417935"/>
                <a:gd name="connsiteY10" fmla="*/ 1177470 h 1718180"/>
                <a:gd name="connsiteX0" fmla="*/ 461175 w 1417935"/>
                <a:gd name="connsiteY0" fmla="*/ 1177470 h 1718180"/>
                <a:gd name="connsiteX1" fmla="*/ 461182 w 1417935"/>
                <a:gd name="connsiteY1" fmla="*/ 127893 h 1718180"/>
                <a:gd name="connsiteX2" fmla="*/ 1002221 w 1417935"/>
                <a:gd name="connsiteY2" fmla="*/ 106789 h 1718180"/>
                <a:gd name="connsiteX3" fmla="*/ 980608 w 1417935"/>
                <a:gd name="connsiteY3" fmla="*/ 1249027 h 1718180"/>
                <a:gd name="connsiteX4" fmla="*/ 1417935 w 1417935"/>
                <a:gd name="connsiteY4" fmla="*/ 1288789 h 1718180"/>
                <a:gd name="connsiteX5" fmla="*/ 1417935 w 1417935"/>
                <a:gd name="connsiteY5" fmla="*/ 1622758 h 1718180"/>
                <a:gd name="connsiteX6" fmla="*/ 1322513 w 1417935"/>
                <a:gd name="connsiteY6" fmla="*/ 1718180 h 1718180"/>
                <a:gd name="connsiteX7" fmla="*/ 95422 w 1417935"/>
                <a:gd name="connsiteY7" fmla="*/ 1718180 h 1718180"/>
                <a:gd name="connsiteX8" fmla="*/ 0 w 1417935"/>
                <a:gd name="connsiteY8" fmla="*/ 1622758 h 1718180"/>
                <a:gd name="connsiteX9" fmla="*/ 119626 w 1417935"/>
                <a:gd name="connsiteY9" fmla="*/ 1299484 h 1718180"/>
                <a:gd name="connsiteX10" fmla="*/ 461175 w 1417935"/>
                <a:gd name="connsiteY10" fmla="*/ 1177470 h 1718180"/>
                <a:gd name="connsiteX0" fmla="*/ 461175 w 1417935"/>
                <a:gd name="connsiteY0" fmla="*/ 1177470 h 1718180"/>
                <a:gd name="connsiteX1" fmla="*/ 461182 w 1417935"/>
                <a:gd name="connsiteY1" fmla="*/ 127893 h 1718180"/>
                <a:gd name="connsiteX2" fmla="*/ 1002221 w 1417935"/>
                <a:gd name="connsiteY2" fmla="*/ 106789 h 1718180"/>
                <a:gd name="connsiteX3" fmla="*/ 980608 w 1417935"/>
                <a:gd name="connsiteY3" fmla="*/ 1249027 h 1718180"/>
                <a:gd name="connsiteX4" fmla="*/ 1417935 w 1417935"/>
                <a:gd name="connsiteY4" fmla="*/ 1288789 h 1718180"/>
                <a:gd name="connsiteX5" fmla="*/ 1417935 w 1417935"/>
                <a:gd name="connsiteY5" fmla="*/ 1622758 h 1718180"/>
                <a:gd name="connsiteX6" fmla="*/ 1322513 w 1417935"/>
                <a:gd name="connsiteY6" fmla="*/ 1718180 h 1718180"/>
                <a:gd name="connsiteX7" fmla="*/ 95422 w 1417935"/>
                <a:gd name="connsiteY7" fmla="*/ 1718180 h 1718180"/>
                <a:gd name="connsiteX8" fmla="*/ 0 w 1417935"/>
                <a:gd name="connsiteY8" fmla="*/ 1622758 h 1718180"/>
                <a:gd name="connsiteX9" fmla="*/ 119626 w 1417935"/>
                <a:gd name="connsiteY9" fmla="*/ 1299484 h 1718180"/>
                <a:gd name="connsiteX10" fmla="*/ 461175 w 1417935"/>
                <a:gd name="connsiteY10" fmla="*/ 1177470 h 1718180"/>
                <a:gd name="connsiteX0" fmla="*/ 461175 w 1417935"/>
                <a:gd name="connsiteY0" fmla="*/ 1177470 h 1718180"/>
                <a:gd name="connsiteX1" fmla="*/ 461182 w 1417935"/>
                <a:gd name="connsiteY1" fmla="*/ 127893 h 1718180"/>
                <a:gd name="connsiteX2" fmla="*/ 1002221 w 1417935"/>
                <a:gd name="connsiteY2" fmla="*/ 106789 h 1718180"/>
                <a:gd name="connsiteX3" fmla="*/ 980608 w 1417935"/>
                <a:gd name="connsiteY3" fmla="*/ 1249027 h 1718180"/>
                <a:gd name="connsiteX4" fmla="*/ 1417935 w 1417935"/>
                <a:gd name="connsiteY4" fmla="*/ 1288789 h 1718180"/>
                <a:gd name="connsiteX5" fmla="*/ 1417935 w 1417935"/>
                <a:gd name="connsiteY5" fmla="*/ 1622758 h 1718180"/>
                <a:gd name="connsiteX6" fmla="*/ 1322513 w 1417935"/>
                <a:gd name="connsiteY6" fmla="*/ 1718180 h 1718180"/>
                <a:gd name="connsiteX7" fmla="*/ 95422 w 1417935"/>
                <a:gd name="connsiteY7" fmla="*/ 1718180 h 1718180"/>
                <a:gd name="connsiteX8" fmla="*/ 0 w 1417935"/>
                <a:gd name="connsiteY8" fmla="*/ 1622758 h 1718180"/>
                <a:gd name="connsiteX9" fmla="*/ 40113 w 1417935"/>
                <a:gd name="connsiteY9" fmla="*/ 1299484 h 1718180"/>
                <a:gd name="connsiteX10" fmla="*/ 461175 w 1417935"/>
                <a:gd name="connsiteY10" fmla="*/ 1177470 h 1718180"/>
                <a:gd name="connsiteX0" fmla="*/ 421418 w 1417935"/>
                <a:gd name="connsiteY0" fmla="*/ 1217227 h 1718180"/>
                <a:gd name="connsiteX1" fmla="*/ 461182 w 1417935"/>
                <a:gd name="connsiteY1" fmla="*/ 127893 h 1718180"/>
                <a:gd name="connsiteX2" fmla="*/ 1002221 w 1417935"/>
                <a:gd name="connsiteY2" fmla="*/ 106789 h 1718180"/>
                <a:gd name="connsiteX3" fmla="*/ 980608 w 1417935"/>
                <a:gd name="connsiteY3" fmla="*/ 1249027 h 1718180"/>
                <a:gd name="connsiteX4" fmla="*/ 1417935 w 1417935"/>
                <a:gd name="connsiteY4" fmla="*/ 1288789 h 1718180"/>
                <a:gd name="connsiteX5" fmla="*/ 1417935 w 1417935"/>
                <a:gd name="connsiteY5" fmla="*/ 1622758 h 1718180"/>
                <a:gd name="connsiteX6" fmla="*/ 1322513 w 1417935"/>
                <a:gd name="connsiteY6" fmla="*/ 1718180 h 1718180"/>
                <a:gd name="connsiteX7" fmla="*/ 95422 w 1417935"/>
                <a:gd name="connsiteY7" fmla="*/ 1718180 h 1718180"/>
                <a:gd name="connsiteX8" fmla="*/ 0 w 1417935"/>
                <a:gd name="connsiteY8" fmla="*/ 1622758 h 1718180"/>
                <a:gd name="connsiteX9" fmla="*/ 40113 w 1417935"/>
                <a:gd name="connsiteY9" fmla="*/ 1299484 h 1718180"/>
                <a:gd name="connsiteX10" fmla="*/ 421418 w 1417935"/>
                <a:gd name="connsiteY10" fmla="*/ 1217227 h 1718180"/>
                <a:gd name="connsiteX0" fmla="*/ 421418 w 1417935"/>
                <a:gd name="connsiteY0" fmla="*/ 1217227 h 1718180"/>
                <a:gd name="connsiteX1" fmla="*/ 461182 w 1417935"/>
                <a:gd name="connsiteY1" fmla="*/ 127893 h 1718180"/>
                <a:gd name="connsiteX2" fmla="*/ 1002221 w 1417935"/>
                <a:gd name="connsiteY2" fmla="*/ 106789 h 1718180"/>
                <a:gd name="connsiteX3" fmla="*/ 980608 w 1417935"/>
                <a:gd name="connsiteY3" fmla="*/ 1249027 h 1718180"/>
                <a:gd name="connsiteX4" fmla="*/ 1417935 w 1417935"/>
                <a:gd name="connsiteY4" fmla="*/ 1288789 h 1718180"/>
                <a:gd name="connsiteX5" fmla="*/ 1417935 w 1417935"/>
                <a:gd name="connsiteY5" fmla="*/ 1622758 h 1718180"/>
                <a:gd name="connsiteX6" fmla="*/ 1322513 w 1417935"/>
                <a:gd name="connsiteY6" fmla="*/ 1718180 h 1718180"/>
                <a:gd name="connsiteX7" fmla="*/ 95422 w 1417935"/>
                <a:gd name="connsiteY7" fmla="*/ 1718180 h 1718180"/>
                <a:gd name="connsiteX8" fmla="*/ 0 w 1417935"/>
                <a:gd name="connsiteY8" fmla="*/ 1622758 h 1718180"/>
                <a:gd name="connsiteX9" fmla="*/ 40113 w 1417935"/>
                <a:gd name="connsiteY9" fmla="*/ 1299484 h 1718180"/>
                <a:gd name="connsiteX10" fmla="*/ 421418 w 1417935"/>
                <a:gd name="connsiteY10" fmla="*/ 1217227 h 1718180"/>
                <a:gd name="connsiteX0" fmla="*/ 421418 w 1417935"/>
                <a:gd name="connsiteY0" fmla="*/ 1228427 h 1729380"/>
                <a:gd name="connsiteX1" fmla="*/ 437328 w 1417935"/>
                <a:gd name="connsiteY1" fmla="*/ 115239 h 1729380"/>
                <a:gd name="connsiteX2" fmla="*/ 1002221 w 1417935"/>
                <a:gd name="connsiteY2" fmla="*/ 117989 h 1729380"/>
                <a:gd name="connsiteX3" fmla="*/ 980608 w 1417935"/>
                <a:gd name="connsiteY3" fmla="*/ 1260227 h 1729380"/>
                <a:gd name="connsiteX4" fmla="*/ 1417935 w 1417935"/>
                <a:gd name="connsiteY4" fmla="*/ 1299989 h 1729380"/>
                <a:gd name="connsiteX5" fmla="*/ 1417935 w 1417935"/>
                <a:gd name="connsiteY5" fmla="*/ 1633958 h 1729380"/>
                <a:gd name="connsiteX6" fmla="*/ 1322513 w 1417935"/>
                <a:gd name="connsiteY6" fmla="*/ 1729380 h 1729380"/>
                <a:gd name="connsiteX7" fmla="*/ 95422 w 1417935"/>
                <a:gd name="connsiteY7" fmla="*/ 1729380 h 1729380"/>
                <a:gd name="connsiteX8" fmla="*/ 0 w 1417935"/>
                <a:gd name="connsiteY8" fmla="*/ 1633958 h 1729380"/>
                <a:gd name="connsiteX9" fmla="*/ 40113 w 1417935"/>
                <a:gd name="connsiteY9" fmla="*/ 1310684 h 1729380"/>
                <a:gd name="connsiteX10" fmla="*/ 421418 w 1417935"/>
                <a:gd name="connsiteY10" fmla="*/ 1228427 h 1729380"/>
                <a:gd name="connsiteX0" fmla="*/ 389613 w 1417935"/>
                <a:gd name="connsiteY0" fmla="*/ 1093255 h 1729380"/>
                <a:gd name="connsiteX1" fmla="*/ 437328 w 1417935"/>
                <a:gd name="connsiteY1" fmla="*/ 115239 h 1729380"/>
                <a:gd name="connsiteX2" fmla="*/ 1002221 w 1417935"/>
                <a:gd name="connsiteY2" fmla="*/ 117989 h 1729380"/>
                <a:gd name="connsiteX3" fmla="*/ 980608 w 1417935"/>
                <a:gd name="connsiteY3" fmla="*/ 1260227 h 1729380"/>
                <a:gd name="connsiteX4" fmla="*/ 1417935 w 1417935"/>
                <a:gd name="connsiteY4" fmla="*/ 1299989 h 1729380"/>
                <a:gd name="connsiteX5" fmla="*/ 1417935 w 1417935"/>
                <a:gd name="connsiteY5" fmla="*/ 1633958 h 1729380"/>
                <a:gd name="connsiteX6" fmla="*/ 1322513 w 1417935"/>
                <a:gd name="connsiteY6" fmla="*/ 1729380 h 1729380"/>
                <a:gd name="connsiteX7" fmla="*/ 95422 w 1417935"/>
                <a:gd name="connsiteY7" fmla="*/ 1729380 h 1729380"/>
                <a:gd name="connsiteX8" fmla="*/ 0 w 1417935"/>
                <a:gd name="connsiteY8" fmla="*/ 1633958 h 1729380"/>
                <a:gd name="connsiteX9" fmla="*/ 40113 w 1417935"/>
                <a:gd name="connsiteY9" fmla="*/ 1310684 h 1729380"/>
                <a:gd name="connsiteX10" fmla="*/ 389613 w 1417935"/>
                <a:gd name="connsiteY10" fmla="*/ 1093255 h 1729380"/>
                <a:gd name="connsiteX0" fmla="*/ 389613 w 1417935"/>
                <a:gd name="connsiteY0" fmla="*/ 1093255 h 1729380"/>
                <a:gd name="connsiteX1" fmla="*/ 437328 w 1417935"/>
                <a:gd name="connsiteY1" fmla="*/ 115239 h 1729380"/>
                <a:gd name="connsiteX2" fmla="*/ 1002221 w 1417935"/>
                <a:gd name="connsiteY2" fmla="*/ 117989 h 1729380"/>
                <a:gd name="connsiteX3" fmla="*/ 1099877 w 1417935"/>
                <a:gd name="connsiteY3" fmla="*/ 1148908 h 1729380"/>
                <a:gd name="connsiteX4" fmla="*/ 1417935 w 1417935"/>
                <a:gd name="connsiteY4" fmla="*/ 1299989 h 1729380"/>
                <a:gd name="connsiteX5" fmla="*/ 1417935 w 1417935"/>
                <a:gd name="connsiteY5" fmla="*/ 1633958 h 1729380"/>
                <a:gd name="connsiteX6" fmla="*/ 1322513 w 1417935"/>
                <a:gd name="connsiteY6" fmla="*/ 1729380 h 1729380"/>
                <a:gd name="connsiteX7" fmla="*/ 95422 w 1417935"/>
                <a:gd name="connsiteY7" fmla="*/ 1729380 h 1729380"/>
                <a:gd name="connsiteX8" fmla="*/ 0 w 1417935"/>
                <a:gd name="connsiteY8" fmla="*/ 1633958 h 1729380"/>
                <a:gd name="connsiteX9" fmla="*/ 40113 w 1417935"/>
                <a:gd name="connsiteY9" fmla="*/ 1310684 h 1729380"/>
                <a:gd name="connsiteX10" fmla="*/ 389613 w 1417935"/>
                <a:gd name="connsiteY10" fmla="*/ 1093255 h 1729380"/>
                <a:gd name="connsiteX0" fmla="*/ 357808 w 1417935"/>
                <a:gd name="connsiteY0" fmla="*/ 1093255 h 1729380"/>
                <a:gd name="connsiteX1" fmla="*/ 437328 w 1417935"/>
                <a:gd name="connsiteY1" fmla="*/ 115239 h 1729380"/>
                <a:gd name="connsiteX2" fmla="*/ 1002221 w 1417935"/>
                <a:gd name="connsiteY2" fmla="*/ 117989 h 1729380"/>
                <a:gd name="connsiteX3" fmla="*/ 1099877 w 1417935"/>
                <a:gd name="connsiteY3" fmla="*/ 1148908 h 1729380"/>
                <a:gd name="connsiteX4" fmla="*/ 1417935 w 1417935"/>
                <a:gd name="connsiteY4" fmla="*/ 1299989 h 1729380"/>
                <a:gd name="connsiteX5" fmla="*/ 1417935 w 1417935"/>
                <a:gd name="connsiteY5" fmla="*/ 1633958 h 1729380"/>
                <a:gd name="connsiteX6" fmla="*/ 1322513 w 1417935"/>
                <a:gd name="connsiteY6" fmla="*/ 1729380 h 1729380"/>
                <a:gd name="connsiteX7" fmla="*/ 95422 w 1417935"/>
                <a:gd name="connsiteY7" fmla="*/ 1729380 h 1729380"/>
                <a:gd name="connsiteX8" fmla="*/ 0 w 1417935"/>
                <a:gd name="connsiteY8" fmla="*/ 1633958 h 1729380"/>
                <a:gd name="connsiteX9" fmla="*/ 40113 w 1417935"/>
                <a:gd name="connsiteY9" fmla="*/ 1310684 h 1729380"/>
                <a:gd name="connsiteX10" fmla="*/ 357808 w 1417935"/>
                <a:gd name="connsiteY10" fmla="*/ 1093255 h 1729380"/>
                <a:gd name="connsiteX0" fmla="*/ 357808 w 1417935"/>
                <a:gd name="connsiteY0" fmla="*/ 1093255 h 1729380"/>
                <a:gd name="connsiteX1" fmla="*/ 437328 w 1417935"/>
                <a:gd name="connsiteY1" fmla="*/ 115239 h 1729380"/>
                <a:gd name="connsiteX2" fmla="*/ 1002221 w 1417935"/>
                <a:gd name="connsiteY2" fmla="*/ 117989 h 1729380"/>
                <a:gd name="connsiteX3" fmla="*/ 1020364 w 1417935"/>
                <a:gd name="connsiteY3" fmla="*/ 1109151 h 1729380"/>
                <a:gd name="connsiteX4" fmla="*/ 1417935 w 1417935"/>
                <a:gd name="connsiteY4" fmla="*/ 1299989 h 1729380"/>
                <a:gd name="connsiteX5" fmla="*/ 1417935 w 1417935"/>
                <a:gd name="connsiteY5" fmla="*/ 1633958 h 1729380"/>
                <a:gd name="connsiteX6" fmla="*/ 1322513 w 1417935"/>
                <a:gd name="connsiteY6" fmla="*/ 1729380 h 1729380"/>
                <a:gd name="connsiteX7" fmla="*/ 95422 w 1417935"/>
                <a:gd name="connsiteY7" fmla="*/ 1729380 h 1729380"/>
                <a:gd name="connsiteX8" fmla="*/ 0 w 1417935"/>
                <a:gd name="connsiteY8" fmla="*/ 1633958 h 1729380"/>
                <a:gd name="connsiteX9" fmla="*/ 40113 w 1417935"/>
                <a:gd name="connsiteY9" fmla="*/ 1310684 h 1729380"/>
                <a:gd name="connsiteX10" fmla="*/ 357808 w 1417935"/>
                <a:gd name="connsiteY10" fmla="*/ 1093255 h 1729380"/>
                <a:gd name="connsiteX0" fmla="*/ 357808 w 1417935"/>
                <a:gd name="connsiteY0" fmla="*/ 1093255 h 1729380"/>
                <a:gd name="connsiteX1" fmla="*/ 437328 w 1417935"/>
                <a:gd name="connsiteY1" fmla="*/ 115239 h 1729380"/>
                <a:gd name="connsiteX2" fmla="*/ 1002221 w 1417935"/>
                <a:gd name="connsiteY2" fmla="*/ 117989 h 1729380"/>
                <a:gd name="connsiteX3" fmla="*/ 1020364 w 1417935"/>
                <a:gd name="connsiteY3" fmla="*/ 1109151 h 1729380"/>
                <a:gd name="connsiteX4" fmla="*/ 1378179 w 1417935"/>
                <a:gd name="connsiteY4" fmla="*/ 1315891 h 1729380"/>
                <a:gd name="connsiteX5" fmla="*/ 1417935 w 1417935"/>
                <a:gd name="connsiteY5" fmla="*/ 1633958 h 1729380"/>
                <a:gd name="connsiteX6" fmla="*/ 1322513 w 1417935"/>
                <a:gd name="connsiteY6" fmla="*/ 1729380 h 1729380"/>
                <a:gd name="connsiteX7" fmla="*/ 95422 w 1417935"/>
                <a:gd name="connsiteY7" fmla="*/ 1729380 h 1729380"/>
                <a:gd name="connsiteX8" fmla="*/ 0 w 1417935"/>
                <a:gd name="connsiteY8" fmla="*/ 1633958 h 1729380"/>
                <a:gd name="connsiteX9" fmla="*/ 40113 w 1417935"/>
                <a:gd name="connsiteY9" fmla="*/ 1310684 h 1729380"/>
                <a:gd name="connsiteX10" fmla="*/ 357808 w 1417935"/>
                <a:gd name="connsiteY10" fmla="*/ 1093255 h 1729380"/>
                <a:gd name="connsiteX0" fmla="*/ 357808 w 1433838"/>
                <a:gd name="connsiteY0" fmla="*/ 1093255 h 1729380"/>
                <a:gd name="connsiteX1" fmla="*/ 437328 w 1433838"/>
                <a:gd name="connsiteY1" fmla="*/ 115239 h 1729380"/>
                <a:gd name="connsiteX2" fmla="*/ 1002221 w 1433838"/>
                <a:gd name="connsiteY2" fmla="*/ 117989 h 1729380"/>
                <a:gd name="connsiteX3" fmla="*/ 1020364 w 1433838"/>
                <a:gd name="connsiteY3" fmla="*/ 1109151 h 1729380"/>
                <a:gd name="connsiteX4" fmla="*/ 1433838 w 1433838"/>
                <a:gd name="connsiteY4" fmla="*/ 1323842 h 1729380"/>
                <a:gd name="connsiteX5" fmla="*/ 1417935 w 1433838"/>
                <a:gd name="connsiteY5" fmla="*/ 1633958 h 1729380"/>
                <a:gd name="connsiteX6" fmla="*/ 1322513 w 1433838"/>
                <a:gd name="connsiteY6" fmla="*/ 1729380 h 1729380"/>
                <a:gd name="connsiteX7" fmla="*/ 95422 w 1433838"/>
                <a:gd name="connsiteY7" fmla="*/ 1729380 h 1729380"/>
                <a:gd name="connsiteX8" fmla="*/ 0 w 1433838"/>
                <a:gd name="connsiteY8" fmla="*/ 1633958 h 1729380"/>
                <a:gd name="connsiteX9" fmla="*/ 40113 w 1433838"/>
                <a:gd name="connsiteY9" fmla="*/ 1310684 h 1729380"/>
                <a:gd name="connsiteX10" fmla="*/ 357808 w 1433838"/>
                <a:gd name="connsiteY10" fmla="*/ 1093255 h 1729380"/>
                <a:gd name="connsiteX0" fmla="*/ 397564 w 1433838"/>
                <a:gd name="connsiteY0" fmla="*/ 1077352 h 1729380"/>
                <a:gd name="connsiteX1" fmla="*/ 437328 w 1433838"/>
                <a:gd name="connsiteY1" fmla="*/ 115239 h 1729380"/>
                <a:gd name="connsiteX2" fmla="*/ 1002221 w 1433838"/>
                <a:gd name="connsiteY2" fmla="*/ 117989 h 1729380"/>
                <a:gd name="connsiteX3" fmla="*/ 1020364 w 1433838"/>
                <a:gd name="connsiteY3" fmla="*/ 1109151 h 1729380"/>
                <a:gd name="connsiteX4" fmla="*/ 1433838 w 1433838"/>
                <a:gd name="connsiteY4" fmla="*/ 1323842 h 1729380"/>
                <a:gd name="connsiteX5" fmla="*/ 1417935 w 1433838"/>
                <a:gd name="connsiteY5" fmla="*/ 1633958 h 1729380"/>
                <a:gd name="connsiteX6" fmla="*/ 1322513 w 1433838"/>
                <a:gd name="connsiteY6" fmla="*/ 1729380 h 1729380"/>
                <a:gd name="connsiteX7" fmla="*/ 95422 w 1433838"/>
                <a:gd name="connsiteY7" fmla="*/ 1729380 h 1729380"/>
                <a:gd name="connsiteX8" fmla="*/ 0 w 1433838"/>
                <a:gd name="connsiteY8" fmla="*/ 1633958 h 1729380"/>
                <a:gd name="connsiteX9" fmla="*/ 40113 w 1433838"/>
                <a:gd name="connsiteY9" fmla="*/ 1310684 h 1729380"/>
                <a:gd name="connsiteX10" fmla="*/ 397564 w 1433838"/>
                <a:gd name="connsiteY10" fmla="*/ 1077352 h 1729380"/>
                <a:gd name="connsiteX0" fmla="*/ 389613 w 1433838"/>
                <a:gd name="connsiteY0" fmla="*/ 1125059 h 1729380"/>
                <a:gd name="connsiteX1" fmla="*/ 437328 w 1433838"/>
                <a:gd name="connsiteY1" fmla="*/ 115239 h 1729380"/>
                <a:gd name="connsiteX2" fmla="*/ 1002221 w 1433838"/>
                <a:gd name="connsiteY2" fmla="*/ 117989 h 1729380"/>
                <a:gd name="connsiteX3" fmla="*/ 1020364 w 1433838"/>
                <a:gd name="connsiteY3" fmla="*/ 1109151 h 1729380"/>
                <a:gd name="connsiteX4" fmla="*/ 1433838 w 1433838"/>
                <a:gd name="connsiteY4" fmla="*/ 1323842 h 1729380"/>
                <a:gd name="connsiteX5" fmla="*/ 1417935 w 1433838"/>
                <a:gd name="connsiteY5" fmla="*/ 1633958 h 1729380"/>
                <a:gd name="connsiteX6" fmla="*/ 1322513 w 1433838"/>
                <a:gd name="connsiteY6" fmla="*/ 1729380 h 1729380"/>
                <a:gd name="connsiteX7" fmla="*/ 95422 w 1433838"/>
                <a:gd name="connsiteY7" fmla="*/ 1729380 h 1729380"/>
                <a:gd name="connsiteX8" fmla="*/ 0 w 1433838"/>
                <a:gd name="connsiteY8" fmla="*/ 1633958 h 1729380"/>
                <a:gd name="connsiteX9" fmla="*/ 40113 w 1433838"/>
                <a:gd name="connsiteY9" fmla="*/ 1310684 h 1729380"/>
                <a:gd name="connsiteX10" fmla="*/ 389613 w 1433838"/>
                <a:gd name="connsiteY10" fmla="*/ 1125059 h 1729380"/>
                <a:gd name="connsiteX0" fmla="*/ 399370 w 1443595"/>
                <a:gd name="connsiteY0" fmla="*/ 1125059 h 1729380"/>
                <a:gd name="connsiteX1" fmla="*/ 447085 w 1443595"/>
                <a:gd name="connsiteY1" fmla="*/ 115239 h 1729380"/>
                <a:gd name="connsiteX2" fmla="*/ 1011978 w 1443595"/>
                <a:gd name="connsiteY2" fmla="*/ 117989 h 1729380"/>
                <a:gd name="connsiteX3" fmla="*/ 1030121 w 1443595"/>
                <a:gd name="connsiteY3" fmla="*/ 1109151 h 1729380"/>
                <a:gd name="connsiteX4" fmla="*/ 1443595 w 1443595"/>
                <a:gd name="connsiteY4" fmla="*/ 1323842 h 1729380"/>
                <a:gd name="connsiteX5" fmla="*/ 1427692 w 1443595"/>
                <a:gd name="connsiteY5" fmla="*/ 1633958 h 1729380"/>
                <a:gd name="connsiteX6" fmla="*/ 1332270 w 1443595"/>
                <a:gd name="connsiteY6" fmla="*/ 1729380 h 1729380"/>
                <a:gd name="connsiteX7" fmla="*/ 105179 w 1443595"/>
                <a:gd name="connsiteY7" fmla="*/ 1729380 h 1729380"/>
                <a:gd name="connsiteX8" fmla="*/ 9757 w 1443595"/>
                <a:gd name="connsiteY8" fmla="*/ 1633958 h 1729380"/>
                <a:gd name="connsiteX9" fmla="*/ 33968 w 1443595"/>
                <a:gd name="connsiteY9" fmla="*/ 1270927 h 1729380"/>
                <a:gd name="connsiteX10" fmla="*/ 399370 w 1443595"/>
                <a:gd name="connsiteY10" fmla="*/ 1125059 h 1729380"/>
                <a:gd name="connsiteX0" fmla="*/ 389613 w 1433838"/>
                <a:gd name="connsiteY0" fmla="*/ 1125059 h 1729380"/>
                <a:gd name="connsiteX1" fmla="*/ 437328 w 1433838"/>
                <a:gd name="connsiteY1" fmla="*/ 115239 h 1729380"/>
                <a:gd name="connsiteX2" fmla="*/ 1002221 w 1433838"/>
                <a:gd name="connsiteY2" fmla="*/ 117989 h 1729380"/>
                <a:gd name="connsiteX3" fmla="*/ 1020364 w 1433838"/>
                <a:gd name="connsiteY3" fmla="*/ 1109151 h 1729380"/>
                <a:gd name="connsiteX4" fmla="*/ 1433838 w 1433838"/>
                <a:gd name="connsiteY4" fmla="*/ 1323842 h 1729380"/>
                <a:gd name="connsiteX5" fmla="*/ 1417935 w 1433838"/>
                <a:gd name="connsiteY5" fmla="*/ 1633958 h 1729380"/>
                <a:gd name="connsiteX6" fmla="*/ 1322513 w 1433838"/>
                <a:gd name="connsiteY6" fmla="*/ 1729380 h 1729380"/>
                <a:gd name="connsiteX7" fmla="*/ 95422 w 1433838"/>
                <a:gd name="connsiteY7" fmla="*/ 1729380 h 1729380"/>
                <a:gd name="connsiteX8" fmla="*/ 0 w 1433838"/>
                <a:gd name="connsiteY8" fmla="*/ 1633958 h 1729380"/>
                <a:gd name="connsiteX9" fmla="*/ 40114 w 1433838"/>
                <a:gd name="connsiteY9" fmla="*/ 1270927 h 1729380"/>
                <a:gd name="connsiteX10" fmla="*/ 389613 w 1433838"/>
                <a:gd name="connsiteY10" fmla="*/ 1125059 h 1729380"/>
                <a:gd name="connsiteX0" fmla="*/ 413467 w 1433838"/>
                <a:gd name="connsiteY0" fmla="*/ 1101205 h 1729380"/>
                <a:gd name="connsiteX1" fmla="*/ 437328 w 1433838"/>
                <a:gd name="connsiteY1" fmla="*/ 115239 h 1729380"/>
                <a:gd name="connsiteX2" fmla="*/ 1002221 w 1433838"/>
                <a:gd name="connsiteY2" fmla="*/ 117989 h 1729380"/>
                <a:gd name="connsiteX3" fmla="*/ 1020364 w 1433838"/>
                <a:gd name="connsiteY3" fmla="*/ 1109151 h 1729380"/>
                <a:gd name="connsiteX4" fmla="*/ 1433838 w 1433838"/>
                <a:gd name="connsiteY4" fmla="*/ 1323842 h 1729380"/>
                <a:gd name="connsiteX5" fmla="*/ 1417935 w 1433838"/>
                <a:gd name="connsiteY5" fmla="*/ 1633958 h 1729380"/>
                <a:gd name="connsiteX6" fmla="*/ 1322513 w 1433838"/>
                <a:gd name="connsiteY6" fmla="*/ 1729380 h 1729380"/>
                <a:gd name="connsiteX7" fmla="*/ 95422 w 1433838"/>
                <a:gd name="connsiteY7" fmla="*/ 1729380 h 1729380"/>
                <a:gd name="connsiteX8" fmla="*/ 0 w 1433838"/>
                <a:gd name="connsiteY8" fmla="*/ 1633958 h 1729380"/>
                <a:gd name="connsiteX9" fmla="*/ 40114 w 1433838"/>
                <a:gd name="connsiteY9" fmla="*/ 1270927 h 1729380"/>
                <a:gd name="connsiteX10" fmla="*/ 413467 w 1433838"/>
                <a:gd name="connsiteY10" fmla="*/ 1101205 h 1729380"/>
                <a:gd name="connsiteX0" fmla="*/ 413467 w 1433838"/>
                <a:gd name="connsiteY0" fmla="*/ 1101205 h 1729380"/>
                <a:gd name="connsiteX1" fmla="*/ 437328 w 1433838"/>
                <a:gd name="connsiteY1" fmla="*/ 115239 h 1729380"/>
                <a:gd name="connsiteX2" fmla="*/ 1002221 w 1433838"/>
                <a:gd name="connsiteY2" fmla="*/ 117989 h 1729380"/>
                <a:gd name="connsiteX3" fmla="*/ 1020364 w 1433838"/>
                <a:gd name="connsiteY3" fmla="*/ 1109151 h 1729380"/>
                <a:gd name="connsiteX4" fmla="*/ 1433838 w 1433838"/>
                <a:gd name="connsiteY4" fmla="*/ 1323842 h 1729380"/>
                <a:gd name="connsiteX5" fmla="*/ 1417935 w 1433838"/>
                <a:gd name="connsiteY5" fmla="*/ 1633958 h 1729380"/>
                <a:gd name="connsiteX6" fmla="*/ 1322513 w 1433838"/>
                <a:gd name="connsiteY6" fmla="*/ 1729380 h 1729380"/>
                <a:gd name="connsiteX7" fmla="*/ 95422 w 1433838"/>
                <a:gd name="connsiteY7" fmla="*/ 1729380 h 1729380"/>
                <a:gd name="connsiteX8" fmla="*/ 0 w 1433838"/>
                <a:gd name="connsiteY8" fmla="*/ 1633958 h 1729380"/>
                <a:gd name="connsiteX9" fmla="*/ 40114 w 1433838"/>
                <a:gd name="connsiteY9" fmla="*/ 1270927 h 1729380"/>
                <a:gd name="connsiteX10" fmla="*/ 413467 w 1433838"/>
                <a:gd name="connsiteY10" fmla="*/ 1101205 h 1729380"/>
                <a:gd name="connsiteX0" fmla="*/ 413467 w 1433838"/>
                <a:gd name="connsiteY0" fmla="*/ 1101205 h 1729380"/>
                <a:gd name="connsiteX1" fmla="*/ 437328 w 1433838"/>
                <a:gd name="connsiteY1" fmla="*/ 115239 h 1729380"/>
                <a:gd name="connsiteX2" fmla="*/ 1002221 w 1433838"/>
                <a:gd name="connsiteY2" fmla="*/ 117989 h 1729380"/>
                <a:gd name="connsiteX3" fmla="*/ 1020364 w 1433838"/>
                <a:gd name="connsiteY3" fmla="*/ 1109151 h 1729380"/>
                <a:gd name="connsiteX4" fmla="*/ 1433838 w 1433838"/>
                <a:gd name="connsiteY4" fmla="*/ 1323842 h 1729380"/>
                <a:gd name="connsiteX5" fmla="*/ 1417935 w 1433838"/>
                <a:gd name="connsiteY5" fmla="*/ 1633958 h 1729380"/>
                <a:gd name="connsiteX6" fmla="*/ 1322513 w 1433838"/>
                <a:gd name="connsiteY6" fmla="*/ 1729380 h 1729380"/>
                <a:gd name="connsiteX7" fmla="*/ 95422 w 1433838"/>
                <a:gd name="connsiteY7" fmla="*/ 1729380 h 1729380"/>
                <a:gd name="connsiteX8" fmla="*/ 0 w 1433838"/>
                <a:gd name="connsiteY8" fmla="*/ 1633958 h 1729380"/>
                <a:gd name="connsiteX9" fmla="*/ 40114 w 1433838"/>
                <a:gd name="connsiteY9" fmla="*/ 1270927 h 1729380"/>
                <a:gd name="connsiteX10" fmla="*/ 413467 w 1433838"/>
                <a:gd name="connsiteY10" fmla="*/ 1101205 h 1729380"/>
                <a:gd name="connsiteX0" fmla="*/ 413467 w 1433838"/>
                <a:gd name="connsiteY0" fmla="*/ 1101205 h 1729380"/>
                <a:gd name="connsiteX1" fmla="*/ 437328 w 1433838"/>
                <a:gd name="connsiteY1" fmla="*/ 115239 h 1729380"/>
                <a:gd name="connsiteX2" fmla="*/ 1002221 w 1433838"/>
                <a:gd name="connsiteY2" fmla="*/ 117989 h 1729380"/>
                <a:gd name="connsiteX3" fmla="*/ 1020364 w 1433838"/>
                <a:gd name="connsiteY3" fmla="*/ 1109151 h 1729380"/>
                <a:gd name="connsiteX4" fmla="*/ 1433838 w 1433838"/>
                <a:gd name="connsiteY4" fmla="*/ 1323842 h 1729380"/>
                <a:gd name="connsiteX5" fmla="*/ 1417935 w 1433838"/>
                <a:gd name="connsiteY5" fmla="*/ 1633958 h 1729380"/>
                <a:gd name="connsiteX6" fmla="*/ 1322513 w 1433838"/>
                <a:gd name="connsiteY6" fmla="*/ 1729380 h 1729380"/>
                <a:gd name="connsiteX7" fmla="*/ 95422 w 1433838"/>
                <a:gd name="connsiteY7" fmla="*/ 1729380 h 1729380"/>
                <a:gd name="connsiteX8" fmla="*/ 0 w 1433838"/>
                <a:gd name="connsiteY8" fmla="*/ 1633958 h 1729380"/>
                <a:gd name="connsiteX9" fmla="*/ 40114 w 1433838"/>
                <a:gd name="connsiteY9" fmla="*/ 1270927 h 1729380"/>
                <a:gd name="connsiteX10" fmla="*/ 413467 w 1433838"/>
                <a:gd name="connsiteY10" fmla="*/ 1101205 h 1729380"/>
                <a:gd name="connsiteX0" fmla="*/ 413467 w 1433838"/>
                <a:gd name="connsiteY0" fmla="*/ 1101205 h 1729380"/>
                <a:gd name="connsiteX1" fmla="*/ 437328 w 1433838"/>
                <a:gd name="connsiteY1" fmla="*/ 115239 h 1729380"/>
                <a:gd name="connsiteX2" fmla="*/ 1002221 w 1433838"/>
                <a:gd name="connsiteY2" fmla="*/ 117989 h 1729380"/>
                <a:gd name="connsiteX3" fmla="*/ 1020364 w 1433838"/>
                <a:gd name="connsiteY3" fmla="*/ 1109151 h 1729380"/>
                <a:gd name="connsiteX4" fmla="*/ 1433838 w 1433838"/>
                <a:gd name="connsiteY4" fmla="*/ 1323842 h 1729380"/>
                <a:gd name="connsiteX5" fmla="*/ 1417935 w 1433838"/>
                <a:gd name="connsiteY5" fmla="*/ 1633958 h 1729380"/>
                <a:gd name="connsiteX6" fmla="*/ 1322513 w 1433838"/>
                <a:gd name="connsiteY6" fmla="*/ 1729380 h 1729380"/>
                <a:gd name="connsiteX7" fmla="*/ 95422 w 1433838"/>
                <a:gd name="connsiteY7" fmla="*/ 1729380 h 1729380"/>
                <a:gd name="connsiteX8" fmla="*/ 0 w 1433838"/>
                <a:gd name="connsiteY8" fmla="*/ 1633958 h 1729380"/>
                <a:gd name="connsiteX9" fmla="*/ 40114 w 1433838"/>
                <a:gd name="connsiteY9" fmla="*/ 1270927 h 1729380"/>
                <a:gd name="connsiteX10" fmla="*/ 413467 w 1433838"/>
                <a:gd name="connsiteY10" fmla="*/ 1101205 h 1729380"/>
                <a:gd name="connsiteX0" fmla="*/ 386797 w 1433838"/>
                <a:gd name="connsiteY0" fmla="*/ 1105015 h 1729380"/>
                <a:gd name="connsiteX1" fmla="*/ 437328 w 1433838"/>
                <a:gd name="connsiteY1" fmla="*/ 115239 h 1729380"/>
                <a:gd name="connsiteX2" fmla="*/ 1002221 w 1433838"/>
                <a:gd name="connsiteY2" fmla="*/ 117989 h 1729380"/>
                <a:gd name="connsiteX3" fmla="*/ 1020364 w 1433838"/>
                <a:gd name="connsiteY3" fmla="*/ 1109151 h 1729380"/>
                <a:gd name="connsiteX4" fmla="*/ 1433838 w 1433838"/>
                <a:gd name="connsiteY4" fmla="*/ 1323842 h 1729380"/>
                <a:gd name="connsiteX5" fmla="*/ 1417935 w 1433838"/>
                <a:gd name="connsiteY5" fmla="*/ 1633958 h 1729380"/>
                <a:gd name="connsiteX6" fmla="*/ 1322513 w 1433838"/>
                <a:gd name="connsiteY6" fmla="*/ 1729380 h 1729380"/>
                <a:gd name="connsiteX7" fmla="*/ 95422 w 1433838"/>
                <a:gd name="connsiteY7" fmla="*/ 1729380 h 1729380"/>
                <a:gd name="connsiteX8" fmla="*/ 0 w 1433838"/>
                <a:gd name="connsiteY8" fmla="*/ 1633958 h 1729380"/>
                <a:gd name="connsiteX9" fmla="*/ 40114 w 1433838"/>
                <a:gd name="connsiteY9" fmla="*/ 1270927 h 1729380"/>
                <a:gd name="connsiteX10" fmla="*/ 386797 w 1433838"/>
                <a:gd name="connsiteY10" fmla="*/ 1105015 h 1729380"/>
                <a:gd name="connsiteX0" fmla="*/ 386797 w 1433838"/>
                <a:gd name="connsiteY0" fmla="*/ 1105015 h 1729380"/>
                <a:gd name="connsiteX1" fmla="*/ 437328 w 1433838"/>
                <a:gd name="connsiteY1" fmla="*/ 115239 h 1729380"/>
                <a:gd name="connsiteX2" fmla="*/ 1002221 w 1433838"/>
                <a:gd name="connsiteY2" fmla="*/ 117989 h 1729380"/>
                <a:gd name="connsiteX3" fmla="*/ 1020364 w 1433838"/>
                <a:gd name="connsiteY3" fmla="*/ 1109151 h 1729380"/>
                <a:gd name="connsiteX4" fmla="*/ 1433838 w 1433838"/>
                <a:gd name="connsiteY4" fmla="*/ 1323842 h 1729380"/>
                <a:gd name="connsiteX5" fmla="*/ 1417935 w 1433838"/>
                <a:gd name="connsiteY5" fmla="*/ 1633958 h 1729380"/>
                <a:gd name="connsiteX6" fmla="*/ 1322513 w 1433838"/>
                <a:gd name="connsiteY6" fmla="*/ 1729380 h 1729380"/>
                <a:gd name="connsiteX7" fmla="*/ 95422 w 1433838"/>
                <a:gd name="connsiteY7" fmla="*/ 1729380 h 1729380"/>
                <a:gd name="connsiteX8" fmla="*/ 0 w 1433838"/>
                <a:gd name="connsiteY8" fmla="*/ 1633958 h 1729380"/>
                <a:gd name="connsiteX9" fmla="*/ 40114 w 1433838"/>
                <a:gd name="connsiteY9" fmla="*/ 1270927 h 1729380"/>
                <a:gd name="connsiteX10" fmla="*/ 386797 w 1433838"/>
                <a:gd name="connsiteY10" fmla="*/ 1105015 h 172938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</a:cxnLst>
              <a:rect l="l" t="t" r="r" b="b"/>
              <a:pathLst>
                <a:path w="1433838" h="1729380">
                  <a:moveTo>
                    <a:pt x="386797" y="1105015"/>
                  </a:moveTo>
                  <a:cubicBezTo>
                    <a:pt x="386797" y="1052315"/>
                    <a:pt x="384628" y="115239"/>
                    <a:pt x="437328" y="115239"/>
                  </a:cubicBezTo>
                  <a:cubicBezTo>
                    <a:pt x="518226" y="-36704"/>
                    <a:pt x="944805" y="-41037"/>
                    <a:pt x="1002221" y="117989"/>
                  </a:cubicBezTo>
                  <a:cubicBezTo>
                    <a:pt x="1059637" y="277015"/>
                    <a:pt x="1025291" y="947932"/>
                    <a:pt x="1020364" y="1109151"/>
                  </a:cubicBezTo>
                  <a:cubicBezTo>
                    <a:pt x="1191174" y="1173921"/>
                    <a:pt x="1372878" y="1240662"/>
                    <a:pt x="1433838" y="1323842"/>
                  </a:cubicBezTo>
                  <a:lnTo>
                    <a:pt x="1417935" y="1633958"/>
                  </a:lnTo>
                  <a:cubicBezTo>
                    <a:pt x="1417935" y="1686658"/>
                    <a:pt x="1375213" y="1729380"/>
                    <a:pt x="1322513" y="1729380"/>
                  </a:cubicBezTo>
                  <a:lnTo>
                    <a:pt x="95422" y="1729380"/>
                  </a:lnTo>
                  <a:cubicBezTo>
                    <a:pt x="42722" y="1729380"/>
                    <a:pt x="0" y="1686658"/>
                    <a:pt x="0" y="1633958"/>
                  </a:cubicBezTo>
                  <a:cubicBezTo>
                    <a:pt x="17286" y="1569476"/>
                    <a:pt x="-30122" y="1339841"/>
                    <a:pt x="40114" y="1270927"/>
                  </a:cubicBezTo>
                  <a:cubicBezTo>
                    <a:pt x="110350" y="1202013"/>
                    <a:pt x="226172" y="1183496"/>
                    <a:pt x="386797" y="1105015"/>
                  </a:cubicBezTo>
                  <a:close/>
                </a:path>
              </a:pathLst>
            </a:custGeom>
            <a:solidFill>
              <a:schemeClr val="accent3">
                <a:lumMod val="40000"/>
                <a:lumOff val="60000"/>
              </a:schemeClr>
            </a:solidFill>
            <a:ln>
              <a:noFill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7" name="Arc 26"/>
          <p:cNvSpPr/>
          <p:nvPr/>
        </p:nvSpPr>
        <p:spPr>
          <a:xfrm rot="8040696">
            <a:off x="6504108" y="530373"/>
            <a:ext cx="4238940" cy="4291751"/>
          </a:xfrm>
          <a:prstGeom prst="arc">
            <a:avLst>
              <a:gd name="adj1" fmla="val 15989377"/>
              <a:gd name="adj2" fmla="val 351598"/>
            </a:avLst>
          </a:prstGeom>
          <a:ln w="28575">
            <a:solidFill>
              <a:srgbClr val="00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/>
          <p:cNvSpPr/>
          <p:nvPr/>
        </p:nvSpPr>
        <p:spPr>
          <a:xfrm>
            <a:off x="225444" y="5011166"/>
            <a:ext cx="11741112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sz="2000" i="1" dirty="0">
                <a:latin typeface="Arial" panose="020B0604020202020204" pitchFamily="34" charset="0"/>
                <a:cs typeface="Arial" panose="020B0604020202020204" pitchFamily="34" charset="0"/>
              </a:rPr>
              <a:t>1. Distance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: Distance of the needle tip to the ultrasound plane, in mm. </a:t>
            </a:r>
          </a:p>
          <a:p>
            <a:pPr>
              <a:defRPr/>
            </a:pPr>
            <a:r>
              <a:rPr lang="en-US" sz="2000" i="1" dirty="0">
                <a:latin typeface="Arial" panose="020B0604020202020204" pitchFamily="34" charset="0"/>
                <a:cs typeface="Arial" panose="020B0604020202020204" pitchFamily="34" charset="0"/>
              </a:rPr>
              <a:t>2. Angle of Elevation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: The up/down angle of the needle relative to the ultrasound plane, in degrees. </a:t>
            </a:r>
          </a:p>
          <a:p>
            <a:pPr>
              <a:defRPr/>
            </a:pPr>
            <a:r>
              <a:rPr lang="en-US" sz="2000" i="1" dirty="0">
                <a:latin typeface="Arial" panose="020B0604020202020204" pitchFamily="34" charset="0"/>
                <a:cs typeface="Arial" panose="020B0604020202020204" pitchFamily="34" charset="0"/>
              </a:rPr>
              <a:t>3. Azimuth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: The left/right angle of the needle relative to the ultrasound plane, in degrees. </a:t>
            </a:r>
          </a:p>
        </p:txBody>
      </p:sp>
      <p:sp>
        <p:nvSpPr>
          <p:cNvPr id="3" name="Rounded Rectangle 2"/>
          <p:cNvSpPr/>
          <p:nvPr/>
        </p:nvSpPr>
        <p:spPr>
          <a:xfrm>
            <a:off x="1908240" y="2418338"/>
            <a:ext cx="4266496" cy="2439233"/>
          </a:xfrm>
          <a:prstGeom prst="roundRect">
            <a:avLst/>
          </a:prstGeom>
          <a:solidFill>
            <a:srgbClr val="FFCCC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846557" y="163499"/>
            <a:ext cx="261578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Long Axis View</a:t>
            </a:r>
          </a:p>
        </p:txBody>
      </p:sp>
      <p:sp>
        <p:nvSpPr>
          <p:cNvPr id="6" name="Rectangle 5"/>
          <p:cNvSpPr/>
          <p:nvPr/>
        </p:nvSpPr>
        <p:spPr>
          <a:xfrm>
            <a:off x="1913237" y="3395837"/>
            <a:ext cx="4252161" cy="535440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ln>
            <a:solidFill>
              <a:schemeClr val="accent5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3872187" y="2486880"/>
            <a:ext cx="166887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Angle of Elevation</a:t>
            </a: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EF976D2B-A97F-4D4F-83EE-C947BC153EBB}"/>
              </a:ext>
            </a:extLst>
          </p:cNvPr>
          <p:cNvCxnSpPr>
            <a:cxnSpLocks/>
          </p:cNvCxnSpPr>
          <p:nvPr/>
        </p:nvCxnSpPr>
        <p:spPr>
          <a:xfrm flipH="1">
            <a:off x="4159834" y="3637954"/>
            <a:ext cx="419351" cy="0"/>
          </a:xfrm>
          <a:prstGeom prst="line">
            <a:avLst/>
          </a:prstGeom>
          <a:ln w="2222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6" name="Rectangle 45"/>
          <p:cNvSpPr/>
          <p:nvPr/>
        </p:nvSpPr>
        <p:spPr>
          <a:xfrm rot="1873011">
            <a:off x="2025781" y="2856297"/>
            <a:ext cx="2771322" cy="45719"/>
          </a:xfrm>
          <a:custGeom>
            <a:avLst/>
            <a:gdLst>
              <a:gd name="connsiteX0" fmla="*/ 0 w 2751530"/>
              <a:gd name="connsiteY0" fmla="*/ 0 h 45719"/>
              <a:gd name="connsiteX1" fmla="*/ 2751530 w 2751530"/>
              <a:gd name="connsiteY1" fmla="*/ 0 h 45719"/>
              <a:gd name="connsiteX2" fmla="*/ 2751530 w 2751530"/>
              <a:gd name="connsiteY2" fmla="*/ 45719 h 45719"/>
              <a:gd name="connsiteX3" fmla="*/ 0 w 2751530"/>
              <a:gd name="connsiteY3" fmla="*/ 45719 h 45719"/>
              <a:gd name="connsiteX4" fmla="*/ 0 w 2751530"/>
              <a:gd name="connsiteY4" fmla="*/ 0 h 45719"/>
              <a:gd name="connsiteX0" fmla="*/ 0 w 2751530"/>
              <a:gd name="connsiteY0" fmla="*/ 0 h 45719"/>
              <a:gd name="connsiteX1" fmla="*/ 2639985 w 2751530"/>
              <a:gd name="connsiteY1" fmla="*/ 312 h 45719"/>
              <a:gd name="connsiteX2" fmla="*/ 2751530 w 2751530"/>
              <a:gd name="connsiteY2" fmla="*/ 0 h 45719"/>
              <a:gd name="connsiteX3" fmla="*/ 2751530 w 2751530"/>
              <a:gd name="connsiteY3" fmla="*/ 45719 h 45719"/>
              <a:gd name="connsiteX4" fmla="*/ 0 w 2751530"/>
              <a:gd name="connsiteY4" fmla="*/ 45719 h 45719"/>
              <a:gd name="connsiteX5" fmla="*/ 0 w 2751530"/>
              <a:gd name="connsiteY5" fmla="*/ 0 h 45719"/>
              <a:gd name="connsiteX0" fmla="*/ 0 w 2751530"/>
              <a:gd name="connsiteY0" fmla="*/ 0 h 45719"/>
              <a:gd name="connsiteX1" fmla="*/ 2639985 w 2751530"/>
              <a:gd name="connsiteY1" fmla="*/ 312 h 45719"/>
              <a:gd name="connsiteX2" fmla="*/ 2717773 w 2751530"/>
              <a:gd name="connsiteY2" fmla="*/ 31594 h 45719"/>
              <a:gd name="connsiteX3" fmla="*/ 2751530 w 2751530"/>
              <a:gd name="connsiteY3" fmla="*/ 45719 h 45719"/>
              <a:gd name="connsiteX4" fmla="*/ 0 w 2751530"/>
              <a:gd name="connsiteY4" fmla="*/ 45719 h 45719"/>
              <a:gd name="connsiteX5" fmla="*/ 0 w 2751530"/>
              <a:gd name="connsiteY5" fmla="*/ 0 h 45719"/>
              <a:gd name="connsiteX0" fmla="*/ 0 w 2751530"/>
              <a:gd name="connsiteY0" fmla="*/ 0 h 45719"/>
              <a:gd name="connsiteX1" fmla="*/ 2639985 w 2751530"/>
              <a:gd name="connsiteY1" fmla="*/ 312 h 45719"/>
              <a:gd name="connsiteX2" fmla="*/ 2716107 w 2751530"/>
              <a:gd name="connsiteY2" fmla="*/ 24250 h 45719"/>
              <a:gd name="connsiteX3" fmla="*/ 2751530 w 2751530"/>
              <a:gd name="connsiteY3" fmla="*/ 45719 h 45719"/>
              <a:gd name="connsiteX4" fmla="*/ 0 w 2751530"/>
              <a:gd name="connsiteY4" fmla="*/ 45719 h 45719"/>
              <a:gd name="connsiteX5" fmla="*/ 0 w 2751530"/>
              <a:gd name="connsiteY5" fmla="*/ 0 h 45719"/>
              <a:gd name="connsiteX0" fmla="*/ 0 w 2751530"/>
              <a:gd name="connsiteY0" fmla="*/ 0 h 45719"/>
              <a:gd name="connsiteX1" fmla="*/ 2639985 w 2751530"/>
              <a:gd name="connsiteY1" fmla="*/ 312 h 45719"/>
              <a:gd name="connsiteX2" fmla="*/ 2701095 w 2751530"/>
              <a:gd name="connsiteY2" fmla="*/ 22275 h 45719"/>
              <a:gd name="connsiteX3" fmla="*/ 2751530 w 2751530"/>
              <a:gd name="connsiteY3" fmla="*/ 45719 h 45719"/>
              <a:gd name="connsiteX4" fmla="*/ 0 w 2751530"/>
              <a:gd name="connsiteY4" fmla="*/ 45719 h 45719"/>
              <a:gd name="connsiteX5" fmla="*/ 0 w 2751530"/>
              <a:gd name="connsiteY5" fmla="*/ 0 h 4571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751530" h="45719">
                <a:moveTo>
                  <a:pt x="0" y="0"/>
                </a:moveTo>
                <a:lnTo>
                  <a:pt x="2639985" y="312"/>
                </a:lnTo>
                <a:lnTo>
                  <a:pt x="2701095" y="22275"/>
                </a:lnTo>
                <a:lnTo>
                  <a:pt x="2751530" y="45719"/>
                </a:lnTo>
                <a:lnTo>
                  <a:pt x="0" y="45719"/>
                </a:lnTo>
                <a:lnTo>
                  <a:pt x="0" y="0"/>
                </a:lnTo>
                <a:close/>
              </a:path>
            </a:pathLst>
          </a:cu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Arc 54">
            <a:extLst>
              <a:ext uri="{FF2B5EF4-FFF2-40B4-BE49-F238E27FC236}">
                <a16:creationId xmlns:a16="http://schemas.microsoft.com/office/drawing/2014/main" id="{758711BA-9B84-4406-A214-383FD27C7052}"/>
              </a:ext>
            </a:extLst>
          </p:cNvPr>
          <p:cNvSpPr/>
          <p:nvPr/>
        </p:nvSpPr>
        <p:spPr>
          <a:xfrm rot="18568182">
            <a:off x="3542696" y="2614882"/>
            <a:ext cx="608907" cy="581574"/>
          </a:xfrm>
          <a:prstGeom prst="arc">
            <a:avLst>
              <a:gd name="adj1" fmla="val 14121011"/>
              <a:gd name="adj2" fmla="val 704475"/>
            </a:avLst>
          </a:prstGeom>
          <a:ln w="22225">
            <a:solidFill>
              <a:schemeClr val="tx1"/>
            </a:solidFill>
            <a:prstDash val="solid"/>
            <a:round/>
            <a:headEnd type="arrow"/>
            <a:tailEnd type="arrow"/>
            <a:extLst>
              <a:ext uri="{C807C97D-BFC1-408E-A445-0C87EB9F89A2}">
                <ask:lineSketchStyleProps xmlns="" xmlns:ask="http://schemas.microsoft.com/office/drawing/2018/sketchyshapes" sd="1219033472">
                  <a:custGeom>
                    <a:avLst/>
                    <a:gdLst>
                      <a:gd name="connsiteX0" fmla="*/ 373537 w 1310640"/>
                      <a:gd name="connsiteY0" fmla="*/ 65740 h 1353130"/>
                      <a:gd name="connsiteX1" fmla="*/ 1000338 w 1310640"/>
                      <a:gd name="connsiteY1" fmla="*/ 101361 h 1353130"/>
                      <a:gd name="connsiteX2" fmla="*/ 1309606 w 1310640"/>
                      <a:gd name="connsiteY2" fmla="*/ 638575 h 1353130"/>
                      <a:gd name="connsiteX3" fmla="*/ 655320 w 1310640"/>
                      <a:gd name="connsiteY3" fmla="*/ 676565 h 1353130"/>
                      <a:gd name="connsiteX4" fmla="*/ 373537 w 1310640"/>
                      <a:gd name="connsiteY4" fmla="*/ 65740 h 1353130"/>
                      <a:gd name="connsiteX0" fmla="*/ 373537 w 1310640"/>
                      <a:gd name="connsiteY0" fmla="*/ 65740 h 1353130"/>
                      <a:gd name="connsiteX1" fmla="*/ 1000338 w 1310640"/>
                      <a:gd name="connsiteY1" fmla="*/ 101361 h 1353130"/>
                      <a:gd name="connsiteX2" fmla="*/ 1309606 w 1310640"/>
                      <a:gd name="connsiteY2" fmla="*/ 638575 h 135313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1310640" h="1353130" stroke="0" extrusionOk="0">
                        <a:moveTo>
                          <a:pt x="373537" y="65740"/>
                        </a:moveTo>
                        <a:cubicBezTo>
                          <a:pt x="541767" y="-53538"/>
                          <a:pt x="771609" y="-5045"/>
                          <a:pt x="1000338" y="101361"/>
                        </a:cubicBezTo>
                        <a:cubicBezTo>
                          <a:pt x="1222782" y="226158"/>
                          <a:pt x="1280474" y="418675"/>
                          <a:pt x="1309606" y="638575"/>
                        </a:cubicBezTo>
                        <a:cubicBezTo>
                          <a:pt x="998922" y="658840"/>
                          <a:pt x="946923" y="696086"/>
                          <a:pt x="655320" y="676565"/>
                        </a:cubicBezTo>
                        <a:cubicBezTo>
                          <a:pt x="535596" y="479352"/>
                          <a:pt x="443651" y="277091"/>
                          <a:pt x="373537" y="65740"/>
                        </a:cubicBezTo>
                        <a:close/>
                      </a:path>
                      <a:path w="1310640" h="1353130" fill="none" extrusionOk="0">
                        <a:moveTo>
                          <a:pt x="373537" y="65740"/>
                        </a:moveTo>
                        <a:cubicBezTo>
                          <a:pt x="595039" y="-30788"/>
                          <a:pt x="818495" y="-35483"/>
                          <a:pt x="1000338" y="101361"/>
                        </a:cubicBezTo>
                        <a:cubicBezTo>
                          <a:pt x="1138682" y="210947"/>
                          <a:pt x="1291059" y="424286"/>
                          <a:pt x="1309606" y="638575"/>
                        </a:cubicBezTo>
                      </a:path>
                    </a:pathLst>
                  </a:custGeom>
                  <ask:type>
                    <ask:lineSketchNone/>
                  </ask:type>
                </ask:lineSketchStyleProps>
              </a:ext>
            </a:extLst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3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7F8C0F15-056D-41BD-935C-1160CA294A78}"/>
              </a:ext>
            </a:extLst>
          </p:cNvPr>
          <p:cNvSpPr txBox="1"/>
          <p:nvPr/>
        </p:nvSpPr>
        <p:spPr>
          <a:xfrm>
            <a:off x="2130962" y="2475485"/>
            <a:ext cx="6957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nterior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93259153-3072-4B24-8EC7-48774CCA285E}"/>
              </a:ext>
            </a:extLst>
          </p:cNvPr>
          <p:cNvSpPr txBox="1"/>
          <p:nvPr/>
        </p:nvSpPr>
        <p:spPr>
          <a:xfrm>
            <a:off x="2155609" y="3012251"/>
            <a:ext cx="8720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osterio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93259153-3072-4B24-8EC7-48774CCA285E}"/>
              </a:ext>
            </a:extLst>
          </p:cNvPr>
          <p:cNvSpPr txBox="1"/>
          <p:nvPr/>
        </p:nvSpPr>
        <p:spPr>
          <a:xfrm>
            <a:off x="2461165" y="2634403"/>
            <a:ext cx="5441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ight 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93259153-3072-4B24-8EC7-48774CCA285E}"/>
              </a:ext>
            </a:extLst>
          </p:cNvPr>
          <p:cNvSpPr txBox="1"/>
          <p:nvPr/>
        </p:nvSpPr>
        <p:spPr>
          <a:xfrm>
            <a:off x="1915909" y="2866502"/>
            <a:ext cx="597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ef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cxnSp>
        <p:nvCxnSpPr>
          <p:cNvPr id="61" name="Straight Arrow Connector 60"/>
          <p:cNvCxnSpPr/>
          <p:nvPr/>
        </p:nvCxnSpPr>
        <p:spPr>
          <a:xfrm>
            <a:off x="2453123" y="2677210"/>
            <a:ext cx="0" cy="434188"/>
          </a:xfrm>
          <a:prstGeom prst="straightConnector1">
            <a:avLst/>
          </a:prstGeom>
          <a:ln w="28575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Arrow Connector 61"/>
          <p:cNvCxnSpPr/>
          <p:nvPr/>
        </p:nvCxnSpPr>
        <p:spPr>
          <a:xfrm flipH="1">
            <a:off x="2343421" y="2755365"/>
            <a:ext cx="230771" cy="258453"/>
          </a:xfrm>
          <a:prstGeom prst="straightConnector1">
            <a:avLst/>
          </a:prstGeom>
          <a:ln w="28575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96" name="Group 95"/>
          <p:cNvGrpSpPr/>
          <p:nvPr/>
        </p:nvGrpSpPr>
        <p:grpSpPr>
          <a:xfrm>
            <a:off x="680538" y="1010023"/>
            <a:ext cx="1893656" cy="1358280"/>
            <a:chOff x="5085569" y="1336210"/>
            <a:chExt cx="2798347" cy="1860996"/>
          </a:xfrm>
        </p:grpSpPr>
        <p:sp>
          <p:nvSpPr>
            <p:cNvPr id="97" name="Rounded Rectangle 96"/>
            <p:cNvSpPr/>
            <p:nvPr/>
          </p:nvSpPr>
          <p:spPr>
            <a:xfrm rot="2051732">
              <a:off x="5085569" y="1336210"/>
              <a:ext cx="133351" cy="357187"/>
            </a:xfrm>
            <a:prstGeom prst="roundRect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8" name="Rounded Rectangle 97"/>
            <p:cNvSpPr/>
            <p:nvPr/>
          </p:nvSpPr>
          <p:spPr>
            <a:xfrm rot="7371903">
              <a:off x="5385856" y="1414200"/>
              <a:ext cx="107932" cy="548064"/>
            </a:xfrm>
            <a:prstGeom prst="roundRect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9" name="Rounded Rectangle 98"/>
            <p:cNvSpPr/>
            <p:nvPr/>
          </p:nvSpPr>
          <p:spPr>
            <a:xfrm rot="2051732">
              <a:off x="5615328" y="1575043"/>
              <a:ext cx="145504" cy="521333"/>
            </a:xfrm>
            <a:prstGeom prst="roundRect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0" name="Rounded Rectangle 99"/>
            <p:cNvSpPr/>
            <p:nvPr/>
          </p:nvSpPr>
          <p:spPr>
            <a:xfrm rot="7415841">
              <a:off x="6518997" y="1301665"/>
              <a:ext cx="320079" cy="2309731"/>
            </a:xfrm>
            <a:prstGeom prst="roundRect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1" name="Trapezoid 100"/>
            <p:cNvSpPr/>
            <p:nvPr/>
          </p:nvSpPr>
          <p:spPr>
            <a:xfrm rot="7349314">
              <a:off x="7675101" y="2988391"/>
              <a:ext cx="148409" cy="269221"/>
            </a:xfrm>
            <a:prstGeom prst="trapezoid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2" name="Rectangle 101"/>
            <p:cNvSpPr/>
            <p:nvPr/>
          </p:nvSpPr>
          <p:spPr>
            <a:xfrm rot="18180000">
              <a:off x="5533751" y="1774948"/>
              <a:ext cx="344875" cy="989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cxnSp>
        <p:nvCxnSpPr>
          <p:cNvPr id="103" name="Straight Connector 102"/>
          <p:cNvCxnSpPr/>
          <p:nvPr/>
        </p:nvCxnSpPr>
        <p:spPr>
          <a:xfrm flipH="1">
            <a:off x="1262536" y="1423950"/>
            <a:ext cx="100906" cy="158675"/>
          </a:xfrm>
          <a:prstGeom prst="line">
            <a:avLst/>
          </a:prstGeom>
          <a:ln w="349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Connector 103"/>
          <p:cNvCxnSpPr/>
          <p:nvPr/>
        </p:nvCxnSpPr>
        <p:spPr>
          <a:xfrm flipH="1">
            <a:off x="1971859" y="1867002"/>
            <a:ext cx="56606" cy="89771"/>
          </a:xfrm>
          <a:prstGeom prst="line">
            <a:avLst/>
          </a:prstGeom>
          <a:ln w="349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Connector 104"/>
          <p:cNvCxnSpPr/>
          <p:nvPr/>
        </p:nvCxnSpPr>
        <p:spPr>
          <a:xfrm flipH="1">
            <a:off x="2079401" y="1943478"/>
            <a:ext cx="56606" cy="89771"/>
          </a:xfrm>
          <a:prstGeom prst="line">
            <a:avLst/>
          </a:prstGeom>
          <a:ln w="349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Connector 105"/>
          <p:cNvCxnSpPr/>
          <p:nvPr/>
        </p:nvCxnSpPr>
        <p:spPr>
          <a:xfrm flipH="1">
            <a:off x="2195859" y="2022851"/>
            <a:ext cx="56606" cy="89771"/>
          </a:xfrm>
          <a:prstGeom prst="line">
            <a:avLst/>
          </a:prstGeom>
          <a:ln w="349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Connector 106"/>
          <p:cNvCxnSpPr/>
          <p:nvPr/>
        </p:nvCxnSpPr>
        <p:spPr>
          <a:xfrm flipH="1">
            <a:off x="2313247" y="2096097"/>
            <a:ext cx="56606" cy="89771"/>
          </a:xfrm>
          <a:prstGeom prst="line">
            <a:avLst/>
          </a:prstGeom>
          <a:ln w="349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Straight Connector 107"/>
          <p:cNvCxnSpPr/>
          <p:nvPr/>
        </p:nvCxnSpPr>
        <p:spPr>
          <a:xfrm flipH="1">
            <a:off x="1420135" y="1503054"/>
            <a:ext cx="56606" cy="89771"/>
          </a:xfrm>
          <a:prstGeom prst="line">
            <a:avLst/>
          </a:prstGeom>
          <a:ln w="349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Connector 108"/>
          <p:cNvCxnSpPr/>
          <p:nvPr/>
        </p:nvCxnSpPr>
        <p:spPr>
          <a:xfrm flipH="1">
            <a:off x="1524388" y="1579530"/>
            <a:ext cx="56606" cy="89771"/>
          </a:xfrm>
          <a:prstGeom prst="line">
            <a:avLst/>
          </a:prstGeom>
          <a:ln w="349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Connector 109"/>
          <p:cNvCxnSpPr/>
          <p:nvPr/>
        </p:nvCxnSpPr>
        <p:spPr>
          <a:xfrm flipH="1">
            <a:off x="1640846" y="1658903"/>
            <a:ext cx="56606" cy="89771"/>
          </a:xfrm>
          <a:prstGeom prst="line">
            <a:avLst/>
          </a:prstGeom>
          <a:ln w="349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Connector 110"/>
          <p:cNvCxnSpPr/>
          <p:nvPr/>
        </p:nvCxnSpPr>
        <p:spPr>
          <a:xfrm flipH="1">
            <a:off x="1758234" y="1732149"/>
            <a:ext cx="56606" cy="89771"/>
          </a:xfrm>
          <a:prstGeom prst="line">
            <a:avLst/>
          </a:prstGeom>
          <a:ln w="349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Straight Connector 111"/>
          <p:cNvCxnSpPr/>
          <p:nvPr/>
        </p:nvCxnSpPr>
        <p:spPr>
          <a:xfrm flipH="1">
            <a:off x="1821085" y="1798772"/>
            <a:ext cx="100906" cy="158675"/>
          </a:xfrm>
          <a:prstGeom prst="line">
            <a:avLst/>
          </a:prstGeom>
          <a:ln w="349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EDA7B20A-E9AC-4458-B1C4-EA67D520CAF9}"/>
              </a:ext>
            </a:extLst>
          </p:cNvPr>
          <p:cNvCxnSpPr>
            <a:cxnSpLocks/>
            <a:stCxn id="2" idx="0"/>
          </p:cNvCxnSpPr>
          <p:nvPr/>
        </p:nvCxnSpPr>
        <p:spPr>
          <a:xfrm>
            <a:off x="8609230" y="2413900"/>
            <a:ext cx="1582971" cy="1639012"/>
          </a:xfrm>
          <a:prstGeom prst="line">
            <a:avLst/>
          </a:prstGeom>
          <a:ln w="25400">
            <a:solidFill>
              <a:srgbClr val="00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/>
          <p:cNvSpPr txBox="1"/>
          <p:nvPr/>
        </p:nvSpPr>
        <p:spPr>
          <a:xfrm>
            <a:off x="4520752" y="3504914"/>
            <a:ext cx="382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-)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3377622" y="3492716"/>
            <a:ext cx="40498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+)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EF976D2B-A97F-4D4F-83EE-C947BC153EBB}"/>
              </a:ext>
            </a:extLst>
          </p:cNvPr>
          <p:cNvCxnSpPr>
            <a:cxnSpLocks/>
          </p:cNvCxnSpPr>
          <p:nvPr/>
        </p:nvCxnSpPr>
        <p:spPr>
          <a:xfrm flipH="1">
            <a:off x="3735096" y="3639294"/>
            <a:ext cx="419351" cy="0"/>
          </a:xfrm>
          <a:prstGeom prst="line">
            <a:avLst/>
          </a:prstGeom>
          <a:ln w="2222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861926F1-B5B2-4138-A399-3215D705C6C5}"/>
              </a:ext>
            </a:extLst>
          </p:cNvPr>
          <p:cNvCxnSpPr>
            <a:cxnSpLocks/>
          </p:cNvCxnSpPr>
          <p:nvPr/>
        </p:nvCxnSpPr>
        <p:spPr>
          <a:xfrm>
            <a:off x="4134295" y="1368115"/>
            <a:ext cx="17898" cy="3438201"/>
          </a:xfrm>
          <a:prstGeom prst="line">
            <a:avLst/>
          </a:prstGeom>
          <a:ln w="25400">
            <a:solidFill>
              <a:srgbClr val="00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Rounded Rectangle 12"/>
          <p:cNvSpPr/>
          <p:nvPr/>
        </p:nvSpPr>
        <p:spPr>
          <a:xfrm>
            <a:off x="3772850" y="695645"/>
            <a:ext cx="772950" cy="1729380"/>
          </a:xfrm>
          <a:custGeom>
            <a:avLst/>
            <a:gdLst>
              <a:gd name="connsiteX0" fmla="*/ 0 w 1417935"/>
              <a:gd name="connsiteY0" fmla="*/ 95422 h 572520"/>
              <a:gd name="connsiteX1" fmla="*/ 95422 w 1417935"/>
              <a:gd name="connsiteY1" fmla="*/ 0 h 572520"/>
              <a:gd name="connsiteX2" fmla="*/ 1322513 w 1417935"/>
              <a:gd name="connsiteY2" fmla="*/ 0 h 572520"/>
              <a:gd name="connsiteX3" fmla="*/ 1417935 w 1417935"/>
              <a:gd name="connsiteY3" fmla="*/ 95422 h 572520"/>
              <a:gd name="connsiteX4" fmla="*/ 1417935 w 1417935"/>
              <a:gd name="connsiteY4" fmla="*/ 477098 h 572520"/>
              <a:gd name="connsiteX5" fmla="*/ 1322513 w 1417935"/>
              <a:gd name="connsiteY5" fmla="*/ 572520 h 572520"/>
              <a:gd name="connsiteX6" fmla="*/ 95422 w 1417935"/>
              <a:gd name="connsiteY6" fmla="*/ 572520 h 572520"/>
              <a:gd name="connsiteX7" fmla="*/ 0 w 1417935"/>
              <a:gd name="connsiteY7" fmla="*/ 477098 h 572520"/>
              <a:gd name="connsiteX8" fmla="*/ 0 w 1417935"/>
              <a:gd name="connsiteY8" fmla="*/ 95422 h 572520"/>
              <a:gd name="connsiteX0" fmla="*/ 0 w 1417935"/>
              <a:gd name="connsiteY0" fmla="*/ 978017 h 1455115"/>
              <a:gd name="connsiteX1" fmla="*/ 699721 w 1417935"/>
              <a:gd name="connsiteY1" fmla="*/ 0 h 1455115"/>
              <a:gd name="connsiteX2" fmla="*/ 1322513 w 1417935"/>
              <a:gd name="connsiteY2" fmla="*/ 882595 h 1455115"/>
              <a:gd name="connsiteX3" fmla="*/ 1417935 w 1417935"/>
              <a:gd name="connsiteY3" fmla="*/ 978017 h 1455115"/>
              <a:gd name="connsiteX4" fmla="*/ 1417935 w 1417935"/>
              <a:gd name="connsiteY4" fmla="*/ 1359693 h 1455115"/>
              <a:gd name="connsiteX5" fmla="*/ 1322513 w 1417935"/>
              <a:gd name="connsiteY5" fmla="*/ 1455115 h 1455115"/>
              <a:gd name="connsiteX6" fmla="*/ 95422 w 1417935"/>
              <a:gd name="connsiteY6" fmla="*/ 1455115 h 1455115"/>
              <a:gd name="connsiteX7" fmla="*/ 0 w 1417935"/>
              <a:gd name="connsiteY7" fmla="*/ 1359693 h 1455115"/>
              <a:gd name="connsiteX8" fmla="*/ 0 w 1417935"/>
              <a:gd name="connsiteY8" fmla="*/ 978017 h 1455115"/>
              <a:gd name="connsiteX0" fmla="*/ 357808 w 1417935"/>
              <a:gd name="connsiteY0" fmla="*/ 985968 h 1455115"/>
              <a:gd name="connsiteX1" fmla="*/ 699721 w 1417935"/>
              <a:gd name="connsiteY1" fmla="*/ 0 h 1455115"/>
              <a:gd name="connsiteX2" fmla="*/ 1322513 w 1417935"/>
              <a:gd name="connsiteY2" fmla="*/ 882595 h 1455115"/>
              <a:gd name="connsiteX3" fmla="*/ 1417935 w 1417935"/>
              <a:gd name="connsiteY3" fmla="*/ 978017 h 1455115"/>
              <a:gd name="connsiteX4" fmla="*/ 1417935 w 1417935"/>
              <a:gd name="connsiteY4" fmla="*/ 1359693 h 1455115"/>
              <a:gd name="connsiteX5" fmla="*/ 1322513 w 1417935"/>
              <a:gd name="connsiteY5" fmla="*/ 1455115 h 1455115"/>
              <a:gd name="connsiteX6" fmla="*/ 95422 w 1417935"/>
              <a:gd name="connsiteY6" fmla="*/ 1455115 h 1455115"/>
              <a:gd name="connsiteX7" fmla="*/ 0 w 1417935"/>
              <a:gd name="connsiteY7" fmla="*/ 1359693 h 1455115"/>
              <a:gd name="connsiteX8" fmla="*/ 357808 w 1417935"/>
              <a:gd name="connsiteY8" fmla="*/ 985968 h 1455115"/>
              <a:gd name="connsiteX0" fmla="*/ 357808 w 1417935"/>
              <a:gd name="connsiteY0" fmla="*/ 985968 h 1455115"/>
              <a:gd name="connsiteX1" fmla="*/ 699721 w 1417935"/>
              <a:gd name="connsiteY1" fmla="*/ 0 h 1455115"/>
              <a:gd name="connsiteX2" fmla="*/ 1322513 w 1417935"/>
              <a:gd name="connsiteY2" fmla="*/ 882595 h 1455115"/>
              <a:gd name="connsiteX3" fmla="*/ 1417935 w 1417935"/>
              <a:gd name="connsiteY3" fmla="*/ 978017 h 1455115"/>
              <a:gd name="connsiteX4" fmla="*/ 1417935 w 1417935"/>
              <a:gd name="connsiteY4" fmla="*/ 1359693 h 1455115"/>
              <a:gd name="connsiteX5" fmla="*/ 1322513 w 1417935"/>
              <a:gd name="connsiteY5" fmla="*/ 1455115 h 1455115"/>
              <a:gd name="connsiteX6" fmla="*/ 95422 w 1417935"/>
              <a:gd name="connsiteY6" fmla="*/ 1455115 h 1455115"/>
              <a:gd name="connsiteX7" fmla="*/ 0 w 1417935"/>
              <a:gd name="connsiteY7" fmla="*/ 1359693 h 1455115"/>
              <a:gd name="connsiteX8" fmla="*/ 357808 w 1417935"/>
              <a:gd name="connsiteY8" fmla="*/ 985968 h 1455115"/>
              <a:gd name="connsiteX0" fmla="*/ 357808 w 1417935"/>
              <a:gd name="connsiteY0" fmla="*/ 985968 h 1455115"/>
              <a:gd name="connsiteX1" fmla="*/ 699721 w 1417935"/>
              <a:gd name="connsiteY1" fmla="*/ 0 h 1455115"/>
              <a:gd name="connsiteX2" fmla="*/ 1044217 w 1417935"/>
              <a:gd name="connsiteY2" fmla="*/ 954157 h 1455115"/>
              <a:gd name="connsiteX3" fmla="*/ 1417935 w 1417935"/>
              <a:gd name="connsiteY3" fmla="*/ 978017 h 1455115"/>
              <a:gd name="connsiteX4" fmla="*/ 1417935 w 1417935"/>
              <a:gd name="connsiteY4" fmla="*/ 1359693 h 1455115"/>
              <a:gd name="connsiteX5" fmla="*/ 1322513 w 1417935"/>
              <a:gd name="connsiteY5" fmla="*/ 1455115 h 1455115"/>
              <a:gd name="connsiteX6" fmla="*/ 95422 w 1417935"/>
              <a:gd name="connsiteY6" fmla="*/ 1455115 h 1455115"/>
              <a:gd name="connsiteX7" fmla="*/ 0 w 1417935"/>
              <a:gd name="connsiteY7" fmla="*/ 1359693 h 1455115"/>
              <a:gd name="connsiteX8" fmla="*/ 357808 w 1417935"/>
              <a:gd name="connsiteY8" fmla="*/ 985968 h 1455115"/>
              <a:gd name="connsiteX0" fmla="*/ 357808 w 1417935"/>
              <a:gd name="connsiteY0" fmla="*/ 985968 h 1455115"/>
              <a:gd name="connsiteX1" fmla="*/ 699721 w 1417935"/>
              <a:gd name="connsiteY1" fmla="*/ 0 h 1455115"/>
              <a:gd name="connsiteX2" fmla="*/ 1044217 w 1417935"/>
              <a:gd name="connsiteY2" fmla="*/ 954157 h 1455115"/>
              <a:gd name="connsiteX3" fmla="*/ 1290714 w 1417935"/>
              <a:gd name="connsiteY3" fmla="*/ 1041627 h 1455115"/>
              <a:gd name="connsiteX4" fmla="*/ 1417935 w 1417935"/>
              <a:gd name="connsiteY4" fmla="*/ 1359693 h 1455115"/>
              <a:gd name="connsiteX5" fmla="*/ 1322513 w 1417935"/>
              <a:gd name="connsiteY5" fmla="*/ 1455115 h 1455115"/>
              <a:gd name="connsiteX6" fmla="*/ 95422 w 1417935"/>
              <a:gd name="connsiteY6" fmla="*/ 1455115 h 1455115"/>
              <a:gd name="connsiteX7" fmla="*/ 0 w 1417935"/>
              <a:gd name="connsiteY7" fmla="*/ 1359693 h 1455115"/>
              <a:gd name="connsiteX8" fmla="*/ 357808 w 1417935"/>
              <a:gd name="connsiteY8" fmla="*/ 985968 h 1455115"/>
              <a:gd name="connsiteX0" fmla="*/ 357808 w 1417935"/>
              <a:gd name="connsiteY0" fmla="*/ 1071289 h 1540436"/>
              <a:gd name="connsiteX1" fmla="*/ 699721 w 1417935"/>
              <a:gd name="connsiteY1" fmla="*/ 85321 h 1540436"/>
              <a:gd name="connsiteX2" fmla="*/ 1002221 w 1417935"/>
              <a:gd name="connsiteY2" fmla="*/ 159632 h 1540436"/>
              <a:gd name="connsiteX3" fmla="*/ 1044217 w 1417935"/>
              <a:gd name="connsiteY3" fmla="*/ 1039478 h 1540436"/>
              <a:gd name="connsiteX4" fmla="*/ 1290714 w 1417935"/>
              <a:gd name="connsiteY4" fmla="*/ 1126948 h 1540436"/>
              <a:gd name="connsiteX5" fmla="*/ 1417935 w 1417935"/>
              <a:gd name="connsiteY5" fmla="*/ 1445014 h 1540436"/>
              <a:gd name="connsiteX6" fmla="*/ 1322513 w 1417935"/>
              <a:gd name="connsiteY6" fmla="*/ 1540436 h 1540436"/>
              <a:gd name="connsiteX7" fmla="*/ 95422 w 1417935"/>
              <a:gd name="connsiteY7" fmla="*/ 1540436 h 1540436"/>
              <a:gd name="connsiteX8" fmla="*/ 0 w 1417935"/>
              <a:gd name="connsiteY8" fmla="*/ 1445014 h 1540436"/>
              <a:gd name="connsiteX9" fmla="*/ 357808 w 1417935"/>
              <a:gd name="connsiteY9" fmla="*/ 1071289 h 1540436"/>
              <a:gd name="connsiteX0" fmla="*/ 357808 w 1417935"/>
              <a:gd name="connsiteY0" fmla="*/ 1056120 h 1525267"/>
              <a:gd name="connsiteX1" fmla="*/ 548646 w 1417935"/>
              <a:gd name="connsiteY1" fmla="*/ 94006 h 1525267"/>
              <a:gd name="connsiteX2" fmla="*/ 1002221 w 1417935"/>
              <a:gd name="connsiteY2" fmla="*/ 144463 h 1525267"/>
              <a:gd name="connsiteX3" fmla="*/ 1044217 w 1417935"/>
              <a:gd name="connsiteY3" fmla="*/ 1024309 h 1525267"/>
              <a:gd name="connsiteX4" fmla="*/ 1290714 w 1417935"/>
              <a:gd name="connsiteY4" fmla="*/ 1111779 h 1525267"/>
              <a:gd name="connsiteX5" fmla="*/ 1417935 w 1417935"/>
              <a:gd name="connsiteY5" fmla="*/ 1429845 h 1525267"/>
              <a:gd name="connsiteX6" fmla="*/ 1322513 w 1417935"/>
              <a:gd name="connsiteY6" fmla="*/ 1525267 h 1525267"/>
              <a:gd name="connsiteX7" fmla="*/ 95422 w 1417935"/>
              <a:gd name="connsiteY7" fmla="*/ 1525267 h 1525267"/>
              <a:gd name="connsiteX8" fmla="*/ 0 w 1417935"/>
              <a:gd name="connsiteY8" fmla="*/ 1429845 h 1525267"/>
              <a:gd name="connsiteX9" fmla="*/ 357808 w 1417935"/>
              <a:gd name="connsiteY9" fmla="*/ 1056120 h 1525267"/>
              <a:gd name="connsiteX0" fmla="*/ 357808 w 1417935"/>
              <a:gd name="connsiteY0" fmla="*/ 1174872 h 1644019"/>
              <a:gd name="connsiteX1" fmla="*/ 461182 w 1417935"/>
              <a:gd name="connsiteY1" fmla="*/ 53732 h 1644019"/>
              <a:gd name="connsiteX2" fmla="*/ 1002221 w 1417935"/>
              <a:gd name="connsiteY2" fmla="*/ 263215 h 1644019"/>
              <a:gd name="connsiteX3" fmla="*/ 1044217 w 1417935"/>
              <a:gd name="connsiteY3" fmla="*/ 1143061 h 1644019"/>
              <a:gd name="connsiteX4" fmla="*/ 1290714 w 1417935"/>
              <a:gd name="connsiteY4" fmla="*/ 1230531 h 1644019"/>
              <a:gd name="connsiteX5" fmla="*/ 1417935 w 1417935"/>
              <a:gd name="connsiteY5" fmla="*/ 1548597 h 1644019"/>
              <a:gd name="connsiteX6" fmla="*/ 1322513 w 1417935"/>
              <a:gd name="connsiteY6" fmla="*/ 1644019 h 1644019"/>
              <a:gd name="connsiteX7" fmla="*/ 95422 w 1417935"/>
              <a:gd name="connsiteY7" fmla="*/ 1644019 h 1644019"/>
              <a:gd name="connsiteX8" fmla="*/ 0 w 1417935"/>
              <a:gd name="connsiteY8" fmla="*/ 1548597 h 1644019"/>
              <a:gd name="connsiteX9" fmla="*/ 357808 w 1417935"/>
              <a:gd name="connsiteY9" fmla="*/ 1174872 h 1644019"/>
              <a:gd name="connsiteX0" fmla="*/ 357808 w 1417935"/>
              <a:gd name="connsiteY0" fmla="*/ 1249033 h 1718180"/>
              <a:gd name="connsiteX1" fmla="*/ 461182 w 1417935"/>
              <a:gd name="connsiteY1" fmla="*/ 127893 h 1718180"/>
              <a:gd name="connsiteX2" fmla="*/ 1002221 w 1417935"/>
              <a:gd name="connsiteY2" fmla="*/ 106789 h 1718180"/>
              <a:gd name="connsiteX3" fmla="*/ 1044217 w 1417935"/>
              <a:gd name="connsiteY3" fmla="*/ 1217222 h 1718180"/>
              <a:gd name="connsiteX4" fmla="*/ 1290714 w 1417935"/>
              <a:gd name="connsiteY4" fmla="*/ 1304692 h 1718180"/>
              <a:gd name="connsiteX5" fmla="*/ 1417935 w 1417935"/>
              <a:gd name="connsiteY5" fmla="*/ 1622758 h 1718180"/>
              <a:gd name="connsiteX6" fmla="*/ 1322513 w 1417935"/>
              <a:gd name="connsiteY6" fmla="*/ 1718180 h 1718180"/>
              <a:gd name="connsiteX7" fmla="*/ 95422 w 1417935"/>
              <a:gd name="connsiteY7" fmla="*/ 1718180 h 1718180"/>
              <a:gd name="connsiteX8" fmla="*/ 0 w 1417935"/>
              <a:gd name="connsiteY8" fmla="*/ 1622758 h 1718180"/>
              <a:gd name="connsiteX9" fmla="*/ 357808 w 1417935"/>
              <a:gd name="connsiteY9" fmla="*/ 1249033 h 1718180"/>
              <a:gd name="connsiteX0" fmla="*/ 357808 w 1417935"/>
              <a:gd name="connsiteY0" fmla="*/ 1249033 h 1718180"/>
              <a:gd name="connsiteX1" fmla="*/ 461182 w 1417935"/>
              <a:gd name="connsiteY1" fmla="*/ 127893 h 1718180"/>
              <a:gd name="connsiteX2" fmla="*/ 1002221 w 1417935"/>
              <a:gd name="connsiteY2" fmla="*/ 106789 h 1718180"/>
              <a:gd name="connsiteX3" fmla="*/ 1004461 w 1417935"/>
              <a:gd name="connsiteY3" fmla="*/ 1280832 h 1718180"/>
              <a:gd name="connsiteX4" fmla="*/ 1290714 w 1417935"/>
              <a:gd name="connsiteY4" fmla="*/ 1304692 h 1718180"/>
              <a:gd name="connsiteX5" fmla="*/ 1417935 w 1417935"/>
              <a:gd name="connsiteY5" fmla="*/ 1622758 h 1718180"/>
              <a:gd name="connsiteX6" fmla="*/ 1322513 w 1417935"/>
              <a:gd name="connsiteY6" fmla="*/ 1718180 h 1718180"/>
              <a:gd name="connsiteX7" fmla="*/ 95422 w 1417935"/>
              <a:gd name="connsiteY7" fmla="*/ 1718180 h 1718180"/>
              <a:gd name="connsiteX8" fmla="*/ 0 w 1417935"/>
              <a:gd name="connsiteY8" fmla="*/ 1622758 h 1718180"/>
              <a:gd name="connsiteX9" fmla="*/ 357808 w 1417935"/>
              <a:gd name="connsiteY9" fmla="*/ 1249033 h 1718180"/>
              <a:gd name="connsiteX0" fmla="*/ 421419 w 1417935"/>
              <a:gd name="connsiteY0" fmla="*/ 1209276 h 1718180"/>
              <a:gd name="connsiteX1" fmla="*/ 461182 w 1417935"/>
              <a:gd name="connsiteY1" fmla="*/ 127893 h 1718180"/>
              <a:gd name="connsiteX2" fmla="*/ 1002221 w 1417935"/>
              <a:gd name="connsiteY2" fmla="*/ 106789 h 1718180"/>
              <a:gd name="connsiteX3" fmla="*/ 1004461 w 1417935"/>
              <a:gd name="connsiteY3" fmla="*/ 1280832 h 1718180"/>
              <a:gd name="connsiteX4" fmla="*/ 1290714 w 1417935"/>
              <a:gd name="connsiteY4" fmla="*/ 1304692 h 1718180"/>
              <a:gd name="connsiteX5" fmla="*/ 1417935 w 1417935"/>
              <a:gd name="connsiteY5" fmla="*/ 1622758 h 1718180"/>
              <a:gd name="connsiteX6" fmla="*/ 1322513 w 1417935"/>
              <a:gd name="connsiteY6" fmla="*/ 1718180 h 1718180"/>
              <a:gd name="connsiteX7" fmla="*/ 95422 w 1417935"/>
              <a:gd name="connsiteY7" fmla="*/ 1718180 h 1718180"/>
              <a:gd name="connsiteX8" fmla="*/ 0 w 1417935"/>
              <a:gd name="connsiteY8" fmla="*/ 1622758 h 1718180"/>
              <a:gd name="connsiteX9" fmla="*/ 421419 w 1417935"/>
              <a:gd name="connsiteY9" fmla="*/ 1209276 h 1718180"/>
              <a:gd name="connsiteX0" fmla="*/ 421419 w 1417935"/>
              <a:gd name="connsiteY0" fmla="*/ 1209276 h 1718180"/>
              <a:gd name="connsiteX1" fmla="*/ 461182 w 1417935"/>
              <a:gd name="connsiteY1" fmla="*/ 127893 h 1718180"/>
              <a:gd name="connsiteX2" fmla="*/ 1002221 w 1417935"/>
              <a:gd name="connsiteY2" fmla="*/ 106789 h 1718180"/>
              <a:gd name="connsiteX3" fmla="*/ 1004461 w 1417935"/>
              <a:gd name="connsiteY3" fmla="*/ 1280832 h 1718180"/>
              <a:gd name="connsiteX4" fmla="*/ 1290714 w 1417935"/>
              <a:gd name="connsiteY4" fmla="*/ 1304692 h 1718180"/>
              <a:gd name="connsiteX5" fmla="*/ 1417935 w 1417935"/>
              <a:gd name="connsiteY5" fmla="*/ 1622758 h 1718180"/>
              <a:gd name="connsiteX6" fmla="*/ 1322513 w 1417935"/>
              <a:gd name="connsiteY6" fmla="*/ 1718180 h 1718180"/>
              <a:gd name="connsiteX7" fmla="*/ 95422 w 1417935"/>
              <a:gd name="connsiteY7" fmla="*/ 1718180 h 1718180"/>
              <a:gd name="connsiteX8" fmla="*/ 0 w 1417935"/>
              <a:gd name="connsiteY8" fmla="*/ 1622758 h 1718180"/>
              <a:gd name="connsiteX9" fmla="*/ 119626 w 1417935"/>
              <a:gd name="connsiteY9" fmla="*/ 1299484 h 1718180"/>
              <a:gd name="connsiteX10" fmla="*/ 421419 w 1417935"/>
              <a:gd name="connsiteY10" fmla="*/ 1209276 h 1718180"/>
              <a:gd name="connsiteX0" fmla="*/ 461175 w 1417935"/>
              <a:gd name="connsiteY0" fmla="*/ 1177470 h 1718180"/>
              <a:gd name="connsiteX1" fmla="*/ 461182 w 1417935"/>
              <a:gd name="connsiteY1" fmla="*/ 127893 h 1718180"/>
              <a:gd name="connsiteX2" fmla="*/ 1002221 w 1417935"/>
              <a:gd name="connsiteY2" fmla="*/ 106789 h 1718180"/>
              <a:gd name="connsiteX3" fmla="*/ 1004461 w 1417935"/>
              <a:gd name="connsiteY3" fmla="*/ 1280832 h 1718180"/>
              <a:gd name="connsiteX4" fmla="*/ 1290714 w 1417935"/>
              <a:gd name="connsiteY4" fmla="*/ 1304692 h 1718180"/>
              <a:gd name="connsiteX5" fmla="*/ 1417935 w 1417935"/>
              <a:gd name="connsiteY5" fmla="*/ 1622758 h 1718180"/>
              <a:gd name="connsiteX6" fmla="*/ 1322513 w 1417935"/>
              <a:gd name="connsiteY6" fmla="*/ 1718180 h 1718180"/>
              <a:gd name="connsiteX7" fmla="*/ 95422 w 1417935"/>
              <a:gd name="connsiteY7" fmla="*/ 1718180 h 1718180"/>
              <a:gd name="connsiteX8" fmla="*/ 0 w 1417935"/>
              <a:gd name="connsiteY8" fmla="*/ 1622758 h 1718180"/>
              <a:gd name="connsiteX9" fmla="*/ 119626 w 1417935"/>
              <a:gd name="connsiteY9" fmla="*/ 1299484 h 1718180"/>
              <a:gd name="connsiteX10" fmla="*/ 461175 w 1417935"/>
              <a:gd name="connsiteY10" fmla="*/ 1177470 h 1718180"/>
              <a:gd name="connsiteX0" fmla="*/ 461175 w 1417935"/>
              <a:gd name="connsiteY0" fmla="*/ 1177470 h 1718180"/>
              <a:gd name="connsiteX1" fmla="*/ 461182 w 1417935"/>
              <a:gd name="connsiteY1" fmla="*/ 127893 h 1718180"/>
              <a:gd name="connsiteX2" fmla="*/ 1002221 w 1417935"/>
              <a:gd name="connsiteY2" fmla="*/ 106789 h 1718180"/>
              <a:gd name="connsiteX3" fmla="*/ 996510 w 1417935"/>
              <a:gd name="connsiteY3" fmla="*/ 1201319 h 1718180"/>
              <a:gd name="connsiteX4" fmla="*/ 1290714 w 1417935"/>
              <a:gd name="connsiteY4" fmla="*/ 1304692 h 1718180"/>
              <a:gd name="connsiteX5" fmla="*/ 1417935 w 1417935"/>
              <a:gd name="connsiteY5" fmla="*/ 1622758 h 1718180"/>
              <a:gd name="connsiteX6" fmla="*/ 1322513 w 1417935"/>
              <a:gd name="connsiteY6" fmla="*/ 1718180 h 1718180"/>
              <a:gd name="connsiteX7" fmla="*/ 95422 w 1417935"/>
              <a:gd name="connsiteY7" fmla="*/ 1718180 h 1718180"/>
              <a:gd name="connsiteX8" fmla="*/ 0 w 1417935"/>
              <a:gd name="connsiteY8" fmla="*/ 1622758 h 1718180"/>
              <a:gd name="connsiteX9" fmla="*/ 119626 w 1417935"/>
              <a:gd name="connsiteY9" fmla="*/ 1299484 h 1718180"/>
              <a:gd name="connsiteX10" fmla="*/ 461175 w 1417935"/>
              <a:gd name="connsiteY10" fmla="*/ 1177470 h 1718180"/>
              <a:gd name="connsiteX0" fmla="*/ 461175 w 1417935"/>
              <a:gd name="connsiteY0" fmla="*/ 1177470 h 1718180"/>
              <a:gd name="connsiteX1" fmla="*/ 461182 w 1417935"/>
              <a:gd name="connsiteY1" fmla="*/ 127893 h 1718180"/>
              <a:gd name="connsiteX2" fmla="*/ 1002221 w 1417935"/>
              <a:gd name="connsiteY2" fmla="*/ 106789 h 1718180"/>
              <a:gd name="connsiteX3" fmla="*/ 996510 w 1417935"/>
              <a:gd name="connsiteY3" fmla="*/ 1201319 h 1718180"/>
              <a:gd name="connsiteX4" fmla="*/ 1417935 w 1417935"/>
              <a:gd name="connsiteY4" fmla="*/ 1288789 h 1718180"/>
              <a:gd name="connsiteX5" fmla="*/ 1417935 w 1417935"/>
              <a:gd name="connsiteY5" fmla="*/ 1622758 h 1718180"/>
              <a:gd name="connsiteX6" fmla="*/ 1322513 w 1417935"/>
              <a:gd name="connsiteY6" fmla="*/ 1718180 h 1718180"/>
              <a:gd name="connsiteX7" fmla="*/ 95422 w 1417935"/>
              <a:gd name="connsiteY7" fmla="*/ 1718180 h 1718180"/>
              <a:gd name="connsiteX8" fmla="*/ 0 w 1417935"/>
              <a:gd name="connsiteY8" fmla="*/ 1622758 h 1718180"/>
              <a:gd name="connsiteX9" fmla="*/ 119626 w 1417935"/>
              <a:gd name="connsiteY9" fmla="*/ 1299484 h 1718180"/>
              <a:gd name="connsiteX10" fmla="*/ 461175 w 1417935"/>
              <a:gd name="connsiteY10" fmla="*/ 1177470 h 1718180"/>
              <a:gd name="connsiteX0" fmla="*/ 461175 w 1417935"/>
              <a:gd name="connsiteY0" fmla="*/ 1177470 h 1718180"/>
              <a:gd name="connsiteX1" fmla="*/ 461182 w 1417935"/>
              <a:gd name="connsiteY1" fmla="*/ 127893 h 1718180"/>
              <a:gd name="connsiteX2" fmla="*/ 1002221 w 1417935"/>
              <a:gd name="connsiteY2" fmla="*/ 106789 h 1718180"/>
              <a:gd name="connsiteX3" fmla="*/ 996510 w 1417935"/>
              <a:gd name="connsiteY3" fmla="*/ 1201319 h 1718180"/>
              <a:gd name="connsiteX4" fmla="*/ 1417935 w 1417935"/>
              <a:gd name="connsiteY4" fmla="*/ 1288789 h 1718180"/>
              <a:gd name="connsiteX5" fmla="*/ 1417935 w 1417935"/>
              <a:gd name="connsiteY5" fmla="*/ 1622758 h 1718180"/>
              <a:gd name="connsiteX6" fmla="*/ 1322513 w 1417935"/>
              <a:gd name="connsiteY6" fmla="*/ 1718180 h 1718180"/>
              <a:gd name="connsiteX7" fmla="*/ 95422 w 1417935"/>
              <a:gd name="connsiteY7" fmla="*/ 1718180 h 1718180"/>
              <a:gd name="connsiteX8" fmla="*/ 0 w 1417935"/>
              <a:gd name="connsiteY8" fmla="*/ 1622758 h 1718180"/>
              <a:gd name="connsiteX9" fmla="*/ 119626 w 1417935"/>
              <a:gd name="connsiteY9" fmla="*/ 1299484 h 1718180"/>
              <a:gd name="connsiteX10" fmla="*/ 461175 w 1417935"/>
              <a:gd name="connsiteY10" fmla="*/ 1177470 h 1718180"/>
              <a:gd name="connsiteX0" fmla="*/ 461175 w 1417935"/>
              <a:gd name="connsiteY0" fmla="*/ 1177470 h 1718180"/>
              <a:gd name="connsiteX1" fmla="*/ 461182 w 1417935"/>
              <a:gd name="connsiteY1" fmla="*/ 127893 h 1718180"/>
              <a:gd name="connsiteX2" fmla="*/ 1002221 w 1417935"/>
              <a:gd name="connsiteY2" fmla="*/ 106789 h 1718180"/>
              <a:gd name="connsiteX3" fmla="*/ 980608 w 1417935"/>
              <a:gd name="connsiteY3" fmla="*/ 1249027 h 1718180"/>
              <a:gd name="connsiteX4" fmla="*/ 1417935 w 1417935"/>
              <a:gd name="connsiteY4" fmla="*/ 1288789 h 1718180"/>
              <a:gd name="connsiteX5" fmla="*/ 1417935 w 1417935"/>
              <a:gd name="connsiteY5" fmla="*/ 1622758 h 1718180"/>
              <a:gd name="connsiteX6" fmla="*/ 1322513 w 1417935"/>
              <a:gd name="connsiteY6" fmla="*/ 1718180 h 1718180"/>
              <a:gd name="connsiteX7" fmla="*/ 95422 w 1417935"/>
              <a:gd name="connsiteY7" fmla="*/ 1718180 h 1718180"/>
              <a:gd name="connsiteX8" fmla="*/ 0 w 1417935"/>
              <a:gd name="connsiteY8" fmla="*/ 1622758 h 1718180"/>
              <a:gd name="connsiteX9" fmla="*/ 119626 w 1417935"/>
              <a:gd name="connsiteY9" fmla="*/ 1299484 h 1718180"/>
              <a:gd name="connsiteX10" fmla="*/ 461175 w 1417935"/>
              <a:gd name="connsiteY10" fmla="*/ 1177470 h 1718180"/>
              <a:gd name="connsiteX0" fmla="*/ 461175 w 1417935"/>
              <a:gd name="connsiteY0" fmla="*/ 1177470 h 1718180"/>
              <a:gd name="connsiteX1" fmla="*/ 461182 w 1417935"/>
              <a:gd name="connsiteY1" fmla="*/ 127893 h 1718180"/>
              <a:gd name="connsiteX2" fmla="*/ 1002221 w 1417935"/>
              <a:gd name="connsiteY2" fmla="*/ 106789 h 1718180"/>
              <a:gd name="connsiteX3" fmla="*/ 980608 w 1417935"/>
              <a:gd name="connsiteY3" fmla="*/ 1249027 h 1718180"/>
              <a:gd name="connsiteX4" fmla="*/ 1417935 w 1417935"/>
              <a:gd name="connsiteY4" fmla="*/ 1288789 h 1718180"/>
              <a:gd name="connsiteX5" fmla="*/ 1417935 w 1417935"/>
              <a:gd name="connsiteY5" fmla="*/ 1622758 h 1718180"/>
              <a:gd name="connsiteX6" fmla="*/ 1322513 w 1417935"/>
              <a:gd name="connsiteY6" fmla="*/ 1718180 h 1718180"/>
              <a:gd name="connsiteX7" fmla="*/ 95422 w 1417935"/>
              <a:gd name="connsiteY7" fmla="*/ 1718180 h 1718180"/>
              <a:gd name="connsiteX8" fmla="*/ 0 w 1417935"/>
              <a:gd name="connsiteY8" fmla="*/ 1622758 h 1718180"/>
              <a:gd name="connsiteX9" fmla="*/ 119626 w 1417935"/>
              <a:gd name="connsiteY9" fmla="*/ 1299484 h 1718180"/>
              <a:gd name="connsiteX10" fmla="*/ 461175 w 1417935"/>
              <a:gd name="connsiteY10" fmla="*/ 1177470 h 1718180"/>
              <a:gd name="connsiteX0" fmla="*/ 461175 w 1417935"/>
              <a:gd name="connsiteY0" fmla="*/ 1177470 h 1718180"/>
              <a:gd name="connsiteX1" fmla="*/ 461182 w 1417935"/>
              <a:gd name="connsiteY1" fmla="*/ 127893 h 1718180"/>
              <a:gd name="connsiteX2" fmla="*/ 1002221 w 1417935"/>
              <a:gd name="connsiteY2" fmla="*/ 106789 h 1718180"/>
              <a:gd name="connsiteX3" fmla="*/ 980608 w 1417935"/>
              <a:gd name="connsiteY3" fmla="*/ 1249027 h 1718180"/>
              <a:gd name="connsiteX4" fmla="*/ 1417935 w 1417935"/>
              <a:gd name="connsiteY4" fmla="*/ 1288789 h 1718180"/>
              <a:gd name="connsiteX5" fmla="*/ 1417935 w 1417935"/>
              <a:gd name="connsiteY5" fmla="*/ 1622758 h 1718180"/>
              <a:gd name="connsiteX6" fmla="*/ 1322513 w 1417935"/>
              <a:gd name="connsiteY6" fmla="*/ 1718180 h 1718180"/>
              <a:gd name="connsiteX7" fmla="*/ 95422 w 1417935"/>
              <a:gd name="connsiteY7" fmla="*/ 1718180 h 1718180"/>
              <a:gd name="connsiteX8" fmla="*/ 0 w 1417935"/>
              <a:gd name="connsiteY8" fmla="*/ 1622758 h 1718180"/>
              <a:gd name="connsiteX9" fmla="*/ 40113 w 1417935"/>
              <a:gd name="connsiteY9" fmla="*/ 1299484 h 1718180"/>
              <a:gd name="connsiteX10" fmla="*/ 461175 w 1417935"/>
              <a:gd name="connsiteY10" fmla="*/ 1177470 h 1718180"/>
              <a:gd name="connsiteX0" fmla="*/ 421418 w 1417935"/>
              <a:gd name="connsiteY0" fmla="*/ 1217227 h 1718180"/>
              <a:gd name="connsiteX1" fmla="*/ 461182 w 1417935"/>
              <a:gd name="connsiteY1" fmla="*/ 127893 h 1718180"/>
              <a:gd name="connsiteX2" fmla="*/ 1002221 w 1417935"/>
              <a:gd name="connsiteY2" fmla="*/ 106789 h 1718180"/>
              <a:gd name="connsiteX3" fmla="*/ 980608 w 1417935"/>
              <a:gd name="connsiteY3" fmla="*/ 1249027 h 1718180"/>
              <a:gd name="connsiteX4" fmla="*/ 1417935 w 1417935"/>
              <a:gd name="connsiteY4" fmla="*/ 1288789 h 1718180"/>
              <a:gd name="connsiteX5" fmla="*/ 1417935 w 1417935"/>
              <a:gd name="connsiteY5" fmla="*/ 1622758 h 1718180"/>
              <a:gd name="connsiteX6" fmla="*/ 1322513 w 1417935"/>
              <a:gd name="connsiteY6" fmla="*/ 1718180 h 1718180"/>
              <a:gd name="connsiteX7" fmla="*/ 95422 w 1417935"/>
              <a:gd name="connsiteY7" fmla="*/ 1718180 h 1718180"/>
              <a:gd name="connsiteX8" fmla="*/ 0 w 1417935"/>
              <a:gd name="connsiteY8" fmla="*/ 1622758 h 1718180"/>
              <a:gd name="connsiteX9" fmla="*/ 40113 w 1417935"/>
              <a:gd name="connsiteY9" fmla="*/ 1299484 h 1718180"/>
              <a:gd name="connsiteX10" fmla="*/ 421418 w 1417935"/>
              <a:gd name="connsiteY10" fmla="*/ 1217227 h 1718180"/>
              <a:gd name="connsiteX0" fmla="*/ 421418 w 1417935"/>
              <a:gd name="connsiteY0" fmla="*/ 1217227 h 1718180"/>
              <a:gd name="connsiteX1" fmla="*/ 461182 w 1417935"/>
              <a:gd name="connsiteY1" fmla="*/ 127893 h 1718180"/>
              <a:gd name="connsiteX2" fmla="*/ 1002221 w 1417935"/>
              <a:gd name="connsiteY2" fmla="*/ 106789 h 1718180"/>
              <a:gd name="connsiteX3" fmla="*/ 980608 w 1417935"/>
              <a:gd name="connsiteY3" fmla="*/ 1249027 h 1718180"/>
              <a:gd name="connsiteX4" fmla="*/ 1417935 w 1417935"/>
              <a:gd name="connsiteY4" fmla="*/ 1288789 h 1718180"/>
              <a:gd name="connsiteX5" fmla="*/ 1417935 w 1417935"/>
              <a:gd name="connsiteY5" fmla="*/ 1622758 h 1718180"/>
              <a:gd name="connsiteX6" fmla="*/ 1322513 w 1417935"/>
              <a:gd name="connsiteY6" fmla="*/ 1718180 h 1718180"/>
              <a:gd name="connsiteX7" fmla="*/ 95422 w 1417935"/>
              <a:gd name="connsiteY7" fmla="*/ 1718180 h 1718180"/>
              <a:gd name="connsiteX8" fmla="*/ 0 w 1417935"/>
              <a:gd name="connsiteY8" fmla="*/ 1622758 h 1718180"/>
              <a:gd name="connsiteX9" fmla="*/ 40113 w 1417935"/>
              <a:gd name="connsiteY9" fmla="*/ 1299484 h 1718180"/>
              <a:gd name="connsiteX10" fmla="*/ 421418 w 1417935"/>
              <a:gd name="connsiteY10" fmla="*/ 1217227 h 1718180"/>
              <a:gd name="connsiteX0" fmla="*/ 421418 w 1417935"/>
              <a:gd name="connsiteY0" fmla="*/ 1228427 h 1729380"/>
              <a:gd name="connsiteX1" fmla="*/ 437328 w 1417935"/>
              <a:gd name="connsiteY1" fmla="*/ 115239 h 1729380"/>
              <a:gd name="connsiteX2" fmla="*/ 1002221 w 1417935"/>
              <a:gd name="connsiteY2" fmla="*/ 117989 h 1729380"/>
              <a:gd name="connsiteX3" fmla="*/ 980608 w 1417935"/>
              <a:gd name="connsiteY3" fmla="*/ 1260227 h 1729380"/>
              <a:gd name="connsiteX4" fmla="*/ 1417935 w 1417935"/>
              <a:gd name="connsiteY4" fmla="*/ 1299989 h 1729380"/>
              <a:gd name="connsiteX5" fmla="*/ 1417935 w 1417935"/>
              <a:gd name="connsiteY5" fmla="*/ 1633958 h 1729380"/>
              <a:gd name="connsiteX6" fmla="*/ 1322513 w 1417935"/>
              <a:gd name="connsiteY6" fmla="*/ 1729380 h 1729380"/>
              <a:gd name="connsiteX7" fmla="*/ 95422 w 1417935"/>
              <a:gd name="connsiteY7" fmla="*/ 1729380 h 1729380"/>
              <a:gd name="connsiteX8" fmla="*/ 0 w 1417935"/>
              <a:gd name="connsiteY8" fmla="*/ 1633958 h 1729380"/>
              <a:gd name="connsiteX9" fmla="*/ 40113 w 1417935"/>
              <a:gd name="connsiteY9" fmla="*/ 1310684 h 1729380"/>
              <a:gd name="connsiteX10" fmla="*/ 421418 w 1417935"/>
              <a:gd name="connsiteY10" fmla="*/ 1228427 h 1729380"/>
              <a:gd name="connsiteX0" fmla="*/ 389613 w 1417935"/>
              <a:gd name="connsiteY0" fmla="*/ 1093255 h 1729380"/>
              <a:gd name="connsiteX1" fmla="*/ 437328 w 1417935"/>
              <a:gd name="connsiteY1" fmla="*/ 115239 h 1729380"/>
              <a:gd name="connsiteX2" fmla="*/ 1002221 w 1417935"/>
              <a:gd name="connsiteY2" fmla="*/ 117989 h 1729380"/>
              <a:gd name="connsiteX3" fmla="*/ 980608 w 1417935"/>
              <a:gd name="connsiteY3" fmla="*/ 1260227 h 1729380"/>
              <a:gd name="connsiteX4" fmla="*/ 1417935 w 1417935"/>
              <a:gd name="connsiteY4" fmla="*/ 1299989 h 1729380"/>
              <a:gd name="connsiteX5" fmla="*/ 1417935 w 1417935"/>
              <a:gd name="connsiteY5" fmla="*/ 1633958 h 1729380"/>
              <a:gd name="connsiteX6" fmla="*/ 1322513 w 1417935"/>
              <a:gd name="connsiteY6" fmla="*/ 1729380 h 1729380"/>
              <a:gd name="connsiteX7" fmla="*/ 95422 w 1417935"/>
              <a:gd name="connsiteY7" fmla="*/ 1729380 h 1729380"/>
              <a:gd name="connsiteX8" fmla="*/ 0 w 1417935"/>
              <a:gd name="connsiteY8" fmla="*/ 1633958 h 1729380"/>
              <a:gd name="connsiteX9" fmla="*/ 40113 w 1417935"/>
              <a:gd name="connsiteY9" fmla="*/ 1310684 h 1729380"/>
              <a:gd name="connsiteX10" fmla="*/ 389613 w 1417935"/>
              <a:gd name="connsiteY10" fmla="*/ 1093255 h 1729380"/>
              <a:gd name="connsiteX0" fmla="*/ 389613 w 1417935"/>
              <a:gd name="connsiteY0" fmla="*/ 1093255 h 1729380"/>
              <a:gd name="connsiteX1" fmla="*/ 437328 w 1417935"/>
              <a:gd name="connsiteY1" fmla="*/ 115239 h 1729380"/>
              <a:gd name="connsiteX2" fmla="*/ 1002221 w 1417935"/>
              <a:gd name="connsiteY2" fmla="*/ 117989 h 1729380"/>
              <a:gd name="connsiteX3" fmla="*/ 1099877 w 1417935"/>
              <a:gd name="connsiteY3" fmla="*/ 1148908 h 1729380"/>
              <a:gd name="connsiteX4" fmla="*/ 1417935 w 1417935"/>
              <a:gd name="connsiteY4" fmla="*/ 1299989 h 1729380"/>
              <a:gd name="connsiteX5" fmla="*/ 1417935 w 1417935"/>
              <a:gd name="connsiteY5" fmla="*/ 1633958 h 1729380"/>
              <a:gd name="connsiteX6" fmla="*/ 1322513 w 1417935"/>
              <a:gd name="connsiteY6" fmla="*/ 1729380 h 1729380"/>
              <a:gd name="connsiteX7" fmla="*/ 95422 w 1417935"/>
              <a:gd name="connsiteY7" fmla="*/ 1729380 h 1729380"/>
              <a:gd name="connsiteX8" fmla="*/ 0 w 1417935"/>
              <a:gd name="connsiteY8" fmla="*/ 1633958 h 1729380"/>
              <a:gd name="connsiteX9" fmla="*/ 40113 w 1417935"/>
              <a:gd name="connsiteY9" fmla="*/ 1310684 h 1729380"/>
              <a:gd name="connsiteX10" fmla="*/ 389613 w 1417935"/>
              <a:gd name="connsiteY10" fmla="*/ 1093255 h 1729380"/>
              <a:gd name="connsiteX0" fmla="*/ 357808 w 1417935"/>
              <a:gd name="connsiteY0" fmla="*/ 1093255 h 1729380"/>
              <a:gd name="connsiteX1" fmla="*/ 437328 w 1417935"/>
              <a:gd name="connsiteY1" fmla="*/ 115239 h 1729380"/>
              <a:gd name="connsiteX2" fmla="*/ 1002221 w 1417935"/>
              <a:gd name="connsiteY2" fmla="*/ 117989 h 1729380"/>
              <a:gd name="connsiteX3" fmla="*/ 1099877 w 1417935"/>
              <a:gd name="connsiteY3" fmla="*/ 1148908 h 1729380"/>
              <a:gd name="connsiteX4" fmla="*/ 1417935 w 1417935"/>
              <a:gd name="connsiteY4" fmla="*/ 1299989 h 1729380"/>
              <a:gd name="connsiteX5" fmla="*/ 1417935 w 1417935"/>
              <a:gd name="connsiteY5" fmla="*/ 1633958 h 1729380"/>
              <a:gd name="connsiteX6" fmla="*/ 1322513 w 1417935"/>
              <a:gd name="connsiteY6" fmla="*/ 1729380 h 1729380"/>
              <a:gd name="connsiteX7" fmla="*/ 95422 w 1417935"/>
              <a:gd name="connsiteY7" fmla="*/ 1729380 h 1729380"/>
              <a:gd name="connsiteX8" fmla="*/ 0 w 1417935"/>
              <a:gd name="connsiteY8" fmla="*/ 1633958 h 1729380"/>
              <a:gd name="connsiteX9" fmla="*/ 40113 w 1417935"/>
              <a:gd name="connsiteY9" fmla="*/ 1310684 h 1729380"/>
              <a:gd name="connsiteX10" fmla="*/ 357808 w 1417935"/>
              <a:gd name="connsiteY10" fmla="*/ 1093255 h 1729380"/>
              <a:gd name="connsiteX0" fmla="*/ 357808 w 1417935"/>
              <a:gd name="connsiteY0" fmla="*/ 1093255 h 1729380"/>
              <a:gd name="connsiteX1" fmla="*/ 437328 w 1417935"/>
              <a:gd name="connsiteY1" fmla="*/ 115239 h 1729380"/>
              <a:gd name="connsiteX2" fmla="*/ 1002221 w 1417935"/>
              <a:gd name="connsiteY2" fmla="*/ 117989 h 1729380"/>
              <a:gd name="connsiteX3" fmla="*/ 1020364 w 1417935"/>
              <a:gd name="connsiteY3" fmla="*/ 1109151 h 1729380"/>
              <a:gd name="connsiteX4" fmla="*/ 1417935 w 1417935"/>
              <a:gd name="connsiteY4" fmla="*/ 1299989 h 1729380"/>
              <a:gd name="connsiteX5" fmla="*/ 1417935 w 1417935"/>
              <a:gd name="connsiteY5" fmla="*/ 1633958 h 1729380"/>
              <a:gd name="connsiteX6" fmla="*/ 1322513 w 1417935"/>
              <a:gd name="connsiteY6" fmla="*/ 1729380 h 1729380"/>
              <a:gd name="connsiteX7" fmla="*/ 95422 w 1417935"/>
              <a:gd name="connsiteY7" fmla="*/ 1729380 h 1729380"/>
              <a:gd name="connsiteX8" fmla="*/ 0 w 1417935"/>
              <a:gd name="connsiteY8" fmla="*/ 1633958 h 1729380"/>
              <a:gd name="connsiteX9" fmla="*/ 40113 w 1417935"/>
              <a:gd name="connsiteY9" fmla="*/ 1310684 h 1729380"/>
              <a:gd name="connsiteX10" fmla="*/ 357808 w 1417935"/>
              <a:gd name="connsiteY10" fmla="*/ 1093255 h 1729380"/>
              <a:gd name="connsiteX0" fmla="*/ 357808 w 1417935"/>
              <a:gd name="connsiteY0" fmla="*/ 1093255 h 1729380"/>
              <a:gd name="connsiteX1" fmla="*/ 437328 w 1417935"/>
              <a:gd name="connsiteY1" fmla="*/ 115239 h 1729380"/>
              <a:gd name="connsiteX2" fmla="*/ 1002221 w 1417935"/>
              <a:gd name="connsiteY2" fmla="*/ 117989 h 1729380"/>
              <a:gd name="connsiteX3" fmla="*/ 1020364 w 1417935"/>
              <a:gd name="connsiteY3" fmla="*/ 1109151 h 1729380"/>
              <a:gd name="connsiteX4" fmla="*/ 1378179 w 1417935"/>
              <a:gd name="connsiteY4" fmla="*/ 1315891 h 1729380"/>
              <a:gd name="connsiteX5" fmla="*/ 1417935 w 1417935"/>
              <a:gd name="connsiteY5" fmla="*/ 1633958 h 1729380"/>
              <a:gd name="connsiteX6" fmla="*/ 1322513 w 1417935"/>
              <a:gd name="connsiteY6" fmla="*/ 1729380 h 1729380"/>
              <a:gd name="connsiteX7" fmla="*/ 95422 w 1417935"/>
              <a:gd name="connsiteY7" fmla="*/ 1729380 h 1729380"/>
              <a:gd name="connsiteX8" fmla="*/ 0 w 1417935"/>
              <a:gd name="connsiteY8" fmla="*/ 1633958 h 1729380"/>
              <a:gd name="connsiteX9" fmla="*/ 40113 w 1417935"/>
              <a:gd name="connsiteY9" fmla="*/ 1310684 h 1729380"/>
              <a:gd name="connsiteX10" fmla="*/ 357808 w 1417935"/>
              <a:gd name="connsiteY10" fmla="*/ 1093255 h 1729380"/>
              <a:gd name="connsiteX0" fmla="*/ 357808 w 1433838"/>
              <a:gd name="connsiteY0" fmla="*/ 1093255 h 1729380"/>
              <a:gd name="connsiteX1" fmla="*/ 437328 w 1433838"/>
              <a:gd name="connsiteY1" fmla="*/ 115239 h 1729380"/>
              <a:gd name="connsiteX2" fmla="*/ 1002221 w 1433838"/>
              <a:gd name="connsiteY2" fmla="*/ 117989 h 1729380"/>
              <a:gd name="connsiteX3" fmla="*/ 1020364 w 1433838"/>
              <a:gd name="connsiteY3" fmla="*/ 1109151 h 1729380"/>
              <a:gd name="connsiteX4" fmla="*/ 1433838 w 1433838"/>
              <a:gd name="connsiteY4" fmla="*/ 1323842 h 1729380"/>
              <a:gd name="connsiteX5" fmla="*/ 1417935 w 1433838"/>
              <a:gd name="connsiteY5" fmla="*/ 1633958 h 1729380"/>
              <a:gd name="connsiteX6" fmla="*/ 1322513 w 1433838"/>
              <a:gd name="connsiteY6" fmla="*/ 1729380 h 1729380"/>
              <a:gd name="connsiteX7" fmla="*/ 95422 w 1433838"/>
              <a:gd name="connsiteY7" fmla="*/ 1729380 h 1729380"/>
              <a:gd name="connsiteX8" fmla="*/ 0 w 1433838"/>
              <a:gd name="connsiteY8" fmla="*/ 1633958 h 1729380"/>
              <a:gd name="connsiteX9" fmla="*/ 40113 w 1433838"/>
              <a:gd name="connsiteY9" fmla="*/ 1310684 h 1729380"/>
              <a:gd name="connsiteX10" fmla="*/ 357808 w 1433838"/>
              <a:gd name="connsiteY10" fmla="*/ 1093255 h 1729380"/>
              <a:gd name="connsiteX0" fmla="*/ 397564 w 1433838"/>
              <a:gd name="connsiteY0" fmla="*/ 1077352 h 1729380"/>
              <a:gd name="connsiteX1" fmla="*/ 437328 w 1433838"/>
              <a:gd name="connsiteY1" fmla="*/ 115239 h 1729380"/>
              <a:gd name="connsiteX2" fmla="*/ 1002221 w 1433838"/>
              <a:gd name="connsiteY2" fmla="*/ 117989 h 1729380"/>
              <a:gd name="connsiteX3" fmla="*/ 1020364 w 1433838"/>
              <a:gd name="connsiteY3" fmla="*/ 1109151 h 1729380"/>
              <a:gd name="connsiteX4" fmla="*/ 1433838 w 1433838"/>
              <a:gd name="connsiteY4" fmla="*/ 1323842 h 1729380"/>
              <a:gd name="connsiteX5" fmla="*/ 1417935 w 1433838"/>
              <a:gd name="connsiteY5" fmla="*/ 1633958 h 1729380"/>
              <a:gd name="connsiteX6" fmla="*/ 1322513 w 1433838"/>
              <a:gd name="connsiteY6" fmla="*/ 1729380 h 1729380"/>
              <a:gd name="connsiteX7" fmla="*/ 95422 w 1433838"/>
              <a:gd name="connsiteY7" fmla="*/ 1729380 h 1729380"/>
              <a:gd name="connsiteX8" fmla="*/ 0 w 1433838"/>
              <a:gd name="connsiteY8" fmla="*/ 1633958 h 1729380"/>
              <a:gd name="connsiteX9" fmla="*/ 40113 w 1433838"/>
              <a:gd name="connsiteY9" fmla="*/ 1310684 h 1729380"/>
              <a:gd name="connsiteX10" fmla="*/ 397564 w 1433838"/>
              <a:gd name="connsiteY10" fmla="*/ 1077352 h 1729380"/>
              <a:gd name="connsiteX0" fmla="*/ 389613 w 1433838"/>
              <a:gd name="connsiteY0" fmla="*/ 1125059 h 1729380"/>
              <a:gd name="connsiteX1" fmla="*/ 437328 w 1433838"/>
              <a:gd name="connsiteY1" fmla="*/ 115239 h 1729380"/>
              <a:gd name="connsiteX2" fmla="*/ 1002221 w 1433838"/>
              <a:gd name="connsiteY2" fmla="*/ 117989 h 1729380"/>
              <a:gd name="connsiteX3" fmla="*/ 1020364 w 1433838"/>
              <a:gd name="connsiteY3" fmla="*/ 1109151 h 1729380"/>
              <a:gd name="connsiteX4" fmla="*/ 1433838 w 1433838"/>
              <a:gd name="connsiteY4" fmla="*/ 1323842 h 1729380"/>
              <a:gd name="connsiteX5" fmla="*/ 1417935 w 1433838"/>
              <a:gd name="connsiteY5" fmla="*/ 1633958 h 1729380"/>
              <a:gd name="connsiteX6" fmla="*/ 1322513 w 1433838"/>
              <a:gd name="connsiteY6" fmla="*/ 1729380 h 1729380"/>
              <a:gd name="connsiteX7" fmla="*/ 95422 w 1433838"/>
              <a:gd name="connsiteY7" fmla="*/ 1729380 h 1729380"/>
              <a:gd name="connsiteX8" fmla="*/ 0 w 1433838"/>
              <a:gd name="connsiteY8" fmla="*/ 1633958 h 1729380"/>
              <a:gd name="connsiteX9" fmla="*/ 40113 w 1433838"/>
              <a:gd name="connsiteY9" fmla="*/ 1310684 h 1729380"/>
              <a:gd name="connsiteX10" fmla="*/ 389613 w 1433838"/>
              <a:gd name="connsiteY10" fmla="*/ 1125059 h 1729380"/>
              <a:gd name="connsiteX0" fmla="*/ 399370 w 1443595"/>
              <a:gd name="connsiteY0" fmla="*/ 1125059 h 1729380"/>
              <a:gd name="connsiteX1" fmla="*/ 447085 w 1443595"/>
              <a:gd name="connsiteY1" fmla="*/ 115239 h 1729380"/>
              <a:gd name="connsiteX2" fmla="*/ 1011978 w 1443595"/>
              <a:gd name="connsiteY2" fmla="*/ 117989 h 1729380"/>
              <a:gd name="connsiteX3" fmla="*/ 1030121 w 1443595"/>
              <a:gd name="connsiteY3" fmla="*/ 1109151 h 1729380"/>
              <a:gd name="connsiteX4" fmla="*/ 1443595 w 1443595"/>
              <a:gd name="connsiteY4" fmla="*/ 1323842 h 1729380"/>
              <a:gd name="connsiteX5" fmla="*/ 1427692 w 1443595"/>
              <a:gd name="connsiteY5" fmla="*/ 1633958 h 1729380"/>
              <a:gd name="connsiteX6" fmla="*/ 1332270 w 1443595"/>
              <a:gd name="connsiteY6" fmla="*/ 1729380 h 1729380"/>
              <a:gd name="connsiteX7" fmla="*/ 105179 w 1443595"/>
              <a:gd name="connsiteY7" fmla="*/ 1729380 h 1729380"/>
              <a:gd name="connsiteX8" fmla="*/ 9757 w 1443595"/>
              <a:gd name="connsiteY8" fmla="*/ 1633958 h 1729380"/>
              <a:gd name="connsiteX9" fmla="*/ 33968 w 1443595"/>
              <a:gd name="connsiteY9" fmla="*/ 1270927 h 1729380"/>
              <a:gd name="connsiteX10" fmla="*/ 399370 w 1443595"/>
              <a:gd name="connsiteY10" fmla="*/ 1125059 h 1729380"/>
              <a:gd name="connsiteX0" fmla="*/ 389613 w 1433838"/>
              <a:gd name="connsiteY0" fmla="*/ 1125059 h 1729380"/>
              <a:gd name="connsiteX1" fmla="*/ 437328 w 1433838"/>
              <a:gd name="connsiteY1" fmla="*/ 115239 h 1729380"/>
              <a:gd name="connsiteX2" fmla="*/ 1002221 w 1433838"/>
              <a:gd name="connsiteY2" fmla="*/ 117989 h 1729380"/>
              <a:gd name="connsiteX3" fmla="*/ 1020364 w 1433838"/>
              <a:gd name="connsiteY3" fmla="*/ 1109151 h 1729380"/>
              <a:gd name="connsiteX4" fmla="*/ 1433838 w 1433838"/>
              <a:gd name="connsiteY4" fmla="*/ 1323842 h 1729380"/>
              <a:gd name="connsiteX5" fmla="*/ 1417935 w 1433838"/>
              <a:gd name="connsiteY5" fmla="*/ 1633958 h 1729380"/>
              <a:gd name="connsiteX6" fmla="*/ 1322513 w 1433838"/>
              <a:gd name="connsiteY6" fmla="*/ 1729380 h 1729380"/>
              <a:gd name="connsiteX7" fmla="*/ 95422 w 1433838"/>
              <a:gd name="connsiteY7" fmla="*/ 1729380 h 1729380"/>
              <a:gd name="connsiteX8" fmla="*/ 0 w 1433838"/>
              <a:gd name="connsiteY8" fmla="*/ 1633958 h 1729380"/>
              <a:gd name="connsiteX9" fmla="*/ 40114 w 1433838"/>
              <a:gd name="connsiteY9" fmla="*/ 1270927 h 1729380"/>
              <a:gd name="connsiteX10" fmla="*/ 389613 w 1433838"/>
              <a:gd name="connsiteY10" fmla="*/ 1125059 h 1729380"/>
              <a:gd name="connsiteX0" fmla="*/ 413467 w 1433838"/>
              <a:gd name="connsiteY0" fmla="*/ 1101205 h 1729380"/>
              <a:gd name="connsiteX1" fmla="*/ 437328 w 1433838"/>
              <a:gd name="connsiteY1" fmla="*/ 115239 h 1729380"/>
              <a:gd name="connsiteX2" fmla="*/ 1002221 w 1433838"/>
              <a:gd name="connsiteY2" fmla="*/ 117989 h 1729380"/>
              <a:gd name="connsiteX3" fmla="*/ 1020364 w 1433838"/>
              <a:gd name="connsiteY3" fmla="*/ 1109151 h 1729380"/>
              <a:gd name="connsiteX4" fmla="*/ 1433838 w 1433838"/>
              <a:gd name="connsiteY4" fmla="*/ 1323842 h 1729380"/>
              <a:gd name="connsiteX5" fmla="*/ 1417935 w 1433838"/>
              <a:gd name="connsiteY5" fmla="*/ 1633958 h 1729380"/>
              <a:gd name="connsiteX6" fmla="*/ 1322513 w 1433838"/>
              <a:gd name="connsiteY6" fmla="*/ 1729380 h 1729380"/>
              <a:gd name="connsiteX7" fmla="*/ 95422 w 1433838"/>
              <a:gd name="connsiteY7" fmla="*/ 1729380 h 1729380"/>
              <a:gd name="connsiteX8" fmla="*/ 0 w 1433838"/>
              <a:gd name="connsiteY8" fmla="*/ 1633958 h 1729380"/>
              <a:gd name="connsiteX9" fmla="*/ 40114 w 1433838"/>
              <a:gd name="connsiteY9" fmla="*/ 1270927 h 1729380"/>
              <a:gd name="connsiteX10" fmla="*/ 413467 w 1433838"/>
              <a:gd name="connsiteY10" fmla="*/ 1101205 h 1729380"/>
              <a:gd name="connsiteX0" fmla="*/ 413468 w 1433838"/>
              <a:gd name="connsiteY0" fmla="*/ 1133010 h 1729380"/>
              <a:gd name="connsiteX1" fmla="*/ 437328 w 1433838"/>
              <a:gd name="connsiteY1" fmla="*/ 115239 h 1729380"/>
              <a:gd name="connsiteX2" fmla="*/ 1002221 w 1433838"/>
              <a:gd name="connsiteY2" fmla="*/ 117989 h 1729380"/>
              <a:gd name="connsiteX3" fmla="*/ 1020364 w 1433838"/>
              <a:gd name="connsiteY3" fmla="*/ 1109151 h 1729380"/>
              <a:gd name="connsiteX4" fmla="*/ 1433838 w 1433838"/>
              <a:gd name="connsiteY4" fmla="*/ 1323842 h 1729380"/>
              <a:gd name="connsiteX5" fmla="*/ 1417935 w 1433838"/>
              <a:gd name="connsiteY5" fmla="*/ 1633958 h 1729380"/>
              <a:gd name="connsiteX6" fmla="*/ 1322513 w 1433838"/>
              <a:gd name="connsiteY6" fmla="*/ 1729380 h 1729380"/>
              <a:gd name="connsiteX7" fmla="*/ 95422 w 1433838"/>
              <a:gd name="connsiteY7" fmla="*/ 1729380 h 1729380"/>
              <a:gd name="connsiteX8" fmla="*/ 0 w 1433838"/>
              <a:gd name="connsiteY8" fmla="*/ 1633958 h 1729380"/>
              <a:gd name="connsiteX9" fmla="*/ 40114 w 1433838"/>
              <a:gd name="connsiteY9" fmla="*/ 1270927 h 1729380"/>
              <a:gd name="connsiteX10" fmla="*/ 413468 w 1433838"/>
              <a:gd name="connsiteY10" fmla="*/ 1133010 h 1729380"/>
              <a:gd name="connsiteX0" fmla="*/ 413468 w 1433838"/>
              <a:gd name="connsiteY0" fmla="*/ 1133010 h 1729380"/>
              <a:gd name="connsiteX1" fmla="*/ 437328 w 1433838"/>
              <a:gd name="connsiteY1" fmla="*/ 115239 h 1729380"/>
              <a:gd name="connsiteX2" fmla="*/ 1002221 w 1433838"/>
              <a:gd name="connsiteY2" fmla="*/ 117989 h 1729380"/>
              <a:gd name="connsiteX3" fmla="*/ 1020364 w 1433838"/>
              <a:gd name="connsiteY3" fmla="*/ 1109151 h 1729380"/>
              <a:gd name="connsiteX4" fmla="*/ 1433838 w 1433838"/>
              <a:gd name="connsiteY4" fmla="*/ 1323842 h 1729380"/>
              <a:gd name="connsiteX5" fmla="*/ 1417935 w 1433838"/>
              <a:gd name="connsiteY5" fmla="*/ 1633958 h 1729380"/>
              <a:gd name="connsiteX6" fmla="*/ 1322513 w 1433838"/>
              <a:gd name="connsiteY6" fmla="*/ 1729380 h 1729380"/>
              <a:gd name="connsiteX7" fmla="*/ 95422 w 1433838"/>
              <a:gd name="connsiteY7" fmla="*/ 1729380 h 1729380"/>
              <a:gd name="connsiteX8" fmla="*/ 0 w 1433838"/>
              <a:gd name="connsiteY8" fmla="*/ 1633958 h 1729380"/>
              <a:gd name="connsiteX9" fmla="*/ 40115 w 1433838"/>
              <a:gd name="connsiteY9" fmla="*/ 1334538 h 1729380"/>
              <a:gd name="connsiteX10" fmla="*/ 413468 w 1433838"/>
              <a:gd name="connsiteY10" fmla="*/ 1133010 h 1729380"/>
              <a:gd name="connsiteX0" fmla="*/ 413468 w 1433838"/>
              <a:gd name="connsiteY0" fmla="*/ 1133010 h 1729380"/>
              <a:gd name="connsiteX1" fmla="*/ 437328 w 1433838"/>
              <a:gd name="connsiteY1" fmla="*/ 115239 h 1729380"/>
              <a:gd name="connsiteX2" fmla="*/ 1002221 w 1433838"/>
              <a:gd name="connsiteY2" fmla="*/ 117989 h 1729380"/>
              <a:gd name="connsiteX3" fmla="*/ 1020364 w 1433838"/>
              <a:gd name="connsiteY3" fmla="*/ 1109151 h 1729380"/>
              <a:gd name="connsiteX4" fmla="*/ 1433838 w 1433838"/>
              <a:gd name="connsiteY4" fmla="*/ 1323842 h 1729380"/>
              <a:gd name="connsiteX5" fmla="*/ 1417935 w 1433838"/>
              <a:gd name="connsiteY5" fmla="*/ 1633958 h 1729380"/>
              <a:gd name="connsiteX6" fmla="*/ 1322513 w 1433838"/>
              <a:gd name="connsiteY6" fmla="*/ 1729380 h 1729380"/>
              <a:gd name="connsiteX7" fmla="*/ 95422 w 1433838"/>
              <a:gd name="connsiteY7" fmla="*/ 1729380 h 1729380"/>
              <a:gd name="connsiteX8" fmla="*/ 0 w 1433838"/>
              <a:gd name="connsiteY8" fmla="*/ 1633958 h 1729380"/>
              <a:gd name="connsiteX9" fmla="*/ 40115 w 1433838"/>
              <a:gd name="connsiteY9" fmla="*/ 1310684 h 1729380"/>
              <a:gd name="connsiteX10" fmla="*/ 413468 w 1433838"/>
              <a:gd name="connsiteY10" fmla="*/ 1133010 h 1729380"/>
              <a:gd name="connsiteX0" fmla="*/ 428408 w 1433838"/>
              <a:gd name="connsiteY0" fmla="*/ 1125059 h 1729380"/>
              <a:gd name="connsiteX1" fmla="*/ 437328 w 1433838"/>
              <a:gd name="connsiteY1" fmla="*/ 115239 h 1729380"/>
              <a:gd name="connsiteX2" fmla="*/ 1002221 w 1433838"/>
              <a:gd name="connsiteY2" fmla="*/ 117989 h 1729380"/>
              <a:gd name="connsiteX3" fmla="*/ 1020364 w 1433838"/>
              <a:gd name="connsiteY3" fmla="*/ 1109151 h 1729380"/>
              <a:gd name="connsiteX4" fmla="*/ 1433838 w 1433838"/>
              <a:gd name="connsiteY4" fmla="*/ 1323842 h 1729380"/>
              <a:gd name="connsiteX5" fmla="*/ 1417935 w 1433838"/>
              <a:gd name="connsiteY5" fmla="*/ 1633958 h 1729380"/>
              <a:gd name="connsiteX6" fmla="*/ 1322513 w 1433838"/>
              <a:gd name="connsiteY6" fmla="*/ 1729380 h 1729380"/>
              <a:gd name="connsiteX7" fmla="*/ 95422 w 1433838"/>
              <a:gd name="connsiteY7" fmla="*/ 1729380 h 1729380"/>
              <a:gd name="connsiteX8" fmla="*/ 0 w 1433838"/>
              <a:gd name="connsiteY8" fmla="*/ 1633958 h 1729380"/>
              <a:gd name="connsiteX9" fmla="*/ 40115 w 1433838"/>
              <a:gd name="connsiteY9" fmla="*/ 1310684 h 1729380"/>
              <a:gd name="connsiteX10" fmla="*/ 428408 w 1433838"/>
              <a:gd name="connsiteY10" fmla="*/ 1125059 h 1729380"/>
              <a:gd name="connsiteX0" fmla="*/ 443347 w 1433838"/>
              <a:gd name="connsiteY0" fmla="*/ 1125059 h 1729380"/>
              <a:gd name="connsiteX1" fmla="*/ 437328 w 1433838"/>
              <a:gd name="connsiteY1" fmla="*/ 115239 h 1729380"/>
              <a:gd name="connsiteX2" fmla="*/ 1002221 w 1433838"/>
              <a:gd name="connsiteY2" fmla="*/ 117989 h 1729380"/>
              <a:gd name="connsiteX3" fmla="*/ 1020364 w 1433838"/>
              <a:gd name="connsiteY3" fmla="*/ 1109151 h 1729380"/>
              <a:gd name="connsiteX4" fmla="*/ 1433838 w 1433838"/>
              <a:gd name="connsiteY4" fmla="*/ 1323842 h 1729380"/>
              <a:gd name="connsiteX5" fmla="*/ 1417935 w 1433838"/>
              <a:gd name="connsiteY5" fmla="*/ 1633958 h 1729380"/>
              <a:gd name="connsiteX6" fmla="*/ 1322513 w 1433838"/>
              <a:gd name="connsiteY6" fmla="*/ 1729380 h 1729380"/>
              <a:gd name="connsiteX7" fmla="*/ 95422 w 1433838"/>
              <a:gd name="connsiteY7" fmla="*/ 1729380 h 1729380"/>
              <a:gd name="connsiteX8" fmla="*/ 0 w 1433838"/>
              <a:gd name="connsiteY8" fmla="*/ 1633958 h 1729380"/>
              <a:gd name="connsiteX9" fmla="*/ 40115 w 1433838"/>
              <a:gd name="connsiteY9" fmla="*/ 1310684 h 1729380"/>
              <a:gd name="connsiteX10" fmla="*/ 443347 w 1433838"/>
              <a:gd name="connsiteY10" fmla="*/ 1125059 h 1729380"/>
              <a:gd name="connsiteX0" fmla="*/ 443347 w 1433838"/>
              <a:gd name="connsiteY0" fmla="*/ 1125059 h 1729380"/>
              <a:gd name="connsiteX1" fmla="*/ 437328 w 1433838"/>
              <a:gd name="connsiteY1" fmla="*/ 115239 h 1729380"/>
              <a:gd name="connsiteX2" fmla="*/ 1002221 w 1433838"/>
              <a:gd name="connsiteY2" fmla="*/ 117989 h 1729380"/>
              <a:gd name="connsiteX3" fmla="*/ 1020364 w 1433838"/>
              <a:gd name="connsiteY3" fmla="*/ 1109151 h 1729380"/>
              <a:gd name="connsiteX4" fmla="*/ 1433838 w 1433838"/>
              <a:gd name="connsiteY4" fmla="*/ 1323842 h 1729380"/>
              <a:gd name="connsiteX5" fmla="*/ 1417935 w 1433838"/>
              <a:gd name="connsiteY5" fmla="*/ 1633958 h 1729380"/>
              <a:gd name="connsiteX6" fmla="*/ 1322513 w 1433838"/>
              <a:gd name="connsiteY6" fmla="*/ 1729380 h 1729380"/>
              <a:gd name="connsiteX7" fmla="*/ 95422 w 1433838"/>
              <a:gd name="connsiteY7" fmla="*/ 1729380 h 1729380"/>
              <a:gd name="connsiteX8" fmla="*/ 0 w 1433838"/>
              <a:gd name="connsiteY8" fmla="*/ 1633958 h 1729380"/>
              <a:gd name="connsiteX9" fmla="*/ 40115 w 1433838"/>
              <a:gd name="connsiteY9" fmla="*/ 1310684 h 1729380"/>
              <a:gd name="connsiteX10" fmla="*/ 443347 w 1433838"/>
              <a:gd name="connsiteY10" fmla="*/ 1125059 h 1729380"/>
              <a:gd name="connsiteX0" fmla="*/ 443347 w 1433838"/>
              <a:gd name="connsiteY0" fmla="*/ 1125059 h 1729380"/>
              <a:gd name="connsiteX1" fmla="*/ 437328 w 1433838"/>
              <a:gd name="connsiteY1" fmla="*/ 115239 h 1729380"/>
              <a:gd name="connsiteX2" fmla="*/ 1002221 w 1433838"/>
              <a:gd name="connsiteY2" fmla="*/ 117989 h 1729380"/>
              <a:gd name="connsiteX3" fmla="*/ 1020364 w 1433838"/>
              <a:gd name="connsiteY3" fmla="*/ 1109151 h 1729380"/>
              <a:gd name="connsiteX4" fmla="*/ 1433838 w 1433838"/>
              <a:gd name="connsiteY4" fmla="*/ 1323842 h 1729380"/>
              <a:gd name="connsiteX5" fmla="*/ 1417935 w 1433838"/>
              <a:gd name="connsiteY5" fmla="*/ 1633958 h 1729380"/>
              <a:gd name="connsiteX6" fmla="*/ 1322513 w 1433838"/>
              <a:gd name="connsiteY6" fmla="*/ 1729380 h 1729380"/>
              <a:gd name="connsiteX7" fmla="*/ 95422 w 1433838"/>
              <a:gd name="connsiteY7" fmla="*/ 1729380 h 1729380"/>
              <a:gd name="connsiteX8" fmla="*/ 0 w 1433838"/>
              <a:gd name="connsiteY8" fmla="*/ 1633958 h 1729380"/>
              <a:gd name="connsiteX9" fmla="*/ 40115 w 1433838"/>
              <a:gd name="connsiteY9" fmla="*/ 1310684 h 1729380"/>
              <a:gd name="connsiteX10" fmla="*/ 443347 w 1433838"/>
              <a:gd name="connsiteY10" fmla="*/ 1125059 h 1729380"/>
              <a:gd name="connsiteX0" fmla="*/ 443347 w 1433838"/>
              <a:gd name="connsiteY0" fmla="*/ 1125059 h 1729380"/>
              <a:gd name="connsiteX1" fmla="*/ 437328 w 1433838"/>
              <a:gd name="connsiteY1" fmla="*/ 115239 h 1729380"/>
              <a:gd name="connsiteX2" fmla="*/ 1002221 w 1433838"/>
              <a:gd name="connsiteY2" fmla="*/ 117989 h 1729380"/>
              <a:gd name="connsiteX3" fmla="*/ 1020364 w 1433838"/>
              <a:gd name="connsiteY3" fmla="*/ 1109151 h 1729380"/>
              <a:gd name="connsiteX4" fmla="*/ 1433838 w 1433838"/>
              <a:gd name="connsiteY4" fmla="*/ 1323842 h 1729380"/>
              <a:gd name="connsiteX5" fmla="*/ 1417935 w 1433838"/>
              <a:gd name="connsiteY5" fmla="*/ 1633958 h 1729380"/>
              <a:gd name="connsiteX6" fmla="*/ 1322513 w 1433838"/>
              <a:gd name="connsiteY6" fmla="*/ 1729380 h 1729380"/>
              <a:gd name="connsiteX7" fmla="*/ 95422 w 1433838"/>
              <a:gd name="connsiteY7" fmla="*/ 1729380 h 1729380"/>
              <a:gd name="connsiteX8" fmla="*/ 0 w 1433838"/>
              <a:gd name="connsiteY8" fmla="*/ 1633958 h 1729380"/>
              <a:gd name="connsiteX9" fmla="*/ 40115 w 1433838"/>
              <a:gd name="connsiteY9" fmla="*/ 1310684 h 1729380"/>
              <a:gd name="connsiteX10" fmla="*/ 443347 w 1433838"/>
              <a:gd name="connsiteY10" fmla="*/ 1125059 h 1729380"/>
              <a:gd name="connsiteX0" fmla="*/ 429031 w 1433838"/>
              <a:gd name="connsiteY0" fmla="*/ 1125059 h 1729380"/>
              <a:gd name="connsiteX1" fmla="*/ 437328 w 1433838"/>
              <a:gd name="connsiteY1" fmla="*/ 115239 h 1729380"/>
              <a:gd name="connsiteX2" fmla="*/ 1002221 w 1433838"/>
              <a:gd name="connsiteY2" fmla="*/ 117989 h 1729380"/>
              <a:gd name="connsiteX3" fmla="*/ 1020364 w 1433838"/>
              <a:gd name="connsiteY3" fmla="*/ 1109151 h 1729380"/>
              <a:gd name="connsiteX4" fmla="*/ 1433838 w 1433838"/>
              <a:gd name="connsiteY4" fmla="*/ 1323842 h 1729380"/>
              <a:gd name="connsiteX5" fmla="*/ 1417935 w 1433838"/>
              <a:gd name="connsiteY5" fmla="*/ 1633958 h 1729380"/>
              <a:gd name="connsiteX6" fmla="*/ 1322513 w 1433838"/>
              <a:gd name="connsiteY6" fmla="*/ 1729380 h 1729380"/>
              <a:gd name="connsiteX7" fmla="*/ 95422 w 1433838"/>
              <a:gd name="connsiteY7" fmla="*/ 1729380 h 1729380"/>
              <a:gd name="connsiteX8" fmla="*/ 0 w 1433838"/>
              <a:gd name="connsiteY8" fmla="*/ 1633958 h 1729380"/>
              <a:gd name="connsiteX9" fmla="*/ 40115 w 1433838"/>
              <a:gd name="connsiteY9" fmla="*/ 1310684 h 1729380"/>
              <a:gd name="connsiteX10" fmla="*/ 429031 w 1433838"/>
              <a:gd name="connsiteY10" fmla="*/ 1125059 h 1729380"/>
              <a:gd name="connsiteX0" fmla="*/ 429031 w 1433838"/>
              <a:gd name="connsiteY0" fmla="*/ 1125059 h 1729380"/>
              <a:gd name="connsiteX1" fmla="*/ 437328 w 1433838"/>
              <a:gd name="connsiteY1" fmla="*/ 115239 h 1729380"/>
              <a:gd name="connsiteX2" fmla="*/ 1002221 w 1433838"/>
              <a:gd name="connsiteY2" fmla="*/ 117989 h 1729380"/>
              <a:gd name="connsiteX3" fmla="*/ 1020364 w 1433838"/>
              <a:gd name="connsiteY3" fmla="*/ 1109151 h 1729380"/>
              <a:gd name="connsiteX4" fmla="*/ 1433838 w 1433838"/>
              <a:gd name="connsiteY4" fmla="*/ 1323842 h 1729380"/>
              <a:gd name="connsiteX5" fmla="*/ 1417935 w 1433838"/>
              <a:gd name="connsiteY5" fmla="*/ 1633958 h 1729380"/>
              <a:gd name="connsiteX6" fmla="*/ 1322513 w 1433838"/>
              <a:gd name="connsiteY6" fmla="*/ 1729380 h 1729380"/>
              <a:gd name="connsiteX7" fmla="*/ 95422 w 1433838"/>
              <a:gd name="connsiteY7" fmla="*/ 1729380 h 1729380"/>
              <a:gd name="connsiteX8" fmla="*/ 0 w 1433838"/>
              <a:gd name="connsiteY8" fmla="*/ 1633958 h 1729380"/>
              <a:gd name="connsiteX9" fmla="*/ 40115 w 1433838"/>
              <a:gd name="connsiteY9" fmla="*/ 1310684 h 1729380"/>
              <a:gd name="connsiteX10" fmla="*/ 429031 w 1433838"/>
              <a:gd name="connsiteY10" fmla="*/ 1125059 h 1729380"/>
              <a:gd name="connsiteX0" fmla="*/ 429031 w 1433838"/>
              <a:gd name="connsiteY0" fmla="*/ 1125059 h 1729380"/>
              <a:gd name="connsiteX1" fmla="*/ 437328 w 1433838"/>
              <a:gd name="connsiteY1" fmla="*/ 115239 h 1729380"/>
              <a:gd name="connsiteX2" fmla="*/ 1002221 w 1433838"/>
              <a:gd name="connsiteY2" fmla="*/ 117989 h 1729380"/>
              <a:gd name="connsiteX3" fmla="*/ 1020364 w 1433838"/>
              <a:gd name="connsiteY3" fmla="*/ 1109151 h 1729380"/>
              <a:gd name="connsiteX4" fmla="*/ 1433838 w 1433838"/>
              <a:gd name="connsiteY4" fmla="*/ 1323842 h 1729380"/>
              <a:gd name="connsiteX5" fmla="*/ 1417935 w 1433838"/>
              <a:gd name="connsiteY5" fmla="*/ 1633958 h 1729380"/>
              <a:gd name="connsiteX6" fmla="*/ 1322513 w 1433838"/>
              <a:gd name="connsiteY6" fmla="*/ 1729380 h 1729380"/>
              <a:gd name="connsiteX7" fmla="*/ 95422 w 1433838"/>
              <a:gd name="connsiteY7" fmla="*/ 1729380 h 1729380"/>
              <a:gd name="connsiteX8" fmla="*/ 0 w 1433838"/>
              <a:gd name="connsiteY8" fmla="*/ 1633958 h 1729380"/>
              <a:gd name="connsiteX9" fmla="*/ 40115 w 1433838"/>
              <a:gd name="connsiteY9" fmla="*/ 1310684 h 1729380"/>
              <a:gd name="connsiteX10" fmla="*/ 429031 w 1433838"/>
              <a:gd name="connsiteY10" fmla="*/ 1125059 h 1729380"/>
              <a:gd name="connsiteX0" fmla="*/ 429031 w 1433838"/>
              <a:gd name="connsiteY0" fmla="*/ 1125059 h 1729380"/>
              <a:gd name="connsiteX1" fmla="*/ 437328 w 1433838"/>
              <a:gd name="connsiteY1" fmla="*/ 115239 h 1729380"/>
              <a:gd name="connsiteX2" fmla="*/ 1002221 w 1433838"/>
              <a:gd name="connsiteY2" fmla="*/ 117989 h 1729380"/>
              <a:gd name="connsiteX3" fmla="*/ 1020364 w 1433838"/>
              <a:gd name="connsiteY3" fmla="*/ 1109151 h 1729380"/>
              <a:gd name="connsiteX4" fmla="*/ 1433838 w 1433838"/>
              <a:gd name="connsiteY4" fmla="*/ 1323842 h 1729380"/>
              <a:gd name="connsiteX5" fmla="*/ 1417935 w 1433838"/>
              <a:gd name="connsiteY5" fmla="*/ 1633958 h 1729380"/>
              <a:gd name="connsiteX6" fmla="*/ 1322513 w 1433838"/>
              <a:gd name="connsiteY6" fmla="*/ 1729380 h 1729380"/>
              <a:gd name="connsiteX7" fmla="*/ 95422 w 1433838"/>
              <a:gd name="connsiteY7" fmla="*/ 1729380 h 1729380"/>
              <a:gd name="connsiteX8" fmla="*/ 0 w 1433838"/>
              <a:gd name="connsiteY8" fmla="*/ 1633958 h 1729380"/>
              <a:gd name="connsiteX9" fmla="*/ 40115 w 1433838"/>
              <a:gd name="connsiteY9" fmla="*/ 1310684 h 1729380"/>
              <a:gd name="connsiteX10" fmla="*/ 429031 w 1433838"/>
              <a:gd name="connsiteY10" fmla="*/ 1125059 h 1729380"/>
              <a:gd name="connsiteX0" fmla="*/ 429031 w 1433838"/>
              <a:gd name="connsiteY0" fmla="*/ 1125059 h 1729380"/>
              <a:gd name="connsiteX1" fmla="*/ 437328 w 1433838"/>
              <a:gd name="connsiteY1" fmla="*/ 115239 h 1729380"/>
              <a:gd name="connsiteX2" fmla="*/ 1002221 w 1433838"/>
              <a:gd name="connsiteY2" fmla="*/ 117989 h 1729380"/>
              <a:gd name="connsiteX3" fmla="*/ 1020364 w 1433838"/>
              <a:gd name="connsiteY3" fmla="*/ 1109151 h 1729380"/>
              <a:gd name="connsiteX4" fmla="*/ 1433838 w 1433838"/>
              <a:gd name="connsiteY4" fmla="*/ 1323842 h 1729380"/>
              <a:gd name="connsiteX5" fmla="*/ 1417935 w 1433838"/>
              <a:gd name="connsiteY5" fmla="*/ 1633958 h 1729380"/>
              <a:gd name="connsiteX6" fmla="*/ 1322513 w 1433838"/>
              <a:gd name="connsiteY6" fmla="*/ 1729380 h 1729380"/>
              <a:gd name="connsiteX7" fmla="*/ 95422 w 1433838"/>
              <a:gd name="connsiteY7" fmla="*/ 1729380 h 1729380"/>
              <a:gd name="connsiteX8" fmla="*/ 0 w 1433838"/>
              <a:gd name="connsiteY8" fmla="*/ 1633958 h 1729380"/>
              <a:gd name="connsiteX9" fmla="*/ 40115 w 1433838"/>
              <a:gd name="connsiteY9" fmla="*/ 1310684 h 1729380"/>
              <a:gd name="connsiteX10" fmla="*/ 429031 w 1433838"/>
              <a:gd name="connsiteY10" fmla="*/ 1125059 h 1729380"/>
              <a:gd name="connsiteX0" fmla="*/ 421873 w 1433838"/>
              <a:gd name="connsiteY0" fmla="*/ 1121249 h 1729380"/>
              <a:gd name="connsiteX1" fmla="*/ 437328 w 1433838"/>
              <a:gd name="connsiteY1" fmla="*/ 115239 h 1729380"/>
              <a:gd name="connsiteX2" fmla="*/ 1002221 w 1433838"/>
              <a:gd name="connsiteY2" fmla="*/ 117989 h 1729380"/>
              <a:gd name="connsiteX3" fmla="*/ 1020364 w 1433838"/>
              <a:gd name="connsiteY3" fmla="*/ 1109151 h 1729380"/>
              <a:gd name="connsiteX4" fmla="*/ 1433838 w 1433838"/>
              <a:gd name="connsiteY4" fmla="*/ 1323842 h 1729380"/>
              <a:gd name="connsiteX5" fmla="*/ 1417935 w 1433838"/>
              <a:gd name="connsiteY5" fmla="*/ 1633958 h 1729380"/>
              <a:gd name="connsiteX6" fmla="*/ 1322513 w 1433838"/>
              <a:gd name="connsiteY6" fmla="*/ 1729380 h 1729380"/>
              <a:gd name="connsiteX7" fmla="*/ 95422 w 1433838"/>
              <a:gd name="connsiteY7" fmla="*/ 1729380 h 1729380"/>
              <a:gd name="connsiteX8" fmla="*/ 0 w 1433838"/>
              <a:gd name="connsiteY8" fmla="*/ 1633958 h 1729380"/>
              <a:gd name="connsiteX9" fmla="*/ 40115 w 1433838"/>
              <a:gd name="connsiteY9" fmla="*/ 1310684 h 1729380"/>
              <a:gd name="connsiteX10" fmla="*/ 421873 w 1433838"/>
              <a:gd name="connsiteY10" fmla="*/ 1121249 h 1729380"/>
              <a:gd name="connsiteX0" fmla="*/ 421873 w 1433838"/>
              <a:gd name="connsiteY0" fmla="*/ 1121249 h 1729380"/>
              <a:gd name="connsiteX1" fmla="*/ 437328 w 1433838"/>
              <a:gd name="connsiteY1" fmla="*/ 115239 h 1729380"/>
              <a:gd name="connsiteX2" fmla="*/ 1002221 w 1433838"/>
              <a:gd name="connsiteY2" fmla="*/ 117989 h 1729380"/>
              <a:gd name="connsiteX3" fmla="*/ 1020364 w 1433838"/>
              <a:gd name="connsiteY3" fmla="*/ 1109151 h 1729380"/>
              <a:gd name="connsiteX4" fmla="*/ 1433838 w 1433838"/>
              <a:gd name="connsiteY4" fmla="*/ 1323842 h 1729380"/>
              <a:gd name="connsiteX5" fmla="*/ 1417935 w 1433838"/>
              <a:gd name="connsiteY5" fmla="*/ 1633958 h 1729380"/>
              <a:gd name="connsiteX6" fmla="*/ 1322513 w 1433838"/>
              <a:gd name="connsiteY6" fmla="*/ 1729380 h 1729380"/>
              <a:gd name="connsiteX7" fmla="*/ 95422 w 1433838"/>
              <a:gd name="connsiteY7" fmla="*/ 1729380 h 1729380"/>
              <a:gd name="connsiteX8" fmla="*/ 0 w 1433838"/>
              <a:gd name="connsiteY8" fmla="*/ 1633958 h 1729380"/>
              <a:gd name="connsiteX9" fmla="*/ 40115 w 1433838"/>
              <a:gd name="connsiteY9" fmla="*/ 1310684 h 1729380"/>
              <a:gd name="connsiteX10" fmla="*/ 421873 w 1433838"/>
              <a:gd name="connsiteY10" fmla="*/ 1121249 h 1729380"/>
              <a:gd name="connsiteX0" fmla="*/ 421873 w 1433838"/>
              <a:gd name="connsiteY0" fmla="*/ 1121249 h 1729380"/>
              <a:gd name="connsiteX1" fmla="*/ 437328 w 1433838"/>
              <a:gd name="connsiteY1" fmla="*/ 115239 h 1729380"/>
              <a:gd name="connsiteX2" fmla="*/ 1002221 w 1433838"/>
              <a:gd name="connsiteY2" fmla="*/ 117989 h 1729380"/>
              <a:gd name="connsiteX3" fmla="*/ 1020364 w 1433838"/>
              <a:gd name="connsiteY3" fmla="*/ 1109151 h 1729380"/>
              <a:gd name="connsiteX4" fmla="*/ 1433838 w 1433838"/>
              <a:gd name="connsiteY4" fmla="*/ 1323842 h 1729380"/>
              <a:gd name="connsiteX5" fmla="*/ 1417935 w 1433838"/>
              <a:gd name="connsiteY5" fmla="*/ 1633958 h 1729380"/>
              <a:gd name="connsiteX6" fmla="*/ 1322513 w 1433838"/>
              <a:gd name="connsiteY6" fmla="*/ 1729380 h 1729380"/>
              <a:gd name="connsiteX7" fmla="*/ 95422 w 1433838"/>
              <a:gd name="connsiteY7" fmla="*/ 1729380 h 1729380"/>
              <a:gd name="connsiteX8" fmla="*/ 0 w 1433838"/>
              <a:gd name="connsiteY8" fmla="*/ 1633958 h 1729380"/>
              <a:gd name="connsiteX9" fmla="*/ 40115 w 1433838"/>
              <a:gd name="connsiteY9" fmla="*/ 1310684 h 1729380"/>
              <a:gd name="connsiteX10" fmla="*/ 421873 w 1433838"/>
              <a:gd name="connsiteY10" fmla="*/ 1121249 h 1729380"/>
              <a:gd name="connsiteX0" fmla="*/ 421873 w 1433838"/>
              <a:gd name="connsiteY0" fmla="*/ 1121249 h 1729380"/>
              <a:gd name="connsiteX1" fmla="*/ 437328 w 1433838"/>
              <a:gd name="connsiteY1" fmla="*/ 115239 h 1729380"/>
              <a:gd name="connsiteX2" fmla="*/ 1002221 w 1433838"/>
              <a:gd name="connsiteY2" fmla="*/ 117989 h 1729380"/>
              <a:gd name="connsiteX3" fmla="*/ 1020364 w 1433838"/>
              <a:gd name="connsiteY3" fmla="*/ 1109151 h 1729380"/>
              <a:gd name="connsiteX4" fmla="*/ 1433838 w 1433838"/>
              <a:gd name="connsiteY4" fmla="*/ 1323842 h 1729380"/>
              <a:gd name="connsiteX5" fmla="*/ 1417935 w 1433838"/>
              <a:gd name="connsiteY5" fmla="*/ 1633958 h 1729380"/>
              <a:gd name="connsiteX6" fmla="*/ 1322513 w 1433838"/>
              <a:gd name="connsiteY6" fmla="*/ 1729380 h 1729380"/>
              <a:gd name="connsiteX7" fmla="*/ 95422 w 1433838"/>
              <a:gd name="connsiteY7" fmla="*/ 1729380 h 1729380"/>
              <a:gd name="connsiteX8" fmla="*/ 0 w 1433838"/>
              <a:gd name="connsiteY8" fmla="*/ 1633958 h 1729380"/>
              <a:gd name="connsiteX9" fmla="*/ 40115 w 1433838"/>
              <a:gd name="connsiteY9" fmla="*/ 1310684 h 1729380"/>
              <a:gd name="connsiteX10" fmla="*/ 421873 w 1433838"/>
              <a:gd name="connsiteY10" fmla="*/ 1121249 h 1729380"/>
              <a:gd name="connsiteX0" fmla="*/ 421873 w 1433838"/>
              <a:gd name="connsiteY0" fmla="*/ 1121249 h 1729380"/>
              <a:gd name="connsiteX1" fmla="*/ 437328 w 1433838"/>
              <a:gd name="connsiteY1" fmla="*/ 115239 h 1729380"/>
              <a:gd name="connsiteX2" fmla="*/ 1002221 w 1433838"/>
              <a:gd name="connsiteY2" fmla="*/ 117989 h 1729380"/>
              <a:gd name="connsiteX3" fmla="*/ 1020364 w 1433838"/>
              <a:gd name="connsiteY3" fmla="*/ 1109151 h 1729380"/>
              <a:gd name="connsiteX4" fmla="*/ 1433838 w 1433838"/>
              <a:gd name="connsiteY4" fmla="*/ 1323842 h 1729380"/>
              <a:gd name="connsiteX5" fmla="*/ 1417935 w 1433838"/>
              <a:gd name="connsiteY5" fmla="*/ 1633958 h 1729380"/>
              <a:gd name="connsiteX6" fmla="*/ 1322513 w 1433838"/>
              <a:gd name="connsiteY6" fmla="*/ 1729380 h 1729380"/>
              <a:gd name="connsiteX7" fmla="*/ 95422 w 1433838"/>
              <a:gd name="connsiteY7" fmla="*/ 1729380 h 1729380"/>
              <a:gd name="connsiteX8" fmla="*/ 0 w 1433838"/>
              <a:gd name="connsiteY8" fmla="*/ 1633958 h 1729380"/>
              <a:gd name="connsiteX9" fmla="*/ 40115 w 1433838"/>
              <a:gd name="connsiteY9" fmla="*/ 1310684 h 1729380"/>
              <a:gd name="connsiteX10" fmla="*/ 421873 w 1433838"/>
              <a:gd name="connsiteY10" fmla="*/ 1121249 h 1729380"/>
              <a:gd name="connsiteX0" fmla="*/ 421873 w 1441941"/>
              <a:gd name="connsiteY0" fmla="*/ 1121249 h 1729380"/>
              <a:gd name="connsiteX1" fmla="*/ 437328 w 1441941"/>
              <a:gd name="connsiteY1" fmla="*/ 115239 h 1729380"/>
              <a:gd name="connsiteX2" fmla="*/ 1002221 w 1441941"/>
              <a:gd name="connsiteY2" fmla="*/ 117989 h 1729380"/>
              <a:gd name="connsiteX3" fmla="*/ 1020364 w 1441941"/>
              <a:gd name="connsiteY3" fmla="*/ 1109151 h 1729380"/>
              <a:gd name="connsiteX4" fmla="*/ 1433838 w 1441941"/>
              <a:gd name="connsiteY4" fmla="*/ 1323842 h 1729380"/>
              <a:gd name="connsiteX5" fmla="*/ 1417935 w 1441941"/>
              <a:gd name="connsiteY5" fmla="*/ 1633958 h 1729380"/>
              <a:gd name="connsiteX6" fmla="*/ 1322513 w 1441941"/>
              <a:gd name="connsiteY6" fmla="*/ 1729380 h 1729380"/>
              <a:gd name="connsiteX7" fmla="*/ 95422 w 1441941"/>
              <a:gd name="connsiteY7" fmla="*/ 1729380 h 1729380"/>
              <a:gd name="connsiteX8" fmla="*/ 0 w 1441941"/>
              <a:gd name="connsiteY8" fmla="*/ 1633958 h 1729380"/>
              <a:gd name="connsiteX9" fmla="*/ 40115 w 1441941"/>
              <a:gd name="connsiteY9" fmla="*/ 1310684 h 1729380"/>
              <a:gd name="connsiteX10" fmla="*/ 421873 w 1441941"/>
              <a:gd name="connsiteY10" fmla="*/ 1121249 h 1729380"/>
              <a:gd name="connsiteX0" fmla="*/ 421873 w 1447506"/>
              <a:gd name="connsiteY0" fmla="*/ 1121249 h 1729380"/>
              <a:gd name="connsiteX1" fmla="*/ 437328 w 1447506"/>
              <a:gd name="connsiteY1" fmla="*/ 115239 h 1729380"/>
              <a:gd name="connsiteX2" fmla="*/ 1002221 w 1447506"/>
              <a:gd name="connsiteY2" fmla="*/ 117989 h 1729380"/>
              <a:gd name="connsiteX3" fmla="*/ 1020364 w 1447506"/>
              <a:gd name="connsiteY3" fmla="*/ 1109151 h 1729380"/>
              <a:gd name="connsiteX4" fmla="*/ 1433838 w 1447506"/>
              <a:gd name="connsiteY4" fmla="*/ 1323842 h 1729380"/>
              <a:gd name="connsiteX5" fmla="*/ 1439408 w 1447506"/>
              <a:gd name="connsiteY5" fmla="*/ 1637768 h 1729380"/>
              <a:gd name="connsiteX6" fmla="*/ 1322513 w 1447506"/>
              <a:gd name="connsiteY6" fmla="*/ 1729380 h 1729380"/>
              <a:gd name="connsiteX7" fmla="*/ 95422 w 1447506"/>
              <a:gd name="connsiteY7" fmla="*/ 1729380 h 1729380"/>
              <a:gd name="connsiteX8" fmla="*/ 0 w 1447506"/>
              <a:gd name="connsiteY8" fmla="*/ 1633958 h 1729380"/>
              <a:gd name="connsiteX9" fmla="*/ 40115 w 1447506"/>
              <a:gd name="connsiteY9" fmla="*/ 1310684 h 1729380"/>
              <a:gd name="connsiteX10" fmla="*/ 421873 w 1447506"/>
              <a:gd name="connsiteY10" fmla="*/ 1121249 h 1729380"/>
              <a:gd name="connsiteX0" fmla="*/ 421873 w 1447506"/>
              <a:gd name="connsiteY0" fmla="*/ 1121249 h 1729380"/>
              <a:gd name="connsiteX1" fmla="*/ 437328 w 1447506"/>
              <a:gd name="connsiteY1" fmla="*/ 115239 h 1729380"/>
              <a:gd name="connsiteX2" fmla="*/ 1002221 w 1447506"/>
              <a:gd name="connsiteY2" fmla="*/ 117989 h 1729380"/>
              <a:gd name="connsiteX3" fmla="*/ 1020364 w 1447506"/>
              <a:gd name="connsiteY3" fmla="*/ 1109151 h 1729380"/>
              <a:gd name="connsiteX4" fmla="*/ 1433838 w 1447506"/>
              <a:gd name="connsiteY4" fmla="*/ 1323842 h 1729380"/>
              <a:gd name="connsiteX5" fmla="*/ 1439408 w 1447506"/>
              <a:gd name="connsiteY5" fmla="*/ 1637768 h 1729380"/>
              <a:gd name="connsiteX6" fmla="*/ 1322513 w 1447506"/>
              <a:gd name="connsiteY6" fmla="*/ 1729380 h 1729380"/>
              <a:gd name="connsiteX7" fmla="*/ 95422 w 1447506"/>
              <a:gd name="connsiteY7" fmla="*/ 1729380 h 1729380"/>
              <a:gd name="connsiteX8" fmla="*/ 0 w 1447506"/>
              <a:gd name="connsiteY8" fmla="*/ 1633958 h 1729380"/>
              <a:gd name="connsiteX9" fmla="*/ 40115 w 1447506"/>
              <a:gd name="connsiteY9" fmla="*/ 1310684 h 1729380"/>
              <a:gd name="connsiteX10" fmla="*/ 421873 w 1447506"/>
              <a:gd name="connsiteY10" fmla="*/ 1121249 h 1729380"/>
              <a:gd name="connsiteX0" fmla="*/ 430557 w 1456190"/>
              <a:gd name="connsiteY0" fmla="*/ 1121249 h 1729380"/>
              <a:gd name="connsiteX1" fmla="*/ 446012 w 1456190"/>
              <a:gd name="connsiteY1" fmla="*/ 115239 h 1729380"/>
              <a:gd name="connsiteX2" fmla="*/ 1010905 w 1456190"/>
              <a:gd name="connsiteY2" fmla="*/ 117989 h 1729380"/>
              <a:gd name="connsiteX3" fmla="*/ 1029048 w 1456190"/>
              <a:gd name="connsiteY3" fmla="*/ 1109151 h 1729380"/>
              <a:gd name="connsiteX4" fmla="*/ 1442522 w 1456190"/>
              <a:gd name="connsiteY4" fmla="*/ 1323842 h 1729380"/>
              <a:gd name="connsiteX5" fmla="*/ 1448092 w 1456190"/>
              <a:gd name="connsiteY5" fmla="*/ 1637768 h 1729380"/>
              <a:gd name="connsiteX6" fmla="*/ 1331197 w 1456190"/>
              <a:gd name="connsiteY6" fmla="*/ 1729380 h 1729380"/>
              <a:gd name="connsiteX7" fmla="*/ 104106 w 1456190"/>
              <a:gd name="connsiteY7" fmla="*/ 1729380 h 1729380"/>
              <a:gd name="connsiteX8" fmla="*/ 8684 w 1456190"/>
              <a:gd name="connsiteY8" fmla="*/ 1633958 h 1729380"/>
              <a:gd name="connsiteX9" fmla="*/ 34483 w 1456190"/>
              <a:gd name="connsiteY9" fmla="*/ 1325924 h 1729380"/>
              <a:gd name="connsiteX10" fmla="*/ 430557 w 1456190"/>
              <a:gd name="connsiteY10" fmla="*/ 1121249 h 1729380"/>
              <a:gd name="connsiteX0" fmla="*/ 421873 w 1447506"/>
              <a:gd name="connsiteY0" fmla="*/ 1121249 h 1729380"/>
              <a:gd name="connsiteX1" fmla="*/ 437328 w 1447506"/>
              <a:gd name="connsiteY1" fmla="*/ 115239 h 1729380"/>
              <a:gd name="connsiteX2" fmla="*/ 1002221 w 1447506"/>
              <a:gd name="connsiteY2" fmla="*/ 117989 h 1729380"/>
              <a:gd name="connsiteX3" fmla="*/ 1020364 w 1447506"/>
              <a:gd name="connsiteY3" fmla="*/ 1109151 h 1729380"/>
              <a:gd name="connsiteX4" fmla="*/ 1433838 w 1447506"/>
              <a:gd name="connsiteY4" fmla="*/ 1323842 h 1729380"/>
              <a:gd name="connsiteX5" fmla="*/ 1439408 w 1447506"/>
              <a:gd name="connsiteY5" fmla="*/ 1637768 h 1729380"/>
              <a:gd name="connsiteX6" fmla="*/ 1322513 w 1447506"/>
              <a:gd name="connsiteY6" fmla="*/ 1729380 h 1729380"/>
              <a:gd name="connsiteX7" fmla="*/ 95422 w 1447506"/>
              <a:gd name="connsiteY7" fmla="*/ 1729380 h 1729380"/>
              <a:gd name="connsiteX8" fmla="*/ 0 w 1447506"/>
              <a:gd name="connsiteY8" fmla="*/ 1633958 h 1729380"/>
              <a:gd name="connsiteX9" fmla="*/ 25799 w 1447506"/>
              <a:gd name="connsiteY9" fmla="*/ 1325924 h 1729380"/>
              <a:gd name="connsiteX10" fmla="*/ 421873 w 1447506"/>
              <a:gd name="connsiteY10" fmla="*/ 1121249 h 1729380"/>
              <a:gd name="connsiteX0" fmla="*/ 427436 w 1453069"/>
              <a:gd name="connsiteY0" fmla="*/ 1121249 h 1729380"/>
              <a:gd name="connsiteX1" fmla="*/ 442891 w 1453069"/>
              <a:gd name="connsiteY1" fmla="*/ 115239 h 1729380"/>
              <a:gd name="connsiteX2" fmla="*/ 1007784 w 1453069"/>
              <a:gd name="connsiteY2" fmla="*/ 117989 h 1729380"/>
              <a:gd name="connsiteX3" fmla="*/ 1025927 w 1453069"/>
              <a:gd name="connsiteY3" fmla="*/ 1109151 h 1729380"/>
              <a:gd name="connsiteX4" fmla="*/ 1439401 w 1453069"/>
              <a:gd name="connsiteY4" fmla="*/ 1323842 h 1729380"/>
              <a:gd name="connsiteX5" fmla="*/ 1444971 w 1453069"/>
              <a:gd name="connsiteY5" fmla="*/ 1637768 h 1729380"/>
              <a:gd name="connsiteX6" fmla="*/ 1328076 w 1453069"/>
              <a:gd name="connsiteY6" fmla="*/ 1729380 h 1729380"/>
              <a:gd name="connsiteX7" fmla="*/ 100985 w 1453069"/>
              <a:gd name="connsiteY7" fmla="*/ 1729380 h 1729380"/>
              <a:gd name="connsiteX8" fmla="*/ 5563 w 1453069"/>
              <a:gd name="connsiteY8" fmla="*/ 1633958 h 1729380"/>
              <a:gd name="connsiteX9" fmla="*/ 31362 w 1453069"/>
              <a:gd name="connsiteY9" fmla="*/ 1325924 h 1729380"/>
              <a:gd name="connsiteX10" fmla="*/ 427436 w 1453069"/>
              <a:gd name="connsiteY10" fmla="*/ 1121249 h 1729380"/>
              <a:gd name="connsiteX0" fmla="*/ 430557 w 1456190"/>
              <a:gd name="connsiteY0" fmla="*/ 1121249 h 1729380"/>
              <a:gd name="connsiteX1" fmla="*/ 446012 w 1456190"/>
              <a:gd name="connsiteY1" fmla="*/ 115239 h 1729380"/>
              <a:gd name="connsiteX2" fmla="*/ 1010905 w 1456190"/>
              <a:gd name="connsiteY2" fmla="*/ 117989 h 1729380"/>
              <a:gd name="connsiteX3" fmla="*/ 1029048 w 1456190"/>
              <a:gd name="connsiteY3" fmla="*/ 1109151 h 1729380"/>
              <a:gd name="connsiteX4" fmla="*/ 1442522 w 1456190"/>
              <a:gd name="connsiteY4" fmla="*/ 1323842 h 1729380"/>
              <a:gd name="connsiteX5" fmla="*/ 1448092 w 1456190"/>
              <a:gd name="connsiteY5" fmla="*/ 1637768 h 1729380"/>
              <a:gd name="connsiteX6" fmla="*/ 1331197 w 1456190"/>
              <a:gd name="connsiteY6" fmla="*/ 1729380 h 1729380"/>
              <a:gd name="connsiteX7" fmla="*/ 104106 w 1456190"/>
              <a:gd name="connsiteY7" fmla="*/ 1729380 h 1729380"/>
              <a:gd name="connsiteX8" fmla="*/ 8684 w 1456190"/>
              <a:gd name="connsiteY8" fmla="*/ 1633958 h 1729380"/>
              <a:gd name="connsiteX9" fmla="*/ 34483 w 1456190"/>
              <a:gd name="connsiteY9" fmla="*/ 1325924 h 1729380"/>
              <a:gd name="connsiteX10" fmla="*/ 430557 w 1456190"/>
              <a:gd name="connsiteY10" fmla="*/ 1121249 h 1729380"/>
              <a:gd name="connsiteX0" fmla="*/ 451837 w 1477470"/>
              <a:gd name="connsiteY0" fmla="*/ 1121249 h 1729380"/>
              <a:gd name="connsiteX1" fmla="*/ 467292 w 1477470"/>
              <a:gd name="connsiteY1" fmla="*/ 115239 h 1729380"/>
              <a:gd name="connsiteX2" fmla="*/ 1032185 w 1477470"/>
              <a:gd name="connsiteY2" fmla="*/ 117989 h 1729380"/>
              <a:gd name="connsiteX3" fmla="*/ 1050328 w 1477470"/>
              <a:gd name="connsiteY3" fmla="*/ 1109151 h 1729380"/>
              <a:gd name="connsiteX4" fmla="*/ 1463802 w 1477470"/>
              <a:gd name="connsiteY4" fmla="*/ 1323842 h 1729380"/>
              <a:gd name="connsiteX5" fmla="*/ 1469372 w 1477470"/>
              <a:gd name="connsiteY5" fmla="*/ 1637768 h 1729380"/>
              <a:gd name="connsiteX6" fmla="*/ 1352477 w 1477470"/>
              <a:gd name="connsiteY6" fmla="*/ 1729380 h 1729380"/>
              <a:gd name="connsiteX7" fmla="*/ 125386 w 1477470"/>
              <a:gd name="connsiteY7" fmla="*/ 1729380 h 1729380"/>
              <a:gd name="connsiteX8" fmla="*/ 29964 w 1477470"/>
              <a:gd name="connsiteY8" fmla="*/ 1633958 h 1729380"/>
              <a:gd name="connsiteX9" fmla="*/ 27130 w 1477470"/>
              <a:gd name="connsiteY9" fmla="*/ 1344974 h 1729380"/>
              <a:gd name="connsiteX10" fmla="*/ 451837 w 1477470"/>
              <a:gd name="connsiteY10" fmla="*/ 1121249 h 1729380"/>
              <a:gd name="connsiteX0" fmla="*/ 451837 w 1477470"/>
              <a:gd name="connsiteY0" fmla="*/ 1121249 h 1729380"/>
              <a:gd name="connsiteX1" fmla="*/ 467292 w 1477470"/>
              <a:gd name="connsiteY1" fmla="*/ 115239 h 1729380"/>
              <a:gd name="connsiteX2" fmla="*/ 1032185 w 1477470"/>
              <a:gd name="connsiteY2" fmla="*/ 117989 h 1729380"/>
              <a:gd name="connsiteX3" fmla="*/ 1050328 w 1477470"/>
              <a:gd name="connsiteY3" fmla="*/ 1109151 h 1729380"/>
              <a:gd name="connsiteX4" fmla="*/ 1463802 w 1477470"/>
              <a:gd name="connsiteY4" fmla="*/ 1323842 h 1729380"/>
              <a:gd name="connsiteX5" fmla="*/ 1469372 w 1477470"/>
              <a:gd name="connsiteY5" fmla="*/ 1637768 h 1729380"/>
              <a:gd name="connsiteX6" fmla="*/ 1352477 w 1477470"/>
              <a:gd name="connsiteY6" fmla="*/ 1729380 h 1729380"/>
              <a:gd name="connsiteX7" fmla="*/ 125386 w 1477470"/>
              <a:gd name="connsiteY7" fmla="*/ 1729380 h 1729380"/>
              <a:gd name="connsiteX8" fmla="*/ 29964 w 1477470"/>
              <a:gd name="connsiteY8" fmla="*/ 1633958 h 1729380"/>
              <a:gd name="connsiteX9" fmla="*/ 27130 w 1477470"/>
              <a:gd name="connsiteY9" fmla="*/ 1344974 h 1729380"/>
              <a:gd name="connsiteX10" fmla="*/ 451837 w 1477470"/>
              <a:gd name="connsiteY10" fmla="*/ 1121249 h 1729380"/>
              <a:gd name="connsiteX0" fmla="*/ 451837 w 1477470"/>
              <a:gd name="connsiteY0" fmla="*/ 1121249 h 1729380"/>
              <a:gd name="connsiteX1" fmla="*/ 467292 w 1477470"/>
              <a:gd name="connsiteY1" fmla="*/ 115239 h 1729380"/>
              <a:gd name="connsiteX2" fmla="*/ 1032185 w 1477470"/>
              <a:gd name="connsiteY2" fmla="*/ 117989 h 1729380"/>
              <a:gd name="connsiteX3" fmla="*/ 1050328 w 1477470"/>
              <a:gd name="connsiteY3" fmla="*/ 1109151 h 1729380"/>
              <a:gd name="connsiteX4" fmla="*/ 1463802 w 1477470"/>
              <a:gd name="connsiteY4" fmla="*/ 1323842 h 1729380"/>
              <a:gd name="connsiteX5" fmla="*/ 1469372 w 1477470"/>
              <a:gd name="connsiteY5" fmla="*/ 1637768 h 1729380"/>
              <a:gd name="connsiteX6" fmla="*/ 1352477 w 1477470"/>
              <a:gd name="connsiteY6" fmla="*/ 1729380 h 1729380"/>
              <a:gd name="connsiteX7" fmla="*/ 125386 w 1477470"/>
              <a:gd name="connsiteY7" fmla="*/ 1729380 h 1729380"/>
              <a:gd name="connsiteX8" fmla="*/ 29964 w 1477470"/>
              <a:gd name="connsiteY8" fmla="*/ 1633958 h 1729380"/>
              <a:gd name="connsiteX9" fmla="*/ 27130 w 1477470"/>
              <a:gd name="connsiteY9" fmla="*/ 1344974 h 1729380"/>
              <a:gd name="connsiteX10" fmla="*/ 451837 w 1477470"/>
              <a:gd name="connsiteY10" fmla="*/ 1121249 h 1729380"/>
              <a:gd name="connsiteX0" fmla="*/ 451837 w 1477470"/>
              <a:gd name="connsiteY0" fmla="*/ 1121249 h 1729380"/>
              <a:gd name="connsiteX1" fmla="*/ 467292 w 1477470"/>
              <a:gd name="connsiteY1" fmla="*/ 115239 h 1729380"/>
              <a:gd name="connsiteX2" fmla="*/ 1032185 w 1477470"/>
              <a:gd name="connsiteY2" fmla="*/ 117989 h 1729380"/>
              <a:gd name="connsiteX3" fmla="*/ 1050328 w 1477470"/>
              <a:gd name="connsiteY3" fmla="*/ 1109151 h 1729380"/>
              <a:gd name="connsiteX4" fmla="*/ 1463802 w 1477470"/>
              <a:gd name="connsiteY4" fmla="*/ 1323842 h 1729380"/>
              <a:gd name="connsiteX5" fmla="*/ 1469372 w 1477470"/>
              <a:gd name="connsiteY5" fmla="*/ 1637768 h 1729380"/>
              <a:gd name="connsiteX6" fmla="*/ 1352477 w 1477470"/>
              <a:gd name="connsiteY6" fmla="*/ 1729380 h 1729380"/>
              <a:gd name="connsiteX7" fmla="*/ 125386 w 1477470"/>
              <a:gd name="connsiteY7" fmla="*/ 1729380 h 1729380"/>
              <a:gd name="connsiteX8" fmla="*/ 29964 w 1477470"/>
              <a:gd name="connsiteY8" fmla="*/ 1633958 h 1729380"/>
              <a:gd name="connsiteX9" fmla="*/ 27130 w 1477470"/>
              <a:gd name="connsiteY9" fmla="*/ 1344974 h 1729380"/>
              <a:gd name="connsiteX10" fmla="*/ 451837 w 1477470"/>
              <a:gd name="connsiteY10" fmla="*/ 1121249 h 1729380"/>
              <a:gd name="connsiteX0" fmla="*/ 451837 w 1477470"/>
              <a:gd name="connsiteY0" fmla="*/ 1121249 h 1729380"/>
              <a:gd name="connsiteX1" fmla="*/ 467292 w 1477470"/>
              <a:gd name="connsiteY1" fmla="*/ 115239 h 1729380"/>
              <a:gd name="connsiteX2" fmla="*/ 1032185 w 1477470"/>
              <a:gd name="connsiteY2" fmla="*/ 117989 h 1729380"/>
              <a:gd name="connsiteX3" fmla="*/ 1050328 w 1477470"/>
              <a:gd name="connsiteY3" fmla="*/ 1109151 h 1729380"/>
              <a:gd name="connsiteX4" fmla="*/ 1463802 w 1477470"/>
              <a:gd name="connsiteY4" fmla="*/ 1323842 h 1729380"/>
              <a:gd name="connsiteX5" fmla="*/ 1469372 w 1477470"/>
              <a:gd name="connsiteY5" fmla="*/ 1637768 h 1729380"/>
              <a:gd name="connsiteX6" fmla="*/ 1352477 w 1477470"/>
              <a:gd name="connsiteY6" fmla="*/ 1729380 h 1729380"/>
              <a:gd name="connsiteX7" fmla="*/ 125386 w 1477470"/>
              <a:gd name="connsiteY7" fmla="*/ 1729380 h 1729380"/>
              <a:gd name="connsiteX8" fmla="*/ 29964 w 1477470"/>
              <a:gd name="connsiteY8" fmla="*/ 1633958 h 1729380"/>
              <a:gd name="connsiteX9" fmla="*/ 27130 w 1477470"/>
              <a:gd name="connsiteY9" fmla="*/ 1344974 h 1729380"/>
              <a:gd name="connsiteX10" fmla="*/ 451837 w 1477470"/>
              <a:gd name="connsiteY10" fmla="*/ 1121249 h 1729380"/>
              <a:gd name="connsiteX0" fmla="*/ 451837 w 1477470"/>
              <a:gd name="connsiteY0" fmla="*/ 1121249 h 1729380"/>
              <a:gd name="connsiteX1" fmla="*/ 467292 w 1477470"/>
              <a:gd name="connsiteY1" fmla="*/ 115239 h 1729380"/>
              <a:gd name="connsiteX2" fmla="*/ 1032185 w 1477470"/>
              <a:gd name="connsiteY2" fmla="*/ 117989 h 1729380"/>
              <a:gd name="connsiteX3" fmla="*/ 1050328 w 1477470"/>
              <a:gd name="connsiteY3" fmla="*/ 1109151 h 1729380"/>
              <a:gd name="connsiteX4" fmla="*/ 1463802 w 1477470"/>
              <a:gd name="connsiteY4" fmla="*/ 1323842 h 1729380"/>
              <a:gd name="connsiteX5" fmla="*/ 1469372 w 1477470"/>
              <a:gd name="connsiteY5" fmla="*/ 1637768 h 1729380"/>
              <a:gd name="connsiteX6" fmla="*/ 1352477 w 1477470"/>
              <a:gd name="connsiteY6" fmla="*/ 1729380 h 1729380"/>
              <a:gd name="connsiteX7" fmla="*/ 125386 w 1477470"/>
              <a:gd name="connsiteY7" fmla="*/ 1729380 h 1729380"/>
              <a:gd name="connsiteX8" fmla="*/ 29964 w 1477470"/>
              <a:gd name="connsiteY8" fmla="*/ 1633958 h 1729380"/>
              <a:gd name="connsiteX9" fmla="*/ 27130 w 1477470"/>
              <a:gd name="connsiteY9" fmla="*/ 1344974 h 1729380"/>
              <a:gd name="connsiteX10" fmla="*/ 451837 w 1477470"/>
              <a:gd name="connsiteY10" fmla="*/ 1121249 h 1729380"/>
              <a:gd name="connsiteX0" fmla="*/ 421873 w 1447506"/>
              <a:gd name="connsiteY0" fmla="*/ 1121249 h 1729380"/>
              <a:gd name="connsiteX1" fmla="*/ 437328 w 1447506"/>
              <a:gd name="connsiteY1" fmla="*/ 115239 h 1729380"/>
              <a:gd name="connsiteX2" fmla="*/ 1002221 w 1447506"/>
              <a:gd name="connsiteY2" fmla="*/ 117989 h 1729380"/>
              <a:gd name="connsiteX3" fmla="*/ 1020364 w 1447506"/>
              <a:gd name="connsiteY3" fmla="*/ 1109151 h 1729380"/>
              <a:gd name="connsiteX4" fmla="*/ 1433838 w 1447506"/>
              <a:gd name="connsiteY4" fmla="*/ 1323842 h 1729380"/>
              <a:gd name="connsiteX5" fmla="*/ 1439408 w 1447506"/>
              <a:gd name="connsiteY5" fmla="*/ 1637768 h 1729380"/>
              <a:gd name="connsiteX6" fmla="*/ 1322513 w 1447506"/>
              <a:gd name="connsiteY6" fmla="*/ 1729380 h 1729380"/>
              <a:gd name="connsiteX7" fmla="*/ 95422 w 1447506"/>
              <a:gd name="connsiteY7" fmla="*/ 1729380 h 1729380"/>
              <a:gd name="connsiteX8" fmla="*/ 0 w 1447506"/>
              <a:gd name="connsiteY8" fmla="*/ 1633958 h 1729380"/>
              <a:gd name="connsiteX9" fmla="*/ 75905 w 1447506"/>
              <a:gd name="connsiteY9" fmla="*/ 1337354 h 1729380"/>
              <a:gd name="connsiteX10" fmla="*/ 421873 w 1447506"/>
              <a:gd name="connsiteY10" fmla="*/ 1121249 h 1729380"/>
              <a:gd name="connsiteX0" fmla="*/ 421873 w 1447506"/>
              <a:gd name="connsiteY0" fmla="*/ 1121249 h 1729380"/>
              <a:gd name="connsiteX1" fmla="*/ 437328 w 1447506"/>
              <a:gd name="connsiteY1" fmla="*/ 115239 h 1729380"/>
              <a:gd name="connsiteX2" fmla="*/ 1002221 w 1447506"/>
              <a:gd name="connsiteY2" fmla="*/ 117989 h 1729380"/>
              <a:gd name="connsiteX3" fmla="*/ 1020364 w 1447506"/>
              <a:gd name="connsiteY3" fmla="*/ 1109151 h 1729380"/>
              <a:gd name="connsiteX4" fmla="*/ 1433838 w 1447506"/>
              <a:gd name="connsiteY4" fmla="*/ 1323842 h 1729380"/>
              <a:gd name="connsiteX5" fmla="*/ 1439408 w 1447506"/>
              <a:gd name="connsiteY5" fmla="*/ 1637768 h 1729380"/>
              <a:gd name="connsiteX6" fmla="*/ 1322513 w 1447506"/>
              <a:gd name="connsiteY6" fmla="*/ 1729380 h 1729380"/>
              <a:gd name="connsiteX7" fmla="*/ 95422 w 1447506"/>
              <a:gd name="connsiteY7" fmla="*/ 1729380 h 1729380"/>
              <a:gd name="connsiteX8" fmla="*/ 0 w 1447506"/>
              <a:gd name="connsiteY8" fmla="*/ 1633958 h 1729380"/>
              <a:gd name="connsiteX9" fmla="*/ 40115 w 1447506"/>
              <a:gd name="connsiteY9" fmla="*/ 1337354 h 1729380"/>
              <a:gd name="connsiteX10" fmla="*/ 421873 w 1447506"/>
              <a:gd name="connsiteY10" fmla="*/ 1121249 h 1729380"/>
              <a:gd name="connsiteX0" fmla="*/ 421873 w 1447506"/>
              <a:gd name="connsiteY0" fmla="*/ 1121249 h 1729380"/>
              <a:gd name="connsiteX1" fmla="*/ 437328 w 1447506"/>
              <a:gd name="connsiteY1" fmla="*/ 115239 h 1729380"/>
              <a:gd name="connsiteX2" fmla="*/ 1002221 w 1447506"/>
              <a:gd name="connsiteY2" fmla="*/ 117989 h 1729380"/>
              <a:gd name="connsiteX3" fmla="*/ 1020364 w 1447506"/>
              <a:gd name="connsiteY3" fmla="*/ 1109151 h 1729380"/>
              <a:gd name="connsiteX4" fmla="*/ 1433838 w 1447506"/>
              <a:gd name="connsiteY4" fmla="*/ 1323842 h 1729380"/>
              <a:gd name="connsiteX5" fmla="*/ 1439408 w 1447506"/>
              <a:gd name="connsiteY5" fmla="*/ 1637768 h 1729380"/>
              <a:gd name="connsiteX6" fmla="*/ 1322513 w 1447506"/>
              <a:gd name="connsiteY6" fmla="*/ 1729380 h 1729380"/>
              <a:gd name="connsiteX7" fmla="*/ 95422 w 1447506"/>
              <a:gd name="connsiteY7" fmla="*/ 1729380 h 1729380"/>
              <a:gd name="connsiteX8" fmla="*/ 0 w 1447506"/>
              <a:gd name="connsiteY8" fmla="*/ 1633958 h 1729380"/>
              <a:gd name="connsiteX9" fmla="*/ 40115 w 1447506"/>
              <a:gd name="connsiteY9" fmla="*/ 1337354 h 1729380"/>
              <a:gd name="connsiteX10" fmla="*/ 421873 w 1447506"/>
              <a:gd name="connsiteY10" fmla="*/ 1121249 h 1729380"/>
              <a:gd name="connsiteX0" fmla="*/ 421873 w 1447506"/>
              <a:gd name="connsiteY0" fmla="*/ 1121249 h 1729380"/>
              <a:gd name="connsiteX1" fmla="*/ 437328 w 1447506"/>
              <a:gd name="connsiteY1" fmla="*/ 115239 h 1729380"/>
              <a:gd name="connsiteX2" fmla="*/ 1002221 w 1447506"/>
              <a:gd name="connsiteY2" fmla="*/ 117989 h 1729380"/>
              <a:gd name="connsiteX3" fmla="*/ 1020364 w 1447506"/>
              <a:gd name="connsiteY3" fmla="*/ 1109151 h 1729380"/>
              <a:gd name="connsiteX4" fmla="*/ 1433838 w 1447506"/>
              <a:gd name="connsiteY4" fmla="*/ 1323842 h 1729380"/>
              <a:gd name="connsiteX5" fmla="*/ 1439408 w 1447506"/>
              <a:gd name="connsiteY5" fmla="*/ 1637768 h 1729380"/>
              <a:gd name="connsiteX6" fmla="*/ 1322513 w 1447506"/>
              <a:gd name="connsiteY6" fmla="*/ 1729380 h 1729380"/>
              <a:gd name="connsiteX7" fmla="*/ 95422 w 1447506"/>
              <a:gd name="connsiteY7" fmla="*/ 1729380 h 1729380"/>
              <a:gd name="connsiteX8" fmla="*/ 0 w 1447506"/>
              <a:gd name="connsiteY8" fmla="*/ 1633958 h 1729380"/>
              <a:gd name="connsiteX9" fmla="*/ 40115 w 1447506"/>
              <a:gd name="connsiteY9" fmla="*/ 1337354 h 1729380"/>
              <a:gd name="connsiteX10" fmla="*/ 421873 w 1447506"/>
              <a:gd name="connsiteY10" fmla="*/ 1121249 h 1729380"/>
              <a:gd name="connsiteX0" fmla="*/ 421873 w 1447506"/>
              <a:gd name="connsiteY0" fmla="*/ 1121249 h 1729380"/>
              <a:gd name="connsiteX1" fmla="*/ 437328 w 1447506"/>
              <a:gd name="connsiteY1" fmla="*/ 115239 h 1729380"/>
              <a:gd name="connsiteX2" fmla="*/ 1002221 w 1447506"/>
              <a:gd name="connsiteY2" fmla="*/ 117989 h 1729380"/>
              <a:gd name="connsiteX3" fmla="*/ 1020364 w 1447506"/>
              <a:gd name="connsiteY3" fmla="*/ 1109151 h 1729380"/>
              <a:gd name="connsiteX4" fmla="*/ 1433838 w 1447506"/>
              <a:gd name="connsiteY4" fmla="*/ 1323842 h 1729380"/>
              <a:gd name="connsiteX5" fmla="*/ 1439408 w 1447506"/>
              <a:gd name="connsiteY5" fmla="*/ 1637768 h 1729380"/>
              <a:gd name="connsiteX6" fmla="*/ 1322513 w 1447506"/>
              <a:gd name="connsiteY6" fmla="*/ 1729380 h 1729380"/>
              <a:gd name="connsiteX7" fmla="*/ 95422 w 1447506"/>
              <a:gd name="connsiteY7" fmla="*/ 1729380 h 1729380"/>
              <a:gd name="connsiteX8" fmla="*/ 0 w 1447506"/>
              <a:gd name="connsiteY8" fmla="*/ 1633958 h 1729380"/>
              <a:gd name="connsiteX9" fmla="*/ 40115 w 1447506"/>
              <a:gd name="connsiteY9" fmla="*/ 1337354 h 1729380"/>
              <a:gd name="connsiteX10" fmla="*/ 421873 w 1447506"/>
              <a:gd name="connsiteY10" fmla="*/ 1121249 h 1729380"/>
              <a:gd name="connsiteX0" fmla="*/ 421873 w 1447506"/>
              <a:gd name="connsiteY0" fmla="*/ 1121249 h 1729380"/>
              <a:gd name="connsiteX1" fmla="*/ 437328 w 1447506"/>
              <a:gd name="connsiteY1" fmla="*/ 115239 h 1729380"/>
              <a:gd name="connsiteX2" fmla="*/ 1002221 w 1447506"/>
              <a:gd name="connsiteY2" fmla="*/ 117989 h 1729380"/>
              <a:gd name="connsiteX3" fmla="*/ 1020364 w 1447506"/>
              <a:gd name="connsiteY3" fmla="*/ 1109151 h 1729380"/>
              <a:gd name="connsiteX4" fmla="*/ 1433838 w 1447506"/>
              <a:gd name="connsiteY4" fmla="*/ 1323842 h 1729380"/>
              <a:gd name="connsiteX5" fmla="*/ 1439408 w 1447506"/>
              <a:gd name="connsiteY5" fmla="*/ 1637768 h 1729380"/>
              <a:gd name="connsiteX6" fmla="*/ 1322513 w 1447506"/>
              <a:gd name="connsiteY6" fmla="*/ 1729380 h 1729380"/>
              <a:gd name="connsiteX7" fmla="*/ 95422 w 1447506"/>
              <a:gd name="connsiteY7" fmla="*/ 1729380 h 1729380"/>
              <a:gd name="connsiteX8" fmla="*/ 0 w 1447506"/>
              <a:gd name="connsiteY8" fmla="*/ 1633958 h 1729380"/>
              <a:gd name="connsiteX9" fmla="*/ 40115 w 1447506"/>
              <a:gd name="connsiteY9" fmla="*/ 1337354 h 1729380"/>
              <a:gd name="connsiteX10" fmla="*/ 421873 w 1447506"/>
              <a:gd name="connsiteY10" fmla="*/ 1121249 h 1729380"/>
              <a:gd name="connsiteX0" fmla="*/ 421873 w 1447506"/>
              <a:gd name="connsiteY0" fmla="*/ 1121249 h 1729380"/>
              <a:gd name="connsiteX1" fmla="*/ 437328 w 1447506"/>
              <a:gd name="connsiteY1" fmla="*/ 115239 h 1729380"/>
              <a:gd name="connsiteX2" fmla="*/ 1002221 w 1447506"/>
              <a:gd name="connsiteY2" fmla="*/ 117989 h 1729380"/>
              <a:gd name="connsiteX3" fmla="*/ 1020364 w 1447506"/>
              <a:gd name="connsiteY3" fmla="*/ 1109151 h 1729380"/>
              <a:gd name="connsiteX4" fmla="*/ 1433838 w 1447506"/>
              <a:gd name="connsiteY4" fmla="*/ 1323842 h 1729380"/>
              <a:gd name="connsiteX5" fmla="*/ 1439408 w 1447506"/>
              <a:gd name="connsiteY5" fmla="*/ 1637768 h 1729380"/>
              <a:gd name="connsiteX6" fmla="*/ 1322513 w 1447506"/>
              <a:gd name="connsiteY6" fmla="*/ 1729380 h 1729380"/>
              <a:gd name="connsiteX7" fmla="*/ 95422 w 1447506"/>
              <a:gd name="connsiteY7" fmla="*/ 1729380 h 1729380"/>
              <a:gd name="connsiteX8" fmla="*/ 0 w 1447506"/>
              <a:gd name="connsiteY8" fmla="*/ 1633958 h 1729380"/>
              <a:gd name="connsiteX9" fmla="*/ 40115 w 1447506"/>
              <a:gd name="connsiteY9" fmla="*/ 1337354 h 1729380"/>
              <a:gd name="connsiteX10" fmla="*/ 421873 w 1447506"/>
              <a:gd name="connsiteY10" fmla="*/ 1121249 h 1729380"/>
              <a:gd name="connsiteX0" fmla="*/ 421873 w 1447506"/>
              <a:gd name="connsiteY0" fmla="*/ 1121249 h 1729380"/>
              <a:gd name="connsiteX1" fmla="*/ 437328 w 1447506"/>
              <a:gd name="connsiteY1" fmla="*/ 115239 h 1729380"/>
              <a:gd name="connsiteX2" fmla="*/ 1002221 w 1447506"/>
              <a:gd name="connsiteY2" fmla="*/ 117989 h 1729380"/>
              <a:gd name="connsiteX3" fmla="*/ 1020364 w 1447506"/>
              <a:gd name="connsiteY3" fmla="*/ 1109151 h 1729380"/>
              <a:gd name="connsiteX4" fmla="*/ 1433838 w 1447506"/>
              <a:gd name="connsiteY4" fmla="*/ 1323842 h 1729380"/>
              <a:gd name="connsiteX5" fmla="*/ 1439408 w 1447506"/>
              <a:gd name="connsiteY5" fmla="*/ 1637768 h 1729380"/>
              <a:gd name="connsiteX6" fmla="*/ 1322513 w 1447506"/>
              <a:gd name="connsiteY6" fmla="*/ 1729380 h 1729380"/>
              <a:gd name="connsiteX7" fmla="*/ 95422 w 1447506"/>
              <a:gd name="connsiteY7" fmla="*/ 1729380 h 1729380"/>
              <a:gd name="connsiteX8" fmla="*/ 0 w 1447506"/>
              <a:gd name="connsiteY8" fmla="*/ 1633958 h 1729380"/>
              <a:gd name="connsiteX9" fmla="*/ 40115 w 1447506"/>
              <a:gd name="connsiteY9" fmla="*/ 1337354 h 1729380"/>
              <a:gd name="connsiteX10" fmla="*/ 421873 w 1447506"/>
              <a:gd name="connsiteY10" fmla="*/ 1121249 h 1729380"/>
              <a:gd name="connsiteX0" fmla="*/ 421873 w 1447506"/>
              <a:gd name="connsiteY0" fmla="*/ 1121249 h 1729380"/>
              <a:gd name="connsiteX1" fmla="*/ 437328 w 1447506"/>
              <a:gd name="connsiteY1" fmla="*/ 115239 h 1729380"/>
              <a:gd name="connsiteX2" fmla="*/ 1002221 w 1447506"/>
              <a:gd name="connsiteY2" fmla="*/ 117989 h 1729380"/>
              <a:gd name="connsiteX3" fmla="*/ 1020364 w 1447506"/>
              <a:gd name="connsiteY3" fmla="*/ 1109151 h 1729380"/>
              <a:gd name="connsiteX4" fmla="*/ 1433838 w 1447506"/>
              <a:gd name="connsiteY4" fmla="*/ 1323842 h 1729380"/>
              <a:gd name="connsiteX5" fmla="*/ 1439408 w 1447506"/>
              <a:gd name="connsiteY5" fmla="*/ 1637768 h 1729380"/>
              <a:gd name="connsiteX6" fmla="*/ 1322513 w 1447506"/>
              <a:gd name="connsiteY6" fmla="*/ 1729380 h 1729380"/>
              <a:gd name="connsiteX7" fmla="*/ 95422 w 1447506"/>
              <a:gd name="connsiteY7" fmla="*/ 1729380 h 1729380"/>
              <a:gd name="connsiteX8" fmla="*/ 0 w 1447506"/>
              <a:gd name="connsiteY8" fmla="*/ 1633958 h 1729380"/>
              <a:gd name="connsiteX9" fmla="*/ 40115 w 1447506"/>
              <a:gd name="connsiteY9" fmla="*/ 1337354 h 1729380"/>
              <a:gd name="connsiteX10" fmla="*/ 421873 w 1447506"/>
              <a:gd name="connsiteY10" fmla="*/ 1121249 h 1729380"/>
              <a:gd name="connsiteX0" fmla="*/ 421873 w 1447506"/>
              <a:gd name="connsiteY0" fmla="*/ 1121249 h 1729380"/>
              <a:gd name="connsiteX1" fmla="*/ 437328 w 1447506"/>
              <a:gd name="connsiteY1" fmla="*/ 115239 h 1729380"/>
              <a:gd name="connsiteX2" fmla="*/ 1002221 w 1447506"/>
              <a:gd name="connsiteY2" fmla="*/ 117989 h 1729380"/>
              <a:gd name="connsiteX3" fmla="*/ 1020364 w 1447506"/>
              <a:gd name="connsiteY3" fmla="*/ 1109151 h 1729380"/>
              <a:gd name="connsiteX4" fmla="*/ 1433838 w 1447506"/>
              <a:gd name="connsiteY4" fmla="*/ 1323842 h 1729380"/>
              <a:gd name="connsiteX5" fmla="*/ 1439408 w 1447506"/>
              <a:gd name="connsiteY5" fmla="*/ 1637768 h 1729380"/>
              <a:gd name="connsiteX6" fmla="*/ 1322513 w 1447506"/>
              <a:gd name="connsiteY6" fmla="*/ 1729380 h 1729380"/>
              <a:gd name="connsiteX7" fmla="*/ 95422 w 1447506"/>
              <a:gd name="connsiteY7" fmla="*/ 1729380 h 1729380"/>
              <a:gd name="connsiteX8" fmla="*/ 0 w 1447506"/>
              <a:gd name="connsiteY8" fmla="*/ 1633958 h 1729380"/>
              <a:gd name="connsiteX9" fmla="*/ 40115 w 1447506"/>
              <a:gd name="connsiteY9" fmla="*/ 1337354 h 1729380"/>
              <a:gd name="connsiteX10" fmla="*/ 421873 w 1447506"/>
              <a:gd name="connsiteY10" fmla="*/ 1121249 h 1729380"/>
              <a:gd name="connsiteX0" fmla="*/ 421873 w 1452167"/>
              <a:gd name="connsiteY0" fmla="*/ 1121249 h 1729380"/>
              <a:gd name="connsiteX1" fmla="*/ 437328 w 1452167"/>
              <a:gd name="connsiteY1" fmla="*/ 115239 h 1729380"/>
              <a:gd name="connsiteX2" fmla="*/ 1002221 w 1452167"/>
              <a:gd name="connsiteY2" fmla="*/ 117989 h 1729380"/>
              <a:gd name="connsiteX3" fmla="*/ 1020364 w 1452167"/>
              <a:gd name="connsiteY3" fmla="*/ 1109151 h 1729380"/>
              <a:gd name="connsiteX4" fmla="*/ 1440996 w 1452167"/>
              <a:gd name="connsiteY4" fmla="*/ 1346702 h 1729380"/>
              <a:gd name="connsiteX5" fmla="*/ 1439408 w 1452167"/>
              <a:gd name="connsiteY5" fmla="*/ 1637768 h 1729380"/>
              <a:gd name="connsiteX6" fmla="*/ 1322513 w 1452167"/>
              <a:gd name="connsiteY6" fmla="*/ 1729380 h 1729380"/>
              <a:gd name="connsiteX7" fmla="*/ 95422 w 1452167"/>
              <a:gd name="connsiteY7" fmla="*/ 1729380 h 1729380"/>
              <a:gd name="connsiteX8" fmla="*/ 0 w 1452167"/>
              <a:gd name="connsiteY8" fmla="*/ 1633958 h 1729380"/>
              <a:gd name="connsiteX9" fmla="*/ 40115 w 1452167"/>
              <a:gd name="connsiteY9" fmla="*/ 1337354 h 1729380"/>
              <a:gd name="connsiteX10" fmla="*/ 421873 w 1452167"/>
              <a:gd name="connsiteY10" fmla="*/ 1121249 h 1729380"/>
              <a:gd name="connsiteX0" fmla="*/ 421873 w 1452167"/>
              <a:gd name="connsiteY0" fmla="*/ 1121249 h 1729380"/>
              <a:gd name="connsiteX1" fmla="*/ 437328 w 1452167"/>
              <a:gd name="connsiteY1" fmla="*/ 115239 h 1729380"/>
              <a:gd name="connsiteX2" fmla="*/ 1002221 w 1452167"/>
              <a:gd name="connsiteY2" fmla="*/ 117989 h 1729380"/>
              <a:gd name="connsiteX3" fmla="*/ 1048996 w 1452167"/>
              <a:gd name="connsiteY3" fmla="*/ 1135821 h 1729380"/>
              <a:gd name="connsiteX4" fmla="*/ 1440996 w 1452167"/>
              <a:gd name="connsiteY4" fmla="*/ 1346702 h 1729380"/>
              <a:gd name="connsiteX5" fmla="*/ 1439408 w 1452167"/>
              <a:gd name="connsiteY5" fmla="*/ 1637768 h 1729380"/>
              <a:gd name="connsiteX6" fmla="*/ 1322513 w 1452167"/>
              <a:gd name="connsiteY6" fmla="*/ 1729380 h 1729380"/>
              <a:gd name="connsiteX7" fmla="*/ 95422 w 1452167"/>
              <a:gd name="connsiteY7" fmla="*/ 1729380 h 1729380"/>
              <a:gd name="connsiteX8" fmla="*/ 0 w 1452167"/>
              <a:gd name="connsiteY8" fmla="*/ 1633958 h 1729380"/>
              <a:gd name="connsiteX9" fmla="*/ 40115 w 1452167"/>
              <a:gd name="connsiteY9" fmla="*/ 1337354 h 1729380"/>
              <a:gd name="connsiteX10" fmla="*/ 421873 w 1452167"/>
              <a:gd name="connsiteY10" fmla="*/ 1121249 h 1729380"/>
              <a:gd name="connsiteX0" fmla="*/ 421873 w 1452167"/>
              <a:gd name="connsiteY0" fmla="*/ 1121249 h 1729380"/>
              <a:gd name="connsiteX1" fmla="*/ 437328 w 1452167"/>
              <a:gd name="connsiteY1" fmla="*/ 115239 h 1729380"/>
              <a:gd name="connsiteX2" fmla="*/ 1002221 w 1452167"/>
              <a:gd name="connsiteY2" fmla="*/ 117989 h 1729380"/>
              <a:gd name="connsiteX3" fmla="*/ 1048996 w 1452167"/>
              <a:gd name="connsiteY3" fmla="*/ 1128201 h 1729380"/>
              <a:gd name="connsiteX4" fmla="*/ 1440996 w 1452167"/>
              <a:gd name="connsiteY4" fmla="*/ 1346702 h 1729380"/>
              <a:gd name="connsiteX5" fmla="*/ 1439408 w 1452167"/>
              <a:gd name="connsiteY5" fmla="*/ 1637768 h 1729380"/>
              <a:gd name="connsiteX6" fmla="*/ 1322513 w 1452167"/>
              <a:gd name="connsiteY6" fmla="*/ 1729380 h 1729380"/>
              <a:gd name="connsiteX7" fmla="*/ 95422 w 1452167"/>
              <a:gd name="connsiteY7" fmla="*/ 1729380 h 1729380"/>
              <a:gd name="connsiteX8" fmla="*/ 0 w 1452167"/>
              <a:gd name="connsiteY8" fmla="*/ 1633958 h 1729380"/>
              <a:gd name="connsiteX9" fmla="*/ 40115 w 1452167"/>
              <a:gd name="connsiteY9" fmla="*/ 1337354 h 1729380"/>
              <a:gd name="connsiteX10" fmla="*/ 421873 w 1452167"/>
              <a:gd name="connsiteY10" fmla="*/ 1121249 h 1729380"/>
              <a:gd name="connsiteX0" fmla="*/ 421873 w 1452167"/>
              <a:gd name="connsiteY0" fmla="*/ 1121249 h 1729380"/>
              <a:gd name="connsiteX1" fmla="*/ 437328 w 1452167"/>
              <a:gd name="connsiteY1" fmla="*/ 115239 h 1729380"/>
              <a:gd name="connsiteX2" fmla="*/ 1002221 w 1452167"/>
              <a:gd name="connsiteY2" fmla="*/ 117989 h 1729380"/>
              <a:gd name="connsiteX3" fmla="*/ 1048996 w 1452167"/>
              <a:gd name="connsiteY3" fmla="*/ 1109151 h 1729380"/>
              <a:gd name="connsiteX4" fmla="*/ 1440996 w 1452167"/>
              <a:gd name="connsiteY4" fmla="*/ 1346702 h 1729380"/>
              <a:gd name="connsiteX5" fmla="*/ 1439408 w 1452167"/>
              <a:gd name="connsiteY5" fmla="*/ 1637768 h 1729380"/>
              <a:gd name="connsiteX6" fmla="*/ 1322513 w 1452167"/>
              <a:gd name="connsiteY6" fmla="*/ 1729380 h 1729380"/>
              <a:gd name="connsiteX7" fmla="*/ 95422 w 1452167"/>
              <a:gd name="connsiteY7" fmla="*/ 1729380 h 1729380"/>
              <a:gd name="connsiteX8" fmla="*/ 0 w 1452167"/>
              <a:gd name="connsiteY8" fmla="*/ 1633958 h 1729380"/>
              <a:gd name="connsiteX9" fmla="*/ 40115 w 1452167"/>
              <a:gd name="connsiteY9" fmla="*/ 1337354 h 1729380"/>
              <a:gd name="connsiteX10" fmla="*/ 421873 w 1452167"/>
              <a:gd name="connsiteY10" fmla="*/ 1121249 h 1729380"/>
              <a:gd name="connsiteX0" fmla="*/ 364610 w 1452167"/>
              <a:gd name="connsiteY0" fmla="*/ 1121249 h 1729380"/>
              <a:gd name="connsiteX1" fmla="*/ 437328 w 1452167"/>
              <a:gd name="connsiteY1" fmla="*/ 115239 h 1729380"/>
              <a:gd name="connsiteX2" fmla="*/ 1002221 w 1452167"/>
              <a:gd name="connsiteY2" fmla="*/ 117989 h 1729380"/>
              <a:gd name="connsiteX3" fmla="*/ 1048996 w 1452167"/>
              <a:gd name="connsiteY3" fmla="*/ 1109151 h 1729380"/>
              <a:gd name="connsiteX4" fmla="*/ 1440996 w 1452167"/>
              <a:gd name="connsiteY4" fmla="*/ 1346702 h 1729380"/>
              <a:gd name="connsiteX5" fmla="*/ 1439408 w 1452167"/>
              <a:gd name="connsiteY5" fmla="*/ 1637768 h 1729380"/>
              <a:gd name="connsiteX6" fmla="*/ 1322513 w 1452167"/>
              <a:gd name="connsiteY6" fmla="*/ 1729380 h 1729380"/>
              <a:gd name="connsiteX7" fmla="*/ 95422 w 1452167"/>
              <a:gd name="connsiteY7" fmla="*/ 1729380 h 1729380"/>
              <a:gd name="connsiteX8" fmla="*/ 0 w 1452167"/>
              <a:gd name="connsiteY8" fmla="*/ 1633958 h 1729380"/>
              <a:gd name="connsiteX9" fmla="*/ 40115 w 1452167"/>
              <a:gd name="connsiteY9" fmla="*/ 1337354 h 1729380"/>
              <a:gd name="connsiteX10" fmla="*/ 364610 w 1452167"/>
              <a:gd name="connsiteY10" fmla="*/ 1121249 h 1729380"/>
              <a:gd name="connsiteX0" fmla="*/ 364610 w 1452167"/>
              <a:gd name="connsiteY0" fmla="*/ 1121249 h 1729380"/>
              <a:gd name="connsiteX1" fmla="*/ 437328 w 1452167"/>
              <a:gd name="connsiteY1" fmla="*/ 115239 h 1729380"/>
              <a:gd name="connsiteX2" fmla="*/ 1002221 w 1452167"/>
              <a:gd name="connsiteY2" fmla="*/ 117989 h 1729380"/>
              <a:gd name="connsiteX3" fmla="*/ 1048996 w 1452167"/>
              <a:gd name="connsiteY3" fmla="*/ 1109151 h 1729380"/>
              <a:gd name="connsiteX4" fmla="*/ 1440996 w 1452167"/>
              <a:gd name="connsiteY4" fmla="*/ 1346702 h 1729380"/>
              <a:gd name="connsiteX5" fmla="*/ 1439408 w 1452167"/>
              <a:gd name="connsiteY5" fmla="*/ 1637768 h 1729380"/>
              <a:gd name="connsiteX6" fmla="*/ 1322513 w 1452167"/>
              <a:gd name="connsiteY6" fmla="*/ 1729380 h 1729380"/>
              <a:gd name="connsiteX7" fmla="*/ 95422 w 1452167"/>
              <a:gd name="connsiteY7" fmla="*/ 1729380 h 1729380"/>
              <a:gd name="connsiteX8" fmla="*/ 0 w 1452167"/>
              <a:gd name="connsiteY8" fmla="*/ 1633958 h 1729380"/>
              <a:gd name="connsiteX9" fmla="*/ 40115 w 1452167"/>
              <a:gd name="connsiteY9" fmla="*/ 1337354 h 1729380"/>
              <a:gd name="connsiteX10" fmla="*/ 364610 w 1452167"/>
              <a:gd name="connsiteY10" fmla="*/ 1121249 h 1729380"/>
              <a:gd name="connsiteX0" fmla="*/ 364610 w 1452167"/>
              <a:gd name="connsiteY0" fmla="*/ 1121249 h 1729380"/>
              <a:gd name="connsiteX1" fmla="*/ 437328 w 1452167"/>
              <a:gd name="connsiteY1" fmla="*/ 115239 h 1729380"/>
              <a:gd name="connsiteX2" fmla="*/ 1002221 w 1452167"/>
              <a:gd name="connsiteY2" fmla="*/ 117989 h 1729380"/>
              <a:gd name="connsiteX3" fmla="*/ 1048996 w 1452167"/>
              <a:gd name="connsiteY3" fmla="*/ 1109151 h 1729380"/>
              <a:gd name="connsiteX4" fmla="*/ 1440996 w 1452167"/>
              <a:gd name="connsiteY4" fmla="*/ 1346702 h 1729380"/>
              <a:gd name="connsiteX5" fmla="*/ 1439408 w 1452167"/>
              <a:gd name="connsiteY5" fmla="*/ 1637768 h 1729380"/>
              <a:gd name="connsiteX6" fmla="*/ 1322513 w 1452167"/>
              <a:gd name="connsiteY6" fmla="*/ 1729380 h 1729380"/>
              <a:gd name="connsiteX7" fmla="*/ 95422 w 1452167"/>
              <a:gd name="connsiteY7" fmla="*/ 1729380 h 1729380"/>
              <a:gd name="connsiteX8" fmla="*/ 0 w 1452167"/>
              <a:gd name="connsiteY8" fmla="*/ 1633958 h 1729380"/>
              <a:gd name="connsiteX9" fmla="*/ 40115 w 1452167"/>
              <a:gd name="connsiteY9" fmla="*/ 1337354 h 1729380"/>
              <a:gd name="connsiteX10" fmla="*/ 364610 w 1452167"/>
              <a:gd name="connsiteY10" fmla="*/ 1121249 h 1729380"/>
              <a:gd name="connsiteX0" fmla="*/ 364610 w 1452167"/>
              <a:gd name="connsiteY0" fmla="*/ 1121249 h 1729380"/>
              <a:gd name="connsiteX1" fmla="*/ 437328 w 1452167"/>
              <a:gd name="connsiteY1" fmla="*/ 115239 h 1729380"/>
              <a:gd name="connsiteX2" fmla="*/ 1002221 w 1452167"/>
              <a:gd name="connsiteY2" fmla="*/ 117989 h 1729380"/>
              <a:gd name="connsiteX3" fmla="*/ 1048996 w 1452167"/>
              <a:gd name="connsiteY3" fmla="*/ 1109151 h 1729380"/>
              <a:gd name="connsiteX4" fmla="*/ 1440996 w 1452167"/>
              <a:gd name="connsiteY4" fmla="*/ 1346702 h 1729380"/>
              <a:gd name="connsiteX5" fmla="*/ 1439408 w 1452167"/>
              <a:gd name="connsiteY5" fmla="*/ 1637768 h 1729380"/>
              <a:gd name="connsiteX6" fmla="*/ 1322513 w 1452167"/>
              <a:gd name="connsiteY6" fmla="*/ 1729380 h 1729380"/>
              <a:gd name="connsiteX7" fmla="*/ 95422 w 1452167"/>
              <a:gd name="connsiteY7" fmla="*/ 1729380 h 1729380"/>
              <a:gd name="connsiteX8" fmla="*/ 0 w 1452167"/>
              <a:gd name="connsiteY8" fmla="*/ 1633958 h 1729380"/>
              <a:gd name="connsiteX9" fmla="*/ 40115 w 1452167"/>
              <a:gd name="connsiteY9" fmla="*/ 1337354 h 1729380"/>
              <a:gd name="connsiteX10" fmla="*/ 364610 w 1452167"/>
              <a:gd name="connsiteY10" fmla="*/ 1121249 h 172938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</a:cxnLst>
            <a:rect l="l" t="t" r="r" b="b"/>
            <a:pathLst>
              <a:path w="1452167" h="1729380">
                <a:moveTo>
                  <a:pt x="364610" y="1121249"/>
                </a:moveTo>
                <a:cubicBezTo>
                  <a:pt x="386084" y="1129509"/>
                  <a:pt x="384628" y="115239"/>
                  <a:pt x="437328" y="115239"/>
                </a:cubicBezTo>
                <a:cubicBezTo>
                  <a:pt x="518226" y="-36704"/>
                  <a:pt x="944805" y="-41037"/>
                  <a:pt x="1002221" y="117989"/>
                </a:cubicBezTo>
                <a:cubicBezTo>
                  <a:pt x="1059637" y="277015"/>
                  <a:pt x="1061081" y="1008892"/>
                  <a:pt x="1048996" y="1109151"/>
                </a:cubicBezTo>
                <a:cubicBezTo>
                  <a:pt x="1044433" y="1109151"/>
                  <a:pt x="1297837" y="1244472"/>
                  <a:pt x="1440996" y="1346702"/>
                </a:cubicBezTo>
                <a:cubicBezTo>
                  <a:pt x="1464326" y="1450074"/>
                  <a:pt x="1444709" y="1534396"/>
                  <a:pt x="1439408" y="1637768"/>
                </a:cubicBezTo>
                <a:cubicBezTo>
                  <a:pt x="1439408" y="1690468"/>
                  <a:pt x="1375213" y="1729380"/>
                  <a:pt x="1322513" y="1729380"/>
                </a:cubicBezTo>
                <a:lnTo>
                  <a:pt x="95422" y="1729380"/>
                </a:lnTo>
                <a:cubicBezTo>
                  <a:pt x="42722" y="1729380"/>
                  <a:pt x="0" y="1686658"/>
                  <a:pt x="0" y="1633958"/>
                </a:cubicBezTo>
                <a:cubicBezTo>
                  <a:pt x="17286" y="1485656"/>
                  <a:pt x="-30120" y="1406268"/>
                  <a:pt x="40115" y="1337354"/>
                </a:cubicBezTo>
                <a:cubicBezTo>
                  <a:pt x="339404" y="1142710"/>
                  <a:pt x="107009" y="1306410"/>
                  <a:pt x="364610" y="1121249"/>
                </a:cubicBezTo>
                <a:close/>
              </a:path>
            </a:pathLst>
          </a:custGeom>
          <a:solidFill>
            <a:schemeClr val="accent3">
              <a:lumMod val="40000"/>
              <a:lumOff val="60000"/>
            </a:schemeClr>
          </a:solidFill>
          <a:ln>
            <a:noFill/>
          </a:ln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Rectangle 65"/>
          <p:cNvSpPr/>
          <p:nvPr/>
        </p:nvSpPr>
        <p:spPr>
          <a:xfrm>
            <a:off x="3725990" y="3647650"/>
            <a:ext cx="848944" cy="267772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ln>
            <a:solidFill>
              <a:schemeClr val="accent5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E8A80512-AEC6-4B2D-9EF1-248EF10AE049}"/>
              </a:ext>
            </a:extLst>
          </p:cNvPr>
          <p:cNvSpPr txBox="1"/>
          <p:nvPr/>
        </p:nvSpPr>
        <p:spPr>
          <a:xfrm>
            <a:off x="3133912" y="3624751"/>
            <a:ext cx="20330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Distance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9D1B0309-5364-E448-BE70-A296C7C395CA}"/>
              </a:ext>
            </a:extLst>
          </p:cNvPr>
          <p:cNvSpPr txBox="1"/>
          <p:nvPr/>
        </p:nvSpPr>
        <p:spPr>
          <a:xfrm>
            <a:off x="3911213" y="2729256"/>
            <a:ext cx="4913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º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06D4391C-EE3B-DF45-88F3-53FCD040AA96}"/>
              </a:ext>
            </a:extLst>
          </p:cNvPr>
          <p:cNvSpPr txBox="1"/>
          <p:nvPr/>
        </p:nvSpPr>
        <p:spPr>
          <a:xfrm>
            <a:off x="3404946" y="3197130"/>
            <a:ext cx="4913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90º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811BA28F-7178-F74C-9E7F-462294B97B06}"/>
              </a:ext>
            </a:extLst>
          </p:cNvPr>
          <p:cNvSpPr txBox="1"/>
          <p:nvPr/>
        </p:nvSpPr>
        <p:spPr>
          <a:xfrm>
            <a:off x="8160939" y="3223692"/>
            <a:ext cx="4913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&lt; 0º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ABC2EDAA-76EA-244F-A46A-4A423F98ED61}"/>
              </a:ext>
            </a:extLst>
          </p:cNvPr>
          <p:cNvSpPr txBox="1"/>
          <p:nvPr/>
        </p:nvSpPr>
        <p:spPr>
          <a:xfrm>
            <a:off x="8750219" y="3219273"/>
            <a:ext cx="5010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&gt; 0º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019772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7C4E60A1-D07D-4584-AC04-681B03D9A34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51969327"/>
              </p:ext>
            </p:extLst>
          </p:nvPr>
        </p:nvGraphicFramePr>
        <p:xfrm>
          <a:off x="1834669" y="-7197"/>
          <a:ext cx="8522661" cy="686519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50" name="Prism 9" r:id="rId3" imgW="8893778" imgH="7163858" progId="Prism9.Document">
                  <p:embed/>
                </p:oleObj>
              </mc:Choice>
              <mc:Fallback>
                <p:oleObj name="Prism 9" r:id="rId3" imgW="8893778" imgH="7163858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834669" y="-7197"/>
                        <a:ext cx="8522661" cy="686519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2413160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638707484"/>
              </p:ext>
            </p:extLst>
          </p:nvPr>
        </p:nvGraphicFramePr>
        <p:xfrm>
          <a:off x="201336" y="0"/>
          <a:ext cx="11990664" cy="68579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B4E2DF97-AF09-4DB3-B362-E1355A09E0C5}"/>
              </a:ext>
            </a:extLst>
          </p:cNvPr>
          <p:cNvSpPr txBox="1"/>
          <p:nvPr/>
        </p:nvSpPr>
        <p:spPr>
          <a:xfrm>
            <a:off x="11011704" y="206453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87%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FCAE003-FA3B-4B65-AA9A-25613A0FEC89}"/>
              </a:ext>
            </a:extLst>
          </p:cNvPr>
          <p:cNvSpPr txBox="1"/>
          <p:nvPr/>
        </p:nvSpPr>
        <p:spPr>
          <a:xfrm>
            <a:off x="11018186" y="695305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87%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0826145-1C42-40C0-991B-2216DADF2ECF}"/>
              </a:ext>
            </a:extLst>
          </p:cNvPr>
          <p:cNvSpPr txBox="1"/>
          <p:nvPr/>
        </p:nvSpPr>
        <p:spPr>
          <a:xfrm>
            <a:off x="10434529" y="1167379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77%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57C7661-4100-404E-895A-29EE28881DCD}"/>
              </a:ext>
            </a:extLst>
          </p:cNvPr>
          <p:cNvSpPr txBox="1"/>
          <p:nvPr/>
        </p:nvSpPr>
        <p:spPr>
          <a:xfrm>
            <a:off x="8162066" y="1673009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37%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B66D248-E6AC-4832-A0FE-F02FB86A2F94}"/>
              </a:ext>
            </a:extLst>
          </p:cNvPr>
          <p:cNvSpPr txBox="1"/>
          <p:nvPr/>
        </p:nvSpPr>
        <p:spPr>
          <a:xfrm>
            <a:off x="8722458" y="2163026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47%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B798030-FCE6-4FE1-891C-AFE3053DB420}"/>
              </a:ext>
            </a:extLst>
          </p:cNvPr>
          <p:cNvSpPr txBox="1"/>
          <p:nvPr/>
        </p:nvSpPr>
        <p:spPr>
          <a:xfrm>
            <a:off x="9857350" y="2643489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67%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AA44E78-FB99-48D9-826C-70664A54214D}"/>
              </a:ext>
            </a:extLst>
          </p:cNvPr>
          <p:cNvSpPr txBox="1"/>
          <p:nvPr/>
        </p:nvSpPr>
        <p:spPr>
          <a:xfrm>
            <a:off x="10822537" y="3132858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83%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3C7F692-6A0A-4CFE-9BB3-B73A9E5BF723}"/>
              </a:ext>
            </a:extLst>
          </p:cNvPr>
          <p:cNvSpPr txBox="1"/>
          <p:nvPr/>
        </p:nvSpPr>
        <p:spPr>
          <a:xfrm>
            <a:off x="10267529" y="5569855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73%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A9D9025-E923-4FA9-8FBA-EDA873D6D700}"/>
              </a:ext>
            </a:extLst>
          </p:cNvPr>
          <p:cNvSpPr txBox="1"/>
          <p:nvPr/>
        </p:nvSpPr>
        <p:spPr>
          <a:xfrm>
            <a:off x="10817953" y="5045326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83%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7E5E901-6E9C-4B2D-8968-2FF95D4CDF06}"/>
              </a:ext>
            </a:extLst>
          </p:cNvPr>
          <p:cNvSpPr txBox="1"/>
          <p:nvPr/>
        </p:nvSpPr>
        <p:spPr>
          <a:xfrm>
            <a:off x="10432333" y="3621410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77%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4DC5E32-9C59-44C3-93CA-AF8B441AEA3B}"/>
              </a:ext>
            </a:extLst>
          </p:cNvPr>
          <p:cNvSpPr txBox="1"/>
          <p:nvPr/>
        </p:nvSpPr>
        <p:spPr>
          <a:xfrm>
            <a:off x="8163677" y="4108663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37%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85AB6C0-7600-4A6A-8A4B-021BA5607DB6}"/>
              </a:ext>
            </a:extLst>
          </p:cNvPr>
          <p:cNvSpPr txBox="1"/>
          <p:nvPr/>
        </p:nvSpPr>
        <p:spPr>
          <a:xfrm>
            <a:off x="7973706" y="4596517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33%</a:t>
            </a:r>
          </a:p>
        </p:txBody>
      </p:sp>
    </p:spTree>
    <p:extLst>
      <p:ext uri="{BB962C8B-B14F-4D97-AF65-F5344CB8AC3E}">
        <p14:creationId xmlns:p14="http://schemas.microsoft.com/office/powerpoint/2010/main" val="83412527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38337" y="309562"/>
            <a:ext cx="8315325" cy="62388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3967314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B8DD7C0E-EE8B-4019-A7EE-1BDF95E4CFD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23311380"/>
              </p:ext>
            </p:extLst>
          </p:nvPr>
        </p:nvGraphicFramePr>
        <p:xfrm>
          <a:off x="2242457" y="-14429"/>
          <a:ext cx="7750630" cy="69318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50" name="Prism 9" r:id="rId4" imgW="7378963" imgH="6599664" progId="Prism9.Document">
                  <p:embed/>
                </p:oleObj>
              </mc:Choice>
              <mc:Fallback>
                <p:oleObj name="Prism 9" r:id="rId4" imgW="7378963" imgH="6599664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242457" y="-14429"/>
                        <a:ext cx="7750630" cy="693187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14994529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2BE6AA-4067-4D8A-83A6-8DED2A7BB6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l Figures and Tables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F51CE6-4309-4E82-919E-CBDF4C2AECA7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932760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3EAEBDD1-CFC6-4A3E-B6DD-220B45409C7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10422923"/>
              </p:ext>
            </p:extLst>
          </p:nvPr>
        </p:nvGraphicFramePr>
        <p:xfrm>
          <a:off x="1905017" y="2584"/>
          <a:ext cx="8381966" cy="68554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74" name="Prism 9" r:id="rId4" imgW="8873978" imgH="7258190" progId="Prism9.Document">
                  <p:embed/>
                </p:oleObj>
              </mc:Choice>
              <mc:Fallback>
                <p:oleObj name="Prism 9" r:id="rId4" imgW="8873978" imgH="7258190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905017" y="2584"/>
                        <a:ext cx="8381966" cy="685541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5172819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176</TotalTime>
  <Words>519</Words>
  <Application>Microsoft Office PowerPoint</Application>
  <PresentationFormat>Widescreen</PresentationFormat>
  <Paragraphs>347</Paragraphs>
  <Slides>14</Slides>
  <Notes>12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9" baseType="lpstr">
      <vt:lpstr>Arial</vt:lpstr>
      <vt:lpstr>Calibri</vt:lpstr>
      <vt:lpstr>Calibri Light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Supplemental Figures and Table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nnifer Silva</dc:creator>
  <cp:lastModifiedBy>David Bloom</cp:lastModifiedBy>
  <cp:revision>191</cp:revision>
  <dcterms:created xsi:type="dcterms:W3CDTF">2021-08-07T21:37:19Z</dcterms:created>
  <dcterms:modified xsi:type="dcterms:W3CDTF">2022-05-31T16:24:23Z</dcterms:modified>
</cp:coreProperties>
</file>